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_rels/slideMaster1.xml.rels" ContentType="application/vnd.openxmlformats-package.relationships+xml"/>
  <Override PartName="/ppt/slideMasters/_rels/slideMaster2.xml.rels" ContentType="application/vnd.openxmlformats-package.relationships+xml"/>
  <Override PartName="/ppt/slideMasters/_rels/slideMaster3.xml.rels" ContentType="application/vnd.openxmlformats-package.relationship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slideLayouts/slideLayout31.xml" ContentType="application/vnd.openxmlformats-officedocument.presentationml.slideLayout+xml"/>
  <Override PartName="/ppt/slideLayouts/slideLayout1.xml" ContentType="application/vnd.openxmlformats-officedocument.presentationml.slideLayout+xml"/>
  <Override PartName="/ppt/slideLayouts/slideLayout32.xml" ContentType="application/vnd.openxmlformats-officedocument.presentationml.slideLayout+xml"/>
  <Override PartName="/ppt/slideLayouts/slideLayout2.xml" ContentType="application/vnd.openxmlformats-officedocument.presentationml.slideLayout+xml"/>
  <Override PartName="/ppt/slideLayouts/slideLayout33.xml" ContentType="application/vnd.openxmlformats-officedocument.presentationml.slideLayout+xml"/>
  <Override PartName="/ppt/slideLayouts/slideLayout3.xml" ContentType="application/vnd.openxmlformats-officedocument.presentationml.slideLayout+xml"/>
  <Override PartName="/ppt/slideLayouts/slideLayout34.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35.xml" ContentType="application/vnd.openxmlformats-officedocument.presentationml.slideLayout+xml"/>
  <Override PartName="/ppt/slideLayouts/slideLayout6.xml" ContentType="application/vnd.openxmlformats-officedocument.presentationml.slideLayout+xml"/>
  <Override PartName="/ppt/slideLayouts/slideLayout3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_rels/slideLayout31.xml.rels" ContentType="application/vnd.openxmlformats-package.relationships+xml"/>
  <Override PartName="/ppt/slideLayouts/_rels/slideLayout1.xml.rels" ContentType="application/vnd.openxmlformats-package.relationships+xml"/>
  <Override PartName="/ppt/slideLayouts/_rels/slideLayout32.xml.rels" ContentType="application/vnd.openxmlformats-package.relationships+xml"/>
  <Override PartName="/ppt/slideLayouts/_rels/slideLayout2.xml.rels" ContentType="application/vnd.openxmlformats-package.relationships+xml"/>
  <Override PartName="/ppt/slideLayouts/_rels/slideLayout33.xml.rels" ContentType="application/vnd.openxmlformats-package.relationships+xml"/>
  <Override PartName="/ppt/slideLayouts/_rels/slideLayout3.xml.rels" ContentType="application/vnd.openxmlformats-package.relationships+xml"/>
  <Override PartName="/ppt/slideLayouts/_rels/slideLayout34.xml.rels" ContentType="application/vnd.openxmlformats-package.relationships+xml"/>
  <Override PartName="/ppt/slideLayouts/_rels/slideLayout4.xml.rels" ContentType="application/vnd.openxmlformats-package.relationships+xml"/>
  <Override PartName="/ppt/slideLayouts/_rels/slideLayout35.xml.rels" ContentType="application/vnd.openxmlformats-package.relationships+xml"/>
  <Override PartName="/ppt/slideLayouts/_rels/slideLayout5.xml.rels" ContentType="application/vnd.openxmlformats-package.relationships+xml"/>
  <Override PartName="/ppt/slideLayouts/_rels/slideLayout36.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8.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11.xml.rels" ContentType="application/vnd.openxmlformats-package.relationships+xml"/>
  <Override PartName="/ppt/slideLayouts/_rels/slideLayout12.xml.rels" ContentType="application/vnd.openxmlformats-package.relationships+xml"/>
  <Override PartName="/ppt/slideLayouts/_rels/slideLayout13.xml.rels" ContentType="application/vnd.openxmlformats-package.relationships+xml"/>
  <Override PartName="/ppt/slideLayouts/_rels/slideLayout14.xml.rels" ContentType="application/vnd.openxmlformats-package.relationships+xml"/>
  <Override PartName="/ppt/slideLayouts/_rels/slideLayout15.xml.rels" ContentType="application/vnd.openxmlformats-package.relationships+xml"/>
  <Override PartName="/ppt/slideLayouts/_rels/slideLayout16.xml.rels" ContentType="application/vnd.openxmlformats-package.relationships+xml"/>
  <Override PartName="/ppt/slideLayouts/_rels/slideLayout17.xml.rels" ContentType="application/vnd.openxmlformats-package.relationships+xml"/>
  <Override PartName="/ppt/slideLayouts/_rels/slideLayout18.xml.rels" ContentType="application/vnd.openxmlformats-package.relationships+xml"/>
  <Override PartName="/ppt/slideLayouts/_rels/slideLayout19.xml.rels" ContentType="application/vnd.openxmlformats-package.relationships+xml"/>
  <Override PartName="/ppt/slideLayouts/_rels/slideLayout20.xml.rels" ContentType="application/vnd.openxmlformats-package.relationships+xml"/>
  <Override PartName="/ppt/slideLayouts/_rels/slideLayout21.xml.rels" ContentType="application/vnd.openxmlformats-package.relationships+xml"/>
  <Override PartName="/ppt/slideLayouts/_rels/slideLayout22.xml.rels" ContentType="application/vnd.openxmlformats-package.relationships+xml"/>
  <Override PartName="/ppt/slideLayouts/_rels/slideLayout23.xml.rels" ContentType="application/vnd.openxmlformats-package.relationships+xml"/>
  <Override PartName="/ppt/slideLayouts/_rels/slideLayout24.xml.rels" ContentType="application/vnd.openxmlformats-package.relationships+xml"/>
  <Override PartName="/ppt/slideLayouts/_rels/slideLayout25.xml.rels" ContentType="application/vnd.openxmlformats-package.relationships+xml"/>
  <Override PartName="/ppt/slideLayouts/_rels/slideLayout26.xml.rels" ContentType="application/vnd.openxmlformats-package.relationships+xml"/>
  <Override PartName="/ppt/slideLayouts/_rels/slideLayout27.xml.rels" ContentType="application/vnd.openxmlformats-package.relationships+xml"/>
  <Override PartName="/ppt/slideLayouts/_rels/slideLayout28.xml.rels" ContentType="application/vnd.openxmlformats-package.relationships+xml"/>
  <Override PartName="/ppt/slideLayouts/_rels/slideLayout29.xml.rels" ContentType="application/vnd.openxmlformats-package.relationships+xml"/>
  <Override PartName="/ppt/slideLayouts/_rels/slideLayout30.xml.rels" ContentType="application/vnd.openxmlformats-package.relationships+xml"/>
  <Override PartName="/ppt/comments/comment4.xml" ContentType="application/vnd.openxmlformats-officedocument.presentationml.comments+xml"/>
  <Override PartName="/ppt/comments/comment5.xml" ContentType="application/vnd.openxmlformats-officedocument.presentationml.comments+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_rels/slide1.xml.rels" ContentType="application/vnd.openxmlformats-package.relationships+xml"/>
  <Override PartName="/ppt/slides/_rels/slide2.xml.rels" ContentType="application/vnd.openxmlformats-package.relationships+xml"/>
  <Override PartName="/ppt/slides/_rels/slide3.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8.xml.rels" ContentType="application/vnd.openxmlformats-package.relationships+xml"/>
  <Override PartName="/ppt/media/image1.jpeg" ContentType="image/jpeg"/>
  <Override PartName="/ppt/media/image2.jpeg" ContentType="image/jpeg"/>
  <Override PartName="/ppt/media/image8.png" ContentType="image/png"/>
  <Override PartName="/ppt/media/image3.jpeg" ContentType="image/jpeg"/>
  <Override PartName="/ppt/media/image5.png" ContentType="image/png"/>
  <Override PartName="/ppt/media/image4.jpeg" ContentType="image/jpeg"/>
  <Override PartName="/ppt/media/image6.png" ContentType="image/png"/>
  <Override PartName="/ppt/media/image7.png" ContentType="image/png"/>
  <Override PartName="/ppt/media/image9.png" ContentType="image/png"/>
  <Override PartName="/ppt/media/image10.png" ContentType="image/png"/>
  <Override PartName="/ppt/media/image11.png" ContentType="image/png"/>
  <Override PartName="/ppt/commentAuthors.xml" ContentType="application/vnd.openxmlformats-officedocument.presentationml.commentAuthors+xml"/>
  <Override PartName="/ppt/_rels/presentation.xml.rels" ContentType="application/vnd.openxmlformats-package.relationship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Lst>
  <p:sldIdLst>
    <p:sldId id="256" r:id="rId5"/>
    <p:sldId id="257" r:id="rId6"/>
    <p:sldId id="258" r:id="rId7"/>
    <p:sldId id="259" r:id="rId8"/>
    <p:sldId id="260" r:id="rId9"/>
    <p:sldId id="261" r:id="rId10"/>
    <p:sldId id="262" r:id="rId11"/>
    <p:sldId id="263" r:id="rId12"/>
  </p:sldIdLst>
  <p:sldSz cx="12192000" cy="6858000"/>
  <p:notesSz cx="7772400" cy="10058400"/>
</p:presentation>
</file>

<file path=ppt/commentAuthors.xml><?xml version="1.0" encoding="utf-8"?>
<p:cmAuthorLst xmlns:p="http://schemas.openxmlformats.org/presentationml/2006/main">
  <p:cmAuthor id="0" name="Carolyn Young" initials="CY" lastIdx="4" clrIdx="0"/>
</p:cmAuthorLst>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commentAuthors" Target="commentAuthors.xml"/>
</Relationships>
</file>

<file path=ppt/charts/chart13.xml><?xml version="1.0" encoding="utf-8"?>
<c:chartSpace xmlns:c="http://schemas.openxmlformats.org/drawingml/2006/chart" xmlns:a="http://schemas.openxmlformats.org/drawingml/2006/main" xmlns:r="http://schemas.openxmlformats.org/officeDocument/2006/relationships">
  <c:lang val="en-US"/>
  <c:roundedCorners val="0"/>
  <c:chart>
    <c:autoTitleDeleted val="1"/>
    <c:plotArea>
      <c:layout>
        <c:manualLayout>
          <c:layoutTarget val="inner"/>
          <c:xMode val="edge"/>
          <c:yMode val="edge"/>
          <c:x val="0.0440284735038228"/>
          <c:y val="0.0367523167649537"/>
          <c:w val="0.93524914315845"/>
          <c:h val="0.744839932603201"/>
        </c:manualLayout>
      </c:layout>
      <c:lineChart>
        <c:grouping val="standard"/>
        <c:varyColors val="0"/>
        <c:ser>
          <c:idx val="0"/>
          <c:order val="0"/>
          <c:tx>
            <c:strRef>
              <c:f>label 0</c:f>
              <c:strCache>
                <c:ptCount val="1"/>
                <c:pt idx="0">
                  <c:v>WW-15cm</c:v>
                </c:pt>
              </c:strCache>
            </c:strRef>
          </c:tx>
          <c:spPr>
            <a:solidFill>
              <a:srgbClr val="5b9bd5"/>
            </a:solidFill>
            <a:ln cap="rnd" w="34920">
              <a:solidFill>
                <a:srgbClr val="5b9bd5"/>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29"/>
                <c:pt idx="0">
                  <c:v>28-Sep-15</c:v>
                </c:pt>
                <c:pt idx="1">
                  <c:v>29-Sep-15</c:v>
                </c:pt>
                <c:pt idx="2">
                  <c:v>30-Sep-15</c:v>
                </c:pt>
                <c:pt idx="3">
                  <c:v>1-Oct-15</c:v>
                </c:pt>
                <c:pt idx="4">
                  <c:v>2-Oct-15</c:v>
                </c:pt>
                <c:pt idx="5">
                  <c:v>3-Oct-15</c:v>
                </c:pt>
                <c:pt idx="6">
                  <c:v>4-Oct-15</c:v>
                </c:pt>
                <c:pt idx="7">
                  <c:v>5-Oct-15</c:v>
                </c:pt>
                <c:pt idx="8">
                  <c:v>6-Oct-15</c:v>
                </c:pt>
                <c:pt idx="9">
                  <c:v>7-Oct-15</c:v>
                </c:pt>
                <c:pt idx="10">
                  <c:v>8-Oct-15</c:v>
                </c:pt>
                <c:pt idx="11">
                  <c:v>9-Oct-15</c:v>
                </c:pt>
                <c:pt idx="12">
                  <c:v>10-Oct-15</c:v>
                </c:pt>
                <c:pt idx="13">
                  <c:v>11-Oct-15</c:v>
                </c:pt>
                <c:pt idx="14">
                  <c:v>12-Oct-15</c:v>
                </c:pt>
                <c:pt idx="15">
                  <c:v>13-Oct-15</c:v>
                </c:pt>
                <c:pt idx="16">
                  <c:v>14-Oct-15</c:v>
                </c:pt>
                <c:pt idx="17">
                  <c:v>15-Oct-15</c:v>
                </c:pt>
                <c:pt idx="18">
                  <c:v>16-Oct-15</c:v>
                </c:pt>
                <c:pt idx="19">
                  <c:v>17-Oct-15</c:v>
                </c:pt>
                <c:pt idx="20">
                  <c:v>18-Oct-15</c:v>
                </c:pt>
                <c:pt idx="21">
                  <c:v>19-Oct-15</c:v>
                </c:pt>
                <c:pt idx="22">
                  <c:v>20-Oct-15</c:v>
                </c:pt>
                <c:pt idx="23">
                  <c:v>21-Oct-15</c:v>
                </c:pt>
                <c:pt idx="24">
                  <c:v>22-Oct-15</c:v>
                </c:pt>
                <c:pt idx="25">
                  <c:v>23-Oct-15</c:v>
                </c:pt>
                <c:pt idx="26">
                  <c:v>24-Oct-15</c:v>
                </c:pt>
                <c:pt idx="27">
                  <c:v>25-Oct-15</c:v>
                </c:pt>
                <c:pt idx="28">
                  <c:v>26-Oct-15</c:v>
                </c:pt>
              </c:strCache>
            </c:strRef>
          </c:cat>
          <c:val>
            <c:numRef>
              <c:f>0</c:f>
              <c:numCache>
                <c:formatCode>General</c:formatCode>
                <c:ptCount val="29"/>
                <c:pt idx="0">
                  <c:v>8.95209895679727</c:v>
                </c:pt>
                <c:pt idx="1">
                  <c:v>9.13083649162824</c:v>
                </c:pt>
                <c:pt idx="2">
                  <c:v>8.84293326719975</c:v>
                </c:pt>
                <c:pt idx="3">
                  <c:v>8.43323230122526</c:v>
                </c:pt>
                <c:pt idx="4">
                  <c:v>8.11685940328365</c:v>
                </c:pt>
                <c:pt idx="5">
                  <c:v>7.77484473461906</c:v>
                </c:pt>
                <c:pt idx="6">
                  <c:v>7.52747813239694</c:v>
                </c:pt>
                <c:pt idx="7">
                  <c:v>7.35797918556879</c:v>
                </c:pt>
                <c:pt idx="8">
                  <c:v>7.22863952590463</c:v>
                </c:pt>
                <c:pt idx="9">
                  <c:v>7.11212089130034</c:v>
                </c:pt>
                <c:pt idx="10">
                  <c:v>6.97467375624304</c:v>
                </c:pt>
                <c:pt idx="11">
                  <c:v>6.96618942699085</c:v>
                </c:pt>
                <c:pt idx="12">
                  <c:v>7.02199792334189</c:v>
                </c:pt>
                <c:pt idx="13">
                  <c:v>6.92188215907663</c:v>
                </c:pt>
                <c:pt idx="14">
                  <c:v>6.79159997574364</c:v>
                </c:pt>
                <c:pt idx="15">
                  <c:v>6.81384784790377</c:v>
                </c:pt>
                <c:pt idx="16">
                  <c:v>6.74521867573882</c:v>
                </c:pt>
                <c:pt idx="17">
                  <c:v>6.75162920185054</c:v>
                </c:pt>
                <c:pt idx="18">
                  <c:v>6.40414689357082</c:v>
                </c:pt>
                <c:pt idx="19">
                  <c:v>6.23031147988513</c:v>
                </c:pt>
                <c:pt idx="20">
                  <c:v>6.16073963271144</c:v>
                </c:pt>
                <c:pt idx="21">
                  <c:v>6.11398118004824</c:v>
                </c:pt>
                <c:pt idx="22">
                  <c:v>6.15809995991488</c:v>
                </c:pt>
                <c:pt idx="23">
                  <c:v>6.29177597002126</c:v>
                </c:pt>
                <c:pt idx="24">
                  <c:v>6.51406664207267</c:v>
                </c:pt>
                <c:pt idx="25">
                  <c:v>6.47390732968537</c:v>
                </c:pt>
                <c:pt idx="26">
                  <c:v>6.10606249926301</c:v>
                </c:pt>
                <c:pt idx="27">
                  <c:v>5.91111041527862</c:v>
                </c:pt>
                <c:pt idx="28">
                  <c:v>5.1527959042384</c:v>
                </c:pt>
              </c:numCache>
            </c:numRef>
          </c:val>
          <c:smooth val="0"/>
        </c:ser>
        <c:ser>
          <c:idx val="1"/>
          <c:order val="1"/>
          <c:tx>
            <c:strRef>
              <c:f>label 1</c:f>
              <c:strCache>
                <c:ptCount val="1"/>
                <c:pt idx="0">
                  <c:v>WS-15cm</c:v>
                </c:pt>
              </c:strCache>
            </c:strRef>
          </c:tx>
          <c:spPr>
            <a:solidFill>
              <a:srgbClr val="ed7d31"/>
            </a:solidFill>
            <a:ln cap="rnd" w="34920">
              <a:solidFill>
                <a:srgbClr val="ed7d31"/>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29"/>
                <c:pt idx="0">
                  <c:v>28-Sep-15</c:v>
                </c:pt>
                <c:pt idx="1">
                  <c:v>29-Sep-15</c:v>
                </c:pt>
                <c:pt idx="2">
                  <c:v>30-Sep-15</c:v>
                </c:pt>
                <c:pt idx="3">
                  <c:v>1-Oct-15</c:v>
                </c:pt>
                <c:pt idx="4">
                  <c:v>2-Oct-15</c:v>
                </c:pt>
                <c:pt idx="5">
                  <c:v>3-Oct-15</c:v>
                </c:pt>
                <c:pt idx="6">
                  <c:v>4-Oct-15</c:v>
                </c:pt>
                <c:pt idx="7">
                  <c:v>5-Oct-15</c:v>
                </c:pt>
                <c:pt idx="8">
                  <c:v>6-Oct-15</c:v>
                </c:pt>
                <c:pt idx="9">
                  <c:v>7-Oct-15</c:v>
                </c:pt>
                <c:pt idx="10">
                  <c:v>8-Oct-15</c:v>
                </c:pt>
                <c:pt idx="11">
                  <c:v>9-Oct-15</c:v>
                </c:pt>
                <c:pt idx="12">
                  <c:v>10-Oct-15</c:v>
                </c:pt>
                <c:pt idx="13">
                  <c:v>11-Oct-15</c:v>
                </c:pt>
                <c:pt idx="14">
                  <c:v>12-Oct-15</c:v>
                </c:pt>
                <c:pt idx="15">
                  <c:v>13-Oct-15</c:v>
                </c:pt>
                <c:pt idx="16">
                  <c:v>14-Oct-15</c:v>
                </c:pt>
                <c:pt idx="17">
                  <c:v>15-Oct-15</c:v>
                </c:pt>
                <c:pt idx="18">
                  <c:v>16-Oct-15</c:v>
                </c:pt>
                <c:pt idx="19">
                  <c:v>17-Oct-15</c:v>
                </c:pt>
                <c:pt idx="20">
                  <c:v>18-Oct-15</c:v>
                </c:pt>
                <c:pt idx="21">
                  <c:v>19-Oct-15</c:v>
                </c:pt>
                <c:pt idx="22">
                  <c:v>20-Oct-15</c:v>
                </c:pt>
                <c:pt idx="23">
                  <c:v>21-Oct-15</c:v>
                </c:pt>
                <c:pt idx="24">
                  <c:v>22-Oct-15</c:v>
                </c:pt>
                <c:pt idx="25">
                  <c:v>23-Oct-15</c:v>
                </c:pt>
                <c:pt idx="26">
                  <c:v>24-Oct-15</c:v>
                </c:pt>
                <c:pt idx="27">
                  <c:v>25-Oct-15</c:v>
                </c:pt>
                <c:pt idx="28">
                  <c:v>26-Oct-15</c:v>
                </c:pt>
              </c:strCache>
            </c:strRef>
          </c:cat>
          <c:val>
            <c:numRef>
              <c:f>1</c:f>
              <c:numCache>
                <c:formatCode>General</c:formatCode>
                <c:ptCount val="29"/>
                <c:pt idx="0">
                  <c:v>7.46092291859289</c:v>
                </c:pt>
                <c:pt idx="1">
                  <c:v>7.05480413356175</c:v>
                </c:pt>
                <c:pt idx="2">
                  <c:v>6.41300833861654</c:v>
                </c:pt>
                <c:pt idx="3">
                  <c:v>5.80251042265445</c:v>
                </c:pt>
                <c:pt idx="4">
                  <c:v>5.53063336216534</c:v>
                </c:pt>
                <c:pt idx="5">
                  <c:v>5.18673333572224</c:v>
                </c:pt>
                <c:pt idx="6">
                  <c:v>4.85188335878775</c:v>
                </c:pt>
                <c:pt idx="7">
                  <c:v>4.54342917461569</c:v>
                </c:pt>
                <c:pt idx="8">
                  <c:v>5.33530427298198</c:v>
                </c:pt>
                <c:pt idx="9">
                  <c:v>6.56572710722685</c:v>
                </c:pt>
                <c:pt idx="10">
                  <c:v>6.23917294821391</c:v>
                </c:pt>
                <c:pt idx="11">
                  <c:v>5.90733953674013</c:v>
                </c:pt>
                <c:pt idx="12">
                  <c:v>4.53324788832106</c:v>
                </c:pt>
                <c:pt idx="13">
                  <c:v>2.76849794706019</c:v>
                </c:pt>
                <c:pt idx="14">
                  <c:v>2.50416250394968</c:v>
                </c:pt>
                <c:pt idx="15">
                  <c:v>2.28696247407546</c:v>
                </c:pt>
                <c:pt idx="16">
                  <c:v>2.12670209778783</c:v>
                </c:pt>
                <c:pt idx="17">
                  <c:v>1.84577500913292</c:v>
                </c:pt>
                <c:pt idx="18">
                  <c:v>2.03243125773345</c:v>
                </c:pt>
                <c:pt idx="19">
                  <c:v>2.05203956963184</c:v>
                </c:pt>
                <c:pt idx="20">
                  <c:v>1.94645624530191</c:v>
                </c:pt>
                <c:pt idx="21">
                  <c:v>2.00226458837278</c:v>
                </c:pt>
                <c:pt idx="22">
                  <c:v>2.04751458950341</c:v>
                </c:pt>
                <c:pt idx="23">
                  <c:v>2.01470835211997</c:v>
                </c:pt>
                <c:pt idx="24">
                  <c:v>2.58033333035807</c:v>
                </c:pt>
                <c:pt idx="25">
                  <c:v>2.81073123915121</c:v>
                </c:pt>
                <c:pt idx="26">
                  <c:v>2.87370414783557</c:v>
                </c:pt>
                <c:pt idx="27">
                  <c:v>2.88162291205178</c:v>
                </c:pt>
                <c:pt idx="28">
                  <c:v>3.07582080325422</c:v>
                </c:pt>
              </c:numCache>
            </c:numRef>
          </c:val>
          <c:smooth val="0"/>
        </c:ser>
        <c:ser>
          <c:idx val="2"/>
          <c:order val="2"/>
          <c:tx>
            <c:strRef>
              <c:f>label 2</c:f>
              <c:strCache>
                <c:ptCount val="1"/>
                <c:pt idx="0">
                  <c:v>WW-60cm</c:v>
                </c:pt>
              </c:strCache>
            </c:strRef>
          </c:tx>
          <c:spPr>
            <a:solidFill>
              <a:srgbClr val="a5a5a5"/>
            </a:solidFill>
            <a:ln cap="rnd" w="34920">
              <a:solidFill>
                <a:srgbClr val="a5a5a5"/>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29"/>
                <c:pt idx="0">
                  <c:v>28-Sep-15</c:v>
                </c:pt>
                <c:pt idx="1">
                  <c:v>29-Sep-15</c:v>
                </c:pt>
                <c:pt idx="2">
                  <c:v>30-Sep-15</c:v>
                </c:pt>
                <c:pt idx="3">
                  <c:v>1-Oct-15</c:v>
                </c:pt>
                <c:pt idx="4">
                  <c:v>2-Oct-15</c:v>
                </c:pt>
                <c:pt idx="5">
                  <c:v>3-Oct-15</c:v>
                </c:pt>
                <c:pt idx="6">
                  <c:v>4-Oct-15</c:v>
                </c:pt>
                <c:pt idx="7">
                  <c:v>5-Oct-15</c:v>
                </c:pt>
                <c:pt idx="8">
                  <c:v>6-Oct-15</c:v>
                </c:pt>
                <c:pt idx="9">
                  <c:v>7-Oct-15</c:v>
                </c:pt>
                <c:pt idx="10">
                  <c:v>8-Oct-15</c:v>
                </c:pt>
                <c:pt idx="11">
                  <c:v>9-Oct-15</c:v>
                </c:pt>
                <c:pt idx="12">
                  <c:v>10-Oct-15</c:v>
                </c:pt>
                <c:pt idx="13">
                  <c:v>11-Oct-15</c:v>
                </c:pt>
                <c:pt idx="14">
                  <c:v>12-Oct-15</c:v>
                </c:pt>
                <c:pt idx="15">
                  <c:v>13-Oct-15</c:v>
                </c:pt>
                <c:pt idx="16">
                  <c:v>14-Oct-15</c:v>
                </c:pt>
                <c:pt idx="17">
                  <c:v>15-Oct-15</c:v>
                </c:pt>
                <c:pt idx="18">
                  <c:v>16-Oct-15</c:v>
                </c:pt>
                <c:pt idx="19">
                  <c:v>17-Oct-15</c:v>
                </c:pt>
                <c:pt idx="20">
                  <c:v>18-Oct-15</c:v>
                </c:pt>
                <c:pt idx="21">
                  <c:v>19-Oct-15</c:v>
                </c:pt>
                <c:pt idx="22">
                  <c:v>20-Oct-15</c:v>
                </c:pt>
                <c:pt idx="23">
                  <c:v>21-Oct-15</c:v>
                </c:pt>
                <c:pt idx="24">
                  <c:v>22-Oct-15</c:v>
                </c:pt>
                <c:pt idx="25">
                  <c:v>23-Oct-15</c:v>
                </c:pt>
                <c:pt idx="26">
                  <c:v>24-Oct-15</c:v>
                </c:pt>
                <c:pt idx="27">
                  <c:v>25-Oct-15</c:v>
                </c:pt>
                <c:pt idx="28">
                  <c:v>26-Oct-15</c:v>
                </c:pt>
              </c:strCache>
            </c:strRef>
          </c:cat>
          <c:val>
            <c:numRef>
              <c:f>2</c:f>
              <c:numCache>
                <c:formatCode>General</c:formatCode>
                <c:ptCount val="29"/>
                <c:pt idx="0">
                  <c:v>35.0905731320381</c:v>
                </c:pt>
                <c:pt idx="1">
                  <c:v>33.9744062783817</c:v>
                </c:pt>
                <c:pt idx="2">
                  <c:v>33.3978461101651</c:v>
                </c:pt>
                <c:pt idx="3">
                  <c:v>33.743631405135</c:v>
                </c:pt>
                <c:pt idx="4">
                  <c:v>33.7440085286895</c:v>
                </c:pt>
                <c:pt idx="5">
                  <c:v>33.7006436971327</c:v>
                </c:pt>
                <c:pt idx="6">
                  <c:v>33.6821663814286</c:v>
                </c:pt>
                <c:pt idx="7">
                  <c:v>33.6908398196101</c:v>
                </c:pt>
                <c:pt idx="8">
                  <c:v>34.3488502626618</c:v>
                </c:pt>
                <c:pt idx="9">
                  <c:v>35.2881651371717</c:v>
                </c:pt>
                <c:pt idx="10">
                  <c:v>35.2843940568467</c:v>
                </c:pt>
                <c:pt idx="11">
                  <c:v>35.3356780173878</c:v>
                </c:pt>
                <c:pt idx="12">
                  <c:v>35.5362852104008</c:v>
                </c:pt>
                <c:pt idx="13">
                  <c:v>35.7466982677579</c:v>
                </c:pt>
                <c:pt idx="14">
                  <c:v>35.6614778128763</c:v>
                </c:pt>
                <c:pt idx="15">
                  <c:v>35.5064955229561</c:v>
                </c:pt>
                <c:pt idx="16">
                  <c:v>35.7896860378484</c:v>
                </c:pt>
                <c:pt idx="17">
                  <c:v>36.3341935910285</c:v>
                </c:pt>
                <c:pt idx="18">
                  <c:v>36.5600666962564</c:v>
                </c:pt>
                <c:pt idx="19">
                  <c:v>37.0823270330826</c:v>
                </c:pt>
                <c:pt idx="20">
                  <c:v>37.7516498168309</c:v>
                </c:pt>
                <c:pt idx="21">
                  <c:v>38.0137233374019</c:v>
                </c:pt>
                <c:pt idx="22">
                  <c:v>38.0288069136441</c:v>
                </c:pt>
                <c:pt idx="23">
                  <c:v>37.7490104486545</c:v>
                </c:pt>
                <c:pt idx="24">
                  <c:v>37.624195497483</c:v>
                </c:pt>
                <c:pt idx="25">
                  <c:v>37.1339874962966</c:v>
                </c:pt>
                <c:pt idx="26">
                  <c:v>36.9639228408535</c:v>
                </c:pt>
                <c:pt idx="27">
                  <c:v>37.5265308655798</c:v>
                </c:pt>
                <c:pt idx="28">
                  <c:v>37.3074455186725</c:v>
                </c:pt>
              </c:numCache>
            </c:numRef>
          </c:val>
          <c:smooth val="0"/>
        </c:ser>
        <c:ser>
          <c:idx val="3"/>
          <c:order val="3"/>
          <c:tx>
            <c:strRef>
              <c:f>label 3</c:f>
              <c:strCache>
                <c:ptCount val="1"/>
                <c:pt idx="0">
                  <c:v>WS-60cm</c:v>
                </c:pt>
              </c:strCache>
            </c:strRef>
          </c:tx>
          <c:spPr>
            <a:solidFill>
              <a:srgbClr val="ffc000"/>
            </a:solidFill>
            <a:ln cap="rnd" w="34920">
              <a:solidFill>
                <a:srgbClr val="ffc000"/>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29"/>
                <c:pt idx="0">
                  <c:v>28-Sep-15</c:v>
                </c:pt>
                <c:pt idx="1">
                  <c:v>29-Sep-15</c:v>
                </c:pt>
                <c:pt idx="2">
                  <c:v>30-Sep-15</c:v>
                </c:pt>
                <c:pt idx="3">
                  <c:v>1-Oct-15</c:v>
                </c:pt>
                <c:pt idx="4">
                  <c:v>2-Oct-15</c:v>
                </c:pt>
                <c:pt idx="5">
                  <c:v>3-Oct-15</c:v>
                </c:pt>
                <c:pt idx="6">
                  <c:v>4-Oct-15</c:v>
                </c:pt>
                <c:pt idx="7">
                  <c:v>5-Oct-15</c:v>
                </c:pt>
                <c:pt idx="8">
                  <c:v>6-Oct-15</c:v>
                </c:pt>
                <c:pt idx="9">
                  <c:v>7-Oct-15</c:v>
                </c:pt>
                <c:pt idx="10">
                  <c:v>8-Oct-15</c:v>
                </c:pt>
                <c:pt idx="11">
                  <c:v>9-Oct-15</c:v>
                </c:pt>
                <c:pt idx="12">
                  <c:v>10-Oct-15</c:v>
                </c:pt>
                <c:pt idx="13">
                  <c:v>11-Oct-15</c:v>
                </c:pt>
                <c:pt idx="14">
                  <c:v>12-Oct-15</c:v>
                </c:pt>
                <c:pt idx="15">
                  <c:v>13-Oct-15</c:v>
                </c:pt>
                <c:pt idx="16">
                  <c:v>14-Oct-15</c:v>
                </c:pt>
                <c:pt idx="17">
                  <c:v>15-Oct-15</c:v>
                </c:pt>
                <c:pt idx="18">
                  <c:v>16-Oct-15</c:v>
                </c:pt>
                <c:pt idx="19">
                  <c:v>17-Oct-15</c:v>
                </c:pt>
                <c:pt idx="20">
                  <c:v>18-Oct-15</c:v>
                </c:pt>
                <c:pt idx="21">
                  <c:v>19-Oct-15</c:v>
                </c:pt>
                <c:pt idx="22">
                  <c:v>20-Oct-15</c:v>
                </c:pt>
                <c:pt idx="23">
                  <c:v>21-Oct-15</c:v>
                </c:pt>
                <c:pt idx="24">
                  <c:v>22-Oct-15</c:v>
                </c:pt>
                <c:pt idx="25">
                  <c:v>23-Oct-15</c:v>
                </c:pt>
                <c:pt idx="26">
                  <c:v>24-Oct-15</c:v>
                </c:pt>
                <c:pt idx="27">
                  <c:v>25-Oct-15</c:v>
                </c:pt>
                <c:pt idx="28">
                  <c:v>26-Oct-15</c:v>
                </c:pt>
              </c:strCache>
            </c:strRef>
          </c:cat>
          <c:val>
            <c:numRef>
              <c:f>3</c:f>
              <c:numCache>
                <c:formatCode>General</c:formatCode>
                <c:ptCount val="29"/>
                <c:pt idx="0">
                  <c:v>33.2515377085656</c:v>
                </c:pt>
                <c:pt idx="1">
                  <c:v>33.3676790352911</c:v>
                </c:pt>
                <c:pt idx="2">
                  <c:v>32.9868252544353</c:v>
                </c:pt>
                <c:pt idx="3">
                  <c:v>32.753222156316</c:v>
                </c:pt>
                <c:pt idx="4">
                  <c:v>32.8876521593581</c:v>
                </c:pt>
                <c:pt idx="5">
                  <c:v>32.9698565881699</c:v>
                </c:pt>
                <c:pt idx="6">
                  <c:v>33.0437647023549</c:v>
                </c:pt>
                <c:pt idx="7">
                  <c:v>33.2110012260576</c:v>
                </c:pt>
                <c:pt idx="8">
                  <c:v>33.8818326437225</c:v>
                </c:pt>
                <c:pt idx="9">
                  <c:v>34.7242368074755</c:v>
                </c:pt>
                <c:pt idx="10">
                  <c:v>34.6699365259459</c:v>
                </c:pt>
                <c:pt idx="11">
                  <c:v>34.6216697711498</c:v>
                </c:pt>
                <c:pt idx="12">
                  <c:v>34.6135625305275</c:v>
                </c:pt>
                <c:pt idx="13">
                  <c:v>34.4740416388959</c:v>
                </c:pt>
                <c:pt idx="14">
                  <c:v>34.4536788295954</c:v>
                </c:pt>
                <c:pt idx="15">
                  <c:v>34.2530706586937</c:v>
                </c:pt>
                <c:pt idx="16">
                  <c:v>32.205319730565</c:v>
                </c:pt>
                <c:pt idx="17">
                  <c:v>29.3457081308588</c:v>
                </c:pt>
                <c:pt idx="18">
                  <c:v>27.3273694949845</c:v>
                </c:pt>
                <c:pt idx="19">
                  <c:v>26.0809208809709</c:v>
                </c:pt>
                <c:pt idx="20">
                  <c:v>24.9474085013693</c:v>
                </c:pt>
                <c:pt idx="21">
                  <c:v>23.3495176459352</c:v>
                </c:pt>
                <c:pt idx="22">
                  <c:v>21.6079583236327</c:v>
                </c:pt>
                <c:pt idx="23">
                  <c:v>19.2860677372664</c:v>
                </c:pt>
                <c:pt idx="24">
                  <c:v>16.9168530536505</c:v>
                </c:pt>
                <c:pt idx="25">
                  <c:v>15.3943792645199</c:v>
                </c:pt>
                <c:pt idx="26">
                  <c:v>14.0368791646324</c:v>
                </c:pt>
                <c:pt idx="27">
                  <c:v>12.9195812740363</c:v>
                </c:pt>
                <c:pt idx="28">
                  <c:v>11.9227613322437</c:v>
                </c:pt>
              </c:numCache>
            </c:numRef>
          </c:val>
          <c:smooth val="0"/>
        </c:ser>
        <c:hiLowLines>
          <c:spPr>
            <a:ln w="0">
              <a:noFill/>
            </a:ln>
          </c:spPr>
        </c:hiLowLines>
        <c:marker val="0"/>
        <c:axId val="4266252"/>
        <c:axId val="39153552"/>
      </c:lineChart>
      <c:dateAx>
        <c:axId val="4266252"/>
        <c:scaling>
          <c:orientation val="minMax"/>
        </c:scaling>
        <c:delete val="0"/>
        <c:axPos val="b"/>
        <c:numFmt formatCode="d\-mmm\-yy" sourceLinked="0"/>
        <c:majorTickMark val="out"/>
        <c:minorTickMark val="none"/>
        <c:tickLblPos val="nextTo"/>
        <c:spPr>
          <a:ln w="12600">
            <a:solidFill>
              <a:srgbClr val="d9d9d9"/>
            </a:solidFill>
            <a:round/>
          </a:ln>
        </c:spPr>
        <c:txPr>
          <a:bodyPr/>
          <a:lstStyle/>
          <a:p>
            <a:pPr>
              <a:defRPr b="0" sz="900" spc="-1" strike="noStrike">
                <a:solidFill>
                  <a:srgbClr val="595959"/>
                </a:solidFill>
                <a:latin typeface="Calibri"/>
                <a:ea typeface="DejaVu Sans"/>
              </a:defRPr>
            </a:pPr>
          </a:p>
        </c:txPr>
        <c:crossAx val="39153552"/>
        <c:crosses val="autoZero"/>
        <c:auto val="1"/>
        <c:lblOffset val="100"/>
        <c:baseTimeUnit val="days"/>
        <c:noMultiLvlLbl val="0"/>
      </c:dateAx>
      <c:valAx>
        <c:axId val="39153552"/>
        <c:scaling>
          <c:orientation val="minMax"/>
        </c:scaling>
        <c:delete val="0"/>
        <c:axPos val="l"/>
        <c:majorGridlines>
          <c:spPr>
            <a:ln w="9360">
              <a:solidFill>
                <a:srgbClr val="d9d9d9"/>
              </a:solidFill>
              <a:round/>
            </a:ln>
          </c:spPr>
        </c:majorGridlines>
        <c:numFmt formatCode="0" sourceLinked="0"/>
        <c:majorTickMark val="none"/>
        <c:minorTickMark val="none"/>
        <c:tickLblPos val="nextTo"/>
        <c:spPr>
          <a:ln w="6480">
            <a:noFill/>
          </a:ln>
        </c:spPr>
        <c:txPr>
          <a:bodyPr/>
          <a:lstStyle/>
          <a:p>
            <a:pPr>
              <a:defRPr b="0" sz="900" spc="-1" strike="noStrike">
                <a:solidFill>
                  <a:srgbClr val="595959"/>
                </a:solidFill>
                <a:latin typeface="Calibri"/>
                <a:ea typeface="DejaVu Sans"/>
              </a:defRPr>
            </a:pPr>
          </a:p>
        </c:txPr>
        <c:crossAx val="4266252"/>
        <c:crosses val="autoZero"/>
        <c:crossBetween val="between"/>
      </c:valAx>
      <c:spPr>
        <a:noFill/>
        <a:ln w="25560">
          <a:noFill/>
        </a:ln>
      </c:spPr>
    </c:plotArea>
    <c:plotVisOnly val="1"/>
    <c:dispBlanksAs val="gap"/>
  </c:chart>
  <c:spPr>
    <a:noFill/>
    <a:ln w="9360">
      <a:noFill/>
    </a:ln>
  </c:spPr>
</c:chartSpace>
</file>

<file path=ppt/charts/chart14.xml><?xml version="1.0" encoding="utf-8"?>
<c:chartSpace xmlns:c="http://schemas.openxmlformats.org/drawingml/2006/chart" xmlns:a="http://schemas.openxmlformats.org/drawingml/2006/main" xmlns:r="http://schemas.openxmlformats.org/officeDocument/2006/relationships">
  <c:lang val="en-US"/>
  <c:roundedCorners val="0"/>
  <c:chart>
    <c:autoTitleDeleted val="1"/>
    <c:plotArea>
      <c:lineChart>
        <c:grouping val="standard"/>
        <c:varyColors val="0"/>
        <c:ser>
          <c:idx val="0"/>
          <c:order val="0"/>
          <c:tx>
            <c:strRef>
              <c:f>label 0</c:f>
              <c:strCache>
                <c:ptCount val="1"/>
                <c:pt idx="0">
                  <c:v>WW15cm</c:v>
                </c:pt>
              </c:strCache>
            </c:strRef>
          </c:tx>
          <c:spPr>
            <a:solidFill>
              <a:srgbClr val="5b9bd5"/>
            </a:solidFill>
            <a:ln cap="rnd" w="34920">
              <a:solidFill>
                <a:srgbClr val="5b9bd5"/>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36"/>
                <c:pt idx="0">
                  <c:v>12-Oct-15</c:v>
                </c:pt>
                <c:pt idx="1">
                  <c:v>13-Oct-15</c:v>
                </c:pt>
                <c:pt idx="2">
                  <c:v>14-Oct-15</c:v>
                </c:pt>
                <c:pt idx="3">
                  <c:v>15-Oct-15</c:v>
                </c:pt>
                <c:pt idx="4">
                  <c:v>16-Oct-15</c:v>
                </c:pt>
                <c:pt idx="5">
                  <c:v>17-Oct-15</c:v>
                </c:pt>
                <c:pt idx="6">
                  <c:v>18-Oct-15</c:v>
                </c:pt>
                <c:pt idx="7">
                  <c:v>19-Oct-15</c:v>
                </c:pt>
                <c:pt idx="8">
                  <c:v>20-Oct-15</c:v>
                </c:pt>
                <c:pt idx="9">
                  <c:v>21-Oct-15</c:v>
                </c:pt>
                <c:pt idx="10">
                  <c:v>22-Oct-15</c:v>
                </c:pt>
                <c:pt idx="11">
                  <c:v>23-Oct-15</c:v>
                </c:pt>
                <c:pt idx="12">
                  <c:v>24-Oct-15</c:v>
                </c:pt>
                <c:pt idx="13">
                  <c:v>25-Oct-15</c:v>
                </c:pt>
                <c:pt idx="14">
                  <c:v>26-Oct-15</c:v>
                </c:pt>
                <c:pt idx="15">
                  <c:v>27-Oct-15</c:v>
                </c:pt>
                <c:pt idx="16">
                  <c:v>28-Oct-15</c:v>
                </c:pt>
                <c:pt idx="17">
                  <c:v>29-Oct-15</c:v>
                </c:pt>
                <c:pt idx="18">
                  <c:v>30-Oct-15</c:v>
                </c:pt>
                <c:pt idx="19">
                  <c:v>31-Oct-15</c:v>
                </c:pt>
                <c:pt idx="20">
                  <c:v>1-Nov-15</c:v>
                </c:pt>
                <c:pt idx="21">
                  <c:v>2-Nov-15</c:v>
                </c:pt>
                <c:pt idx="22">
                  <c:v>3-Nov-15</c:v>
                </c:pt>
                <c:pt idx="23">
                  <c:v>4-Nov-15</c:v>
                </c:pt>
                <c:pt idx="24">
                  <c:v>5-Nov-15</c:v>
                </c:pt>
                <c:pt idx="25">
                  <c:v>6-Nov-15</c:v>
                </c:pt>
                <c:pt idx="26">
                  <c:v>7-Nov-15</c:v>
                </c:pt>
                <c:pt idx="27">
                  <c:v>8-Nov-15</c:v>
                </c:pt>
                <c:pt idx="28">
                  <c:v>9-Nov-15</c:v>
                </c:pt>
                <c:pt idx="29">
                  <c:v>10-Nov-15</c:v>
                </c:pt>
                <c:pt idx="30">
                  <c:v>11-Nov-15</c:v>
                </c:pt>
                <c:pt idx="31">
                  <c:v>12-Nov-15</c:v>
                </c:pt>
                <c:pt idx="32">
                  <c:v>13-Nov-15</c:v>
                </c:pt>
                <c:pt idx="33">
                  <c:v>14-Nov-15</c:v>
                </c:pt>
                <c:pt idx="34">
                  <c:v>15-Nov-15</c:v>
                </c:pt>
                <c:pt idx="35">
                  <c:v>16-Nov-15</c:v>
                </c:pt>
              </c:strCache>
            </c:strRef>
          </c:cat>
          <c:val>
            <c:numRef>
              <c:f>0</c:f>
              <c:numCache>
                <c:formatCode>General</c:formatCode>
                <c:ptCount val="36"/>
                <c:pt idx="0">
                  <c:v>32.5343248744806</c:v>
                </c:pt>
                <c:pt idx="1">
                  <c:v>33.0611107560496</c:v>
                </c:pt>
                <c:pt idx="2">
                  <c:v>33.4732627185682</c:v>
                </c:pt>
                <c:pt idx="3">
                  <c:v>33.2832122221589</c:v>
                </c:pt>
                <c:pt idx="4">
                  <c:v>33.3699413885673</c:v>
                </c:pt>
                <c:pt idx="5">
                  <c:v>33.5795993295809</c:v>
                </c:pt>
                <c:pt idx="6">
                  <c:v>33.6689682056506</c:v>
                </c:pt>
                <c:pt idx="7">
                  <c:v>33.7462699661652</c:v>
                </c:pt>
                <c:pt idx="8">
                  <c:v>33.6912161360184</c:v>
                </c:pt>
                <c:pt idx="9">
                  <c:v>33.6090121418238</c:v>
                </c:pt>
                <c:pt idx="10">
                  <c:v>33.3974686451256</c:v>
                </c:pt>
                <c:pt idx="11">
                  <c:v>33.2406017308434</c:v>
                </c:pt>
                <c:pt idx="12">
                  <c:v>33.0652579354743</c:v>
                </c:pt>
                <c:pt idx="13">
                  <c:v>32.7997918861608</c:v>
                </c:pt>
                <c:pt idx="14">
                  <c:v>32.3408812905351</c:v>
                </c:pt>
                <c:pt idx="15">
                  <c:v>31.8367208043734</c:v>
                </c:pt>
                <c:pt idx="16">
                  <c:v>31.3951558743914</c:v>
                </c:pt>
                <c:pt idx="17">
                  <c:v>30.5497355759144</c:v>
                </c:pt>
                <c:pt idx="18">
                  <c:v>29.7295788613458</c:v>
                </c:pt>
                <c:pt idx="19">
                  <c:v>28.9625918182234</c:v>
                </c:pt>
                <c:pt idx="20">
                  <c:v>28.164306593438</c:v>
                </c:pt>
                <c:pt idx="21">
                  <c:v>27.3400020164748</c:v>
                </c:pt>
                <c:pt idx="22">
                  <c:v>26.613362506032</c:v>
                </c:pt>
                <c:pt idx="23">
                  <c:v>25.8870999018351</c:v>
                </c:pt>
                <c:pt idx="24">
                  <c:v>25.2023166355987</c:v>
                </c:pt>
                <c:pt idx="25">
                  <c:v>24.5160249372323</c:v>
                </c:pt>
                <c:pt idx="26">
                  <c:v>23.8598999877771</c:v>
                </c:pt>
                <c:pt idx="27">
                  <c:v>23.2686334600051</c:v>
                </c:pt>
                <c:pt idx="28">
                  <c:v>22.7177146511773</c:v>
                </c:pt>
                <c:pt idx="29">
                  <c:v>22.2569187792639</c:v>
                </c:pt>
                <c:pt idx="30">
                  <c:v>21.9963544203589</c:v>
                </c:pt>
                <c:pt idx="31">
                  <c:v>21.6415187188735</c:v>
                </c:pt>
                <c:pt idx="32">
                  <c:v>21.2780103087425</c:v>
                </c:pt>
                <c:pt idx="33">
                  <c:v>20.9288311501344</c:v>
                </c:pt>
                <c:pt idx="34">
                  <c:v>20.5555188314368</c:v>
                </c:pt>
                <c:pt idx="35">
                  <c:v>20.2977189794183</c:v>
                </c:pt>
              </c:numCache>
            </c:numRef>
          </c:val>
          <c:smooth val="0"/>
        </c:ser>
        <c:ser>
          <c:idx val="1"/>
          <c:order val="1"/>
          <c:tx>
            <c:strRef>
              <c:f>label 1</c:f>
              <c:strCache>
                <c:ptCount val="1"/>
                <c:pt idx="0">
                  <c:v>WS-15cm</c:v>
                </c:pt>
              </c:strCache>
            </c:strRef>
          </c:tx>
          <c:spPr>
            <a:solidFill>
              <a:srgbClr val="ed7d31"/>
            </a:solidFill>
            <a:ln cap="rnd" w="34920">
              <a:solidFill>
                <a:srgbClr val="ed7d31"/>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36"/>
                <c:pt idx="0">
                  <c:v>12-Oct-15</c:v>
                </c:pt>
                <c:pt idx="1">
                  <c:v>13-Oct-15</c:v>
                </c:pt>
                <c:pt idx="2">
                  <c:v>14-Oct-15</c:v>
                </c:pt>
                <c:pt idx="3">
                  <c:v>15-Oct-15</c:v>
                </c:pt>
                <c:pt idx="4">
                  <c:v>16-Oct-15</c:v>
                </c:pt>
                <c:pt idx="5">
                  <c:v>17-Oct-15</c:v>
                </c:pt>
                <c:pt idx="6">
                  <c:v>18-Oct-15</c:v>
                </c:pt>
                <c:pt idx="7">
                  <c:v>19-Oct-15</c:v>
                </c:pt>
                <c:pt idx="8">
                  <c:v>20-Oct-15</c:v>
                </c:pt>
                <c:pt idx="9">
                  <c:v>21-Oct-15</c:v>
                </c:pt>
                <c:pt idx="10">
                  <c:v>22-Oct-15</c:v>
                </c:pt>
                <c:pt idx="11">
                  <c:v>23-Oct-15</c:v>
                </c:pt>
                <c:pt idx="12">
                  <c:v>24-Oct-15</c:v>
                </c:pt>
                <c:pt idx="13">
                  <c:v>25-Oct-15</c:v>
                </c:pt>
                <c:pt idx="14">
                  <c:v>26-Oct-15</c:v>
                </c:pt>
                <c:pt idx="15">
                  <c:v>27-Oct-15</c:v>
                </c:pt>
                <c:pt idx="16">
                  <c:v>28-Oct-15</c:v>
                </c:pt>
                <c:pt idx="17">
                  <c:v>29-Oct-15</c:v>
                </c:pt>
                <c:pt idx="18">
                  <c:v>30-Oct-15</c:v>
                </c:pt>
                <c:pt idx="19">
                  <c:v>31-Oct-15</c:v>
                </c:pt>
                <c:pt idx="20">
                  <c:v>1-Nov-15</c:v>
                </c:pt>
                <c:pt idx="21">
                  <c:v>2-Nov-15</c:v>
                </c:pt>
                <c:pt idx="22">
                  <c:v>3-Nov-15</c:v>
                </c:pt>
                <c:pt idx="23">
                  <c:v>4-Nov-15</c:v>
                </c:pt>
                <c:pt idx="24">
                  <c:v>5-Nov-15</c:v>
                </c:pt>
                <c:pt idx="25">
                  <c:v>6-Nov-15</c:v>
                </c:pt>
                <c:pt idx="26">
                  <c:v>7-Nov-15</c:v>
                </c:pt>
                <c:pt idx="27">
                  <c:v>8-Nov-15</c:v>
                </c:pt>
                <c:pt idx="28">
                  <c:v>9-Nov-15</c:v>
                </c:pt>
                <c:pt idx="29">
                  <c:v>10-Nov-15</c:v>
                </c:pt>
                <c:pt idx="30">
                  <c:v>11-Nov-15</c:v>
                </c:pt>
                <c:pt idx="31">
                  <c:v>12-Nov-15</c:v>
                </c:pt>
                <c:pt idx="32">
                  <c:v>13-Nov-15</c:v>
                </c:pt>
                <c:pt idx="33">
                  <c:v>14-Nov-15</c:v>
                </c:pt>
                <c:pt idx="34">
                  <c:v>15-Nov-15</c:v>
                </c:pt>
                <c:pt idx="35">
                  <c:v>16-Nov-15</c:v>
                </c:pt>
              </c:strCache>
            </c:strRef>
          </c:cat>
          <c:val>
            <c:numRef>
              <c:f>1</c:f>
              <c:numCache>
                <c:formatCode>General</c:formatCode>
                <c:ptCount val="36"/>
                <c:pt idx="0">
                  <c:v>13.800447996861</c:v>
                </c:pt>
                <c:pt idx="1">
                  <c:v>12.9365501265662</c:v>
                </c:pt>
                <c:pt idx="2">
                  <c:v>11.018327010485</c:v>
                </c:pt>
                <c:pt idx="3">
                  <c:v>9.49528752050052</c:v>
                </c:pt>
                <c:pt idx="4">
                  <c:v>7.78219789693443</c:v>
                </c:pt>
                <c:pt idx="5">
                  <c:v>6.79178859475845</c:v>
                </c:pt>
                <c:pt idx="6">
                  <c:v>6.37624272203539</c:v>
                </c:pt>
                <c:pt idx="7">
                  <c:v>5.83607080382838</c:v>
                </c:pt>
                <c:pt idx="8">
                  <c:v>5.08548644914602</c:v>
                </c:pt>
                <c:pt idx="9">
                  <c:v>5.00347082464335</c:v>
                </c:pt>
                <c:pt idx="10">
                  <c:v>5.51083649916109</c:v>
                </c:pt>
                <c:pt idx="11">
                  <c:v>5.30589171855051</c:v>
                </c:pt>
                <c:pt idx="12">
                  <c:v>5.23990211901643</c:v>
                </c:pt>
                <c:pt idx="13">
                  <c:v>4.95614687994627</c:v>
                </c:pt>
                <c:pt idx="14">
                  <c:v>4.32057285597693</c:v>
                </c:pt>
                <c:pt idx="15">
                  <c:v>3.53039474523484</c:v>
                </c:pt>
                <c:pt idx="16">
                  <c:v>3.30339061352637</c:v>
                </c:pt>
                <c:pt idx="17">
                  <c:v>2.96967188881657</c:v>
                </c:pt>
                <c:pt idx="18">
                  <c:v>2.58221875701565</c:v>
                </c:pt>
                <c:pt idx="19">
                  <c:v>2.31015313438547</c:v>
                </c:pt>
                <c:pt idx="20">
                  <c:v>1.95399792925552</c:v>
                </c:pt>
                <c:pt idx="21">
                  <c:v>1.91402708078385</c:v>
                </c:pt>
                <c:pt idx="22">
                  <c:v>1.94268543491489</c:v>
                </c:pt>
                <c:pt idx="23">
                  <c:v>1.69588437456696</c:v>
                </c:pt>
                <c:pt idx="24">
                  <c:v>1.45964165058103</c:v>
                </c:pt>
                <c:pt idx="25">
                  <c:v>1.10706874596265</c:v>
                </c:pt>
                <c:pt idx="26">
                  <c:v>0.799745840049581</c:v>
                </c:pt>
                <c:pt idx="27">
                  <c:v>0.498079158811985</c:v>
                </c:pt>
                <c:pt idx="28">
                  <c:v>0.28314166944862</c:v>
                </c:pt>
                <c:pt idx="29">
                  <c:v>0.136267717607552</c:v>
                </c:pt>
                <c:pt idx="30">
                  <c:v>0.56029792613117</c:v>
                </c:pt>
                <c:pt idx="31">
                  <c:v>0.920035424011682</c:v>
                </c:pt>
                <c:pt idx="32">
                  <c:v>0.845372932963073</c:v>
                </c:pt>
                <c:pt idx="33">
                  <c:v>0.93247917733</c:v>
                </c:pt>
                <c:pt idx="34">
                  <c:v>0.913059390101504</c:v>
                </c:pt>
                <c:pt idx="35">
                  <c:v>0.832175012005286</c:v>
                </c:pt>
              </c:numCache>
            </c:numRef>
          </c:val>
          <c:smooth val="0"/>
        </c:ser>
        <c:ser>
          <c:idx val="2"/>
          <c:order val="2"/>
          <c:tx>
            <c:strRef>
              <c:f>label 2</c:f>
              <c:strCache>
                <c:ptCount val="1"/>
                <c:pt idx="0">
                  <c:v>WW-60cm</c:v>
                </c:pt>
              </c:strCache>
            </c:strRef>
          </c:tx>
          <c:spPr>
            <a:solidFill>
              <a:srgbClr val="a5a5a5"/>
            </a:solidFill>
            <a:ln cap="rnd" w="34920">
              <a:solidFill>
                <a:srgbClr val="a5a5a5"/>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36"/>
                <c:pt idx="0">
                  <c:v>12-Oct-15</c:v>
                </c:pt>
                <c:pt idx="1">
                  <c:v>13-Oct-15</c:v>
                </c:pt>
                <c:pt idx="2">
                  <c:v>14-Oct-15</c:v>
                </c:pt>
                <c:pt idx="3">
                  <c:v>15-Oct-15</c:v>
                </c:pt>
                <c:pt idx="4">
                  <c:v>16-Oct-15</c:v>
                </c:pt>
                <c:pt idx="5">
                  <c:v>17-Oct-15</c:v>
                </c:pt>
                <c:pt idx="6">
                  <c:v>18-Oct-15</c:v>
                </c:pt>
                <c:pt idx="7">
                  <c:v>19-Oct-15</c:v>
                </c:pt>
                <c:pt idx="8">
                  <c:v>20-Oct-15</c:v>
                </c:pt>
                <c:pt idx="9">
                  <c:v>21-Oct-15</c:v>
                </c:pt>
                <c:pt idx="10">
                  <c:v>22-Oct-15</c:v>
                </c:pt>
                <c:pt idx="11">
                  <c:v>23-Oct-15</c:v>
                </c:pt>
                <c:pt idx="12">
                  <c:v>24-Oct-15</c:v>
                </c:pt>
                <c:pt idx="13">
                  <c:v>25-Oct-15</c:v>
                </c:pt>
                <c:pt idx="14">
                  <c:v>26-Oct-15</c:v>
                </c:pt>
                <c:pt idx="15">
                  <c:v>27-Oct-15</c:v>
                </c:pt>
                <c:pt idx="16">
                  <c:v>28-Oct-15</c:v>
                </c:pt>
                <c:pt idx="17">
                  <c:v>29-Oct-15</c:v>
                </c:pt>
                <c:pt idx="18">
                  <c:v>30-Oct-15</c:v>
                </c:pt>
                <c:pt idx="19">
                  <c:v>31-Oct-15</c:v>
                </c:pt>
                <c:pt idx="20">
                  <c:v>1-Nov-15</c:v>
                </c:pt>
                <c:pt idx="21">
                  <c:v>2-Nov-15</c:v>
                </c:pt>
                <c:pt idx="22">
                  <c:v>3-Nov-15</c:v>
                </c:pt>
                <c:pt idx="23">
                  <c:v>4-Nov-15</c:v>
                </c:pt>
                <c:pt idx="24">
                  <c:v>5-Nov-15</c:v>
                </c:pt>
                <c:pt idx="25">
                  <c:v>6-Nov-15</c:v>
                </c:pt>
                <c:pt idx="26">
                  <c:v>7-Nov-15</c:v>
                </c:pt>
                <c:pt idx="27">
                  <c:v>8-Nov-15</c:v>
                </c:pt>
                <c:pt idx="28">
                  <c:v>9-Nov-15</c:v>
                </c:pt>
                <c:pt idx="29">
                  <c:v>10-Nov-15</c:v>
                </c:pt>
                <c:pt idx="30">
                  <c:v>11-Nov-15</c:v>
                </c:pt>
                <c:pt idx="31">
                  <c:v>12-Nov-15</c:v>
                </c:pt>
                <c:pt idx="32">
                  <c:v>13-Nov-15</c:v>
                </c:pt>
                <c:pt idx="33">
                  <c:v>14-Nov-15</c:v>
                </c:pt>
                <c:pt idx="34">
                  <c:v>15-Nov-15</c:v>
                </c:pt>
                <c:pt idx="35">
                  <c:v>16-Nov-15</c:v>
                </c:pt>
              </c:strCache>
            </c:strRef>
          </c:cat>
          <c:val>
            <c:numRef>
              <c:f>2</c:f>
              <c:numCache>
                <c:formatCode>General</c:formatCode>
                <c:ptCount val="36"/>
                <c:pt idx="0">
                  <c:v>29.3326990911737</c:v>
                </c:pt>
                <c:pt idx="1">
                  <c:v>29.7244881046936</c:v>
                </c:pt>
                <c:pt idx="2">
                  <c:v>29.7182662334914</c:v>
                </c:pt>
                <c:pt idx="3">
                  <c:v>29.5470709912479</c:v>
                </c:pt>
                <c:pt idx="4">
                  <c:v>29.6518999384716</c:v>
                </c:pt>
                <c:pt idx="5">
                  <c:v>29.9596003101518</c:v>
                </c:pt>
                <c:pt idx="6">
                  <c:v>30.0904482292632</c:v>
                </c:pt>
                <c:pt idx="7">
                  <c:v>29.9844872982552</c:v>
                </c:pt>
                <c:pt idx="8">
                  <c:v>29.5974118712669</c:v>
                </c:pt>
                <c:pt idx="9">
                  <c:v>29.3905815264831</c:v>
                </c:pt>
                <c:pt idx="10">
                  <c:v>29.6733937303846</c:v>
                </c:pt>
                <c:pt idx="11">
                  <c:v>30.1636021429052</c:v>
                </c:pt>
                <c:pt idx="12">
                  <c:v>30.3227309137583</c:v>
                </c:pt>
                <c:pt idx="13">
                  <c:v>30.3106646208713</c:v>
                </c:pt>
                <c:pt idx="14">
                  <c:v>30.1234426054483</c:v>
                </c:pt>
                <c:pt idx="15">
                  <c:v>29.9369751475751</c:v>
                </c:pt>
                <c:pt idx="16">
                  <c:v>30.1941460929811</c:v>
                </c:pt>
                <c:pt idx="17">
                  <c:v>30.1100565353408</c:v>
                </c:pt>
                <c:pt idx="18">
                  <c:v>30.0953500904143</c:v>
                </c:pt>
                <c:pt idx="19">
                  <c:v>30.0189906964079</c:v>
                </c:pt>
                <c:pt idx="20">
                  <c:v>30.041050290068</c:v>
                </c:pt>
                <c:pt idx="21">
                  <c:v>29.970347112976</c:v>
                </c:pt>
                <c:pt idx="22">
                  <c:v>29.926416852201</c:v>
                </c:pt>
                <c:pt idx="23">
                  <c:v>29.9428200271601</c:v>
                </c:pt>
                <c:pt idx="24">
                  <c:v>30.0201219817003</c:v>
                </c:pt>
                <c:pt idx="25">
                  <c:v>30.0344511711349</c:v>
                </c:pt>
                <c:pt idx="26">
                  <c:v>30.0065470005696</c:v>
                </c:pt>
                <c:pt idx="27">
                  <c:v>29.9464018937821</c:v>
                </c:pt>
                <c:pt idx="28">
                  <c:v>29.7523927409202</c:v>
                </c:pt>
                <c:pt idx="29">
                  <c:v>29.7269393922761</c:v>
                </c:pt>
                <c:pt idx="30">
                  <c:v>29.8125372190649</c:v>
                </c:pt>
                <c:pt idx="31">
                  <c:v>29.9999479437247</c:v>
                </c:pt>
                <c:pt idx="32">
                  <c:v>30.1455024940272</c:v>
                </c:pt>
                <c:pt idx="33">
                  <c:v>30.0229501444846</c:v>
                </c:pt>
                <c:pt idx="34">
                  <c:v>30.0340740863855</c:v>
                </c:pt>
                <c:pt idx="35">
                  <c:v>29.9998222746783</c:v>
                </c:pt>
              </c:numCache>
            </c:numRef>
          </c:val>
          <c:smooth val="0"/>
        </c:ser>
        <c:ser>
          <c:idx val="3"/>
          <c:order val="3"/>
          <c:tx>
            <c:strRef>
              <c:f>label 3</c:f>
              <c:strCache>
                <c:ptCount val="1"/>
                <c:pt idx="0">
                  <c:v>WS-60cm</c:v>
                </c:pt>
              </c:strCache>
            </c:strRef>
          </c:tx>
          <c:spPr>
            <a:solidFill>
              <a:srgbClr val="ffc000"/>
            </a:solidFill>
            <a:ln cap="rnd" w="34920">
              <a:solidFill>
                <a:srgbClr val="ffc000"/>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cat>
            <c:strRef>
              <c:f>categories</c:f>
              <c:strCache>
                <c:ptCount val="36"/>
                <c:pt idx="0">
                  <c:v>12-Oct-15</c:v>
                </c:pt>
                <c:pt idx="1">
                  <c:v>13-Oct-15</c:v>
                </c:pt>
                <c:pt idx="2">
                  <c:v>14-Oct-15</c:v>
                </c:pt>
                <c:pt idx="3">
                  <c:v>15-Oct-15</c:v>
                </c:pt>
                <c:pt idx="4">
                  <c:v>16-Oct-15</c:v>
                </c:pt>
                <c:pt idx="5">
                  <c:v>17-Oct-15</c:v>
                </c:pt>
                <c:pt idx="6">
                  <c:v>18-Oct-15</c:v>
                </c:pt>
                <c:pt idx="7">
                  <c:v>19-Oct-15</c:v>
                </c:pt>
                <c:pt idx="8">
                  <c:v>20-Oct-15</c:v>
                </c:pt>
                <c:pt idx="9">
                  <c:v>21-Oct-15</c:v>
                </c:pt>
                <c:pt idx="10">
                  <c:v>22-Oct-15</c:v>
                </c:pt>
                <c:pt idx="11">
                  <c:v>23-Oct-15</c:v>
                </c:pt>
                <c:pt idx="12">
                  <c:v>24-Oct-15</c:v>
                </c:pt>
                <c:pt idx="13">
                  <c:v>25-Oct-15</c:v>
                </c:pt>
                <c:pt idx="14">
                  <c:v>26-Oct-15</c:v>
                </c:pt>
                <c:pt idx="15">
                  <c:v>27-Oct-15</c:v>
                </c:pt>
                <c:pt idx="16">
                  <c:v>28-Oct-15</c:v>
                </c:pt>
                <c:pt idx="17">
                  <c:v>29-Oct-15</c:v>
                </c:pt>
                <c:pt idx="18">
                  <c:v>30-Oct-15</c:v>
                </c:pt>
                <c:pt idx="19">
                  <c:v>31-Oct-15</c:v>
                </c:pt>
                <c:pt idx="20">
                  <c:v>1-Nov-15</c:v>
                </c:pt>
                <c:pt idx="21">
                  <c:v>2-Nov-15</c:v>
                </c:pt>
                <c:pt idx="22">
                  <c:v>3-Nov-15</c:v>
                </c:pt>
                <c:pt idx="23">
                  <c:v>4-Nov-15</c:v>
                </c:pt>
                <c:pt idx="24">
                  <c:v>5-Nov-15</c:v>
                </c:pt>
                <c:pt idx="25">
                  <c:v>6-Nov-15</c:v>
                </c:pt>
                <c:pt idx="26">
                  <c:v>7-Nov-15</c:v>
                </c:pt>
                <c:pt idx="27">
                  <c:v>8-Nov-15</c:v>
                </c:pt>
                <c:pt idx="28">
                  <c:v>9-Nov-15</c:v>
                </c:pt>
                <c:pt idx="29">
                  <c:v>10-Nov-15</c:v>
                </c:pt>
                <c:pt idx="30">
                  <c:v>11-Nov-15</c:v>
                </c:pt>
                <c:pt idx="31">
                  <c:v>12-Nov-15</c:v>
                </c:pt>
                <c:pt idx="32">
                  <c:v>13-Nov-15</c:v>
                </c:pt>
                <c:pt idx="33">
                  <c:v>14-Nov-15</c:v>
                </c:pt>
                <c:pt idx="34">
                  <c:v>15-Nov-15</c:v>
                </c:pt>
                <c:pt idx="35">
                  <c:v>16-Nov-15</c:v>
                </c:pt>
              </c:strCache>
            </c:strRef>
          </c:cat>
          <c:val>
            <c:numRef>
              <c:f>3</c:f>
              <c:numCache>
                <c:formatCode>General</c:formatCode>
                <c:ptCount val="36"/>
                <c:pt idx="0">
                  <c:v>15.1341914199293</c:v>
                </c:pt>
                <c:pt idx="1">
                  <c:v>13.9335582343241</c:v>
                </c:pt>
                <c:pt idx="2">
                  <c:v>13.3192896532516</c:v>
                </c:pt>
                <c:pt idx="3">
                  <c:v>13.3143874661376</c:v>
                </c:pt>
                <c:pt idx="4">
                  <c:v>13.3404061819116</c:v>
                </c:pt>
                <c:pt idx="5">
                  <c:v>13.2401022439202</c:v>
                </c:pt>
                <c:pt idx="6">
                  <c:v>13.1141564808786</c:v>
                </c:pt>
                <c:pt idx="7">
                  <c:v>13.0772021599114</c:v>
                </c:pt>
                <c:pt idx="8">
                  <c:v>13.0843666382134</c:v>
                </c:pt>
                <c:pt idx="9">
                  <c:v>13.161668771257</c:v>
                </c:pt>
                <c:pt idx="10">
                  <c:v>13.1997542611013</c:v>
                </c:pt>
                <c:pt idx="11">
                  <c:v>13.1903271035602</c:v>
                </c:pt>
                <c:pt idx="12">
                  <c:v>13.1371583789587</c:v>
                </c:pt>
                <c:pt idx="13">
                  <c:v>13.0575940789034</c:v>
                </c:pt>
                <c:pt idx="14">
                  <c:v>12.7770439799254</c:v>
                </c:pt>
                <c:pt idx="15">
                  <c:v>12.4259791880225</c:v>
                </c:pt>
                <c:pt idx="16">
                  <c:v>12.3622519817824</c:v>
                </c:pt>
                <c:pt idx="17">
                  <c:v>12.2955083381385</c:v>
                </c:pt>
                <c:pt idx="18">
                  <c:v>12.2540293261409</c:v>
                </c:pt>
                <c:pt idx="19">
                  <c:v>12.224993792673</c:v>
                </c:pt>
                <c:pt idx="20">
                  <c:v>12.1243125371014</c:v>
                </c:pt>
                <c:pt idx="21">
                  <c:v>12.0764230921244</c:v>
                </c:pt>
                <c:pt idx="22">
                  <c:v>12.0752918766812</c:v>
                </c:pt>
                <c:pt idx="23">
                  <c:v>12.0583231638496</c:v>
                </c:pt>
                <c:pt idx="24">
                  <c:v>12.0345668246349</c:v>
                </c:pt>
                <c:pt idx="25">
                  <c:v>11.8882582522929</c:v>
                </c:pt>
                <c:pt idx="26">
                  <c:v>11.8218915925051</c:v>
                </c:pt>
                <c:pt idx="27">
                  <c:v>11.6838791640475</c:v>
                </c:pt>
                <c:pt idx="28">
                  <c:v>11.5779187607889</c:v>
                </c:pt>
                <c:pt idx="29">
                  <c:v>11.4979770267382</c:v>
                </c:pt>
                <c:pt idx="30">
                  <c:v>11.3791957109546</c:v>
                </c:pt>
                <c:pt idx="31">
                  <c:v>11.2091312572981</c:v>
                </c:pt>
                <c:pt idx="32">
                  <c:v>11.0650854573275</c:v>
                </c:pt>
                <c:pt idx="33">
                  <c:v>10.8874791534618</c:v>
                </c:pt>
                <c:pt idx="34">
                  <c:v>10.7498438407977</c:v>
                </c:pt>
                <c:pt idx="35">
                  <c:v>10.7358916041752</c:v>
                </c:pt>
              </c:numCache>
            </c:numRef>
          </c:val>
          <c:smooth val="0"/>
        </c:ser>
        <c:hiLowLines>
          <c:spPr>
            <a:ln w="0">
              <a:noFill/>
            </a:ln>
          </c:spPr>
        </c:hiLowLines>
        <c:marker val="0"/>
        <c:axId val="65263948"/>
        <c:axId val="48192103"/>
      </c:lineChart>
      <c:dateAx>
        <c:axId val="65263948"/>
        <c:scaling>
          <c:orientation val="minMax"/>
        </c:scaling>
        <c:delete val="0"/>
        <c:axPos val="b"/>
        <c:numFmt formatCode="d\-mmm\-yy" sourceLinked="0"/>
        <c:majorTickMark val="out"/>
        <c:minorTickMark val="none"/>
        <c:tickLblPos val="nextTo"/>
        <c:spPr>
          <a:ln w="12600">
            <a:solidFill>
              <a:srgbClr val="d9d9d9"/>
            </a:solidFill>
            <a:round/>
          </a:ln>
        </c:spPr>
        <c:txPr>
          <a:bodyPr/>
          <a:lstStyle/>
          <a:p>
            <a:pPr>
              <a:defRPr b="0" sz="900" spc="-1" strike="noStrike">
                <a:solidFill>
                  <a:srgbClr val="595959"/>
                </a:solidFill>
                <a:latin typeface="Calibri"/>
                <a:ea typeface="DejaVu Sans"/>
              </a:defRPr>
            </a:pPr>
          </a:p>
        </c:txPr>
        <c:crossAx val="48192103"/>
        <c:crosses val="autoZero"/>
        <c:auto val="1"/>
        <c:lblOffset val="100"/>
        <c:baseTimeUnit val="days"/>
        <c:noMultiLvlLbl val="0"/>
      </c:dateAx>
      <c:valAx>
        <c:axId val="48192103"/>
        <c:scaling>
          <c:orientation val="minMax"/>
        </c:scaling>
        <c:delete val="0"/>
        <c:axPos val="l"/>
        <c:majorGridlines>
          <c:spPr>
            <a:ln w="9360">
              <a:solidFill>
                <a:srgbClr val="d9d9d9"/>
              </a:solidFill>
              <a:round/>
            </a:ln>
          </c:spPr>
        </c:majorGridlines>
        <c:numFmt formatCode="0" sourceLinked="0"/>
        <c:majorTickMark val="none"/>
        <c:minorTickMark val="none"/>
        <c:tickLblPos val="nextTo"/>
        <c:spPr>
          <a:ln w="6480">
            <a:noFill/>
          </a:ln>
        </c:spPr>
        <c:txPr>
          <a:bodyPr/>
          <a:lstStyle/>
          <a:p>
            <a:pPr>
              <a:defRPr b="0" sz="900" spc="-1" strike="noStrike">
                <a:solidFill>
                  <a:srgbClr val="595959"/>
                </a:solidFill>
                <a:latin typeface="Calibri"/>
                <a:ea typeface="DejaVu Sans"/>
              </a:defRPr>
            </a:pPr>
          </a:p>
        </c:txPr>
        <c:crossAx val="65263948"/>
        <c:crosses val="autoZero"/>
        <c:crossBetween val="between"/>
      </c:valAx>
      <c:spPr>
        <a:noFill/>
        <a:ln w="0">
          <a:noFill/>
        </a:ln>
      </c:spPr>
    </c:plotArea>
    <c:plotVisOnly val="1"/>
    <c:dispBlanksAs val="gap"/>
  </c:chart>
  <c:spPr>
    <a:noFill/>
    <a:ln w="9360">
      <a:noFill/>
    </a:ln>
  </c:spPr>
</c:chartSpace>
</file>

<file path=ppt/charts/chart15.xml><?xml version="1.0" encoding="utf-8"?>
<c:chartSpace xmlns:c="http://schemas.openxmlformats.org/drawingml/2006/chart" xmlns:a="http://schemas.openxmlformats.org/drawingml/2006/main" xmlns:r="http://schemas.openxmlformats.org/officeDocument/2006/relationships">
  <c:lang val="en-US"/>
  <c:roundedCorners val="0"/>
  <c:chart>
    <c:autoTitleDeleted val="1"/>
    <c:plotArea>
      <c:layout>
        <c:manualLayout>
          <c:layoutTarget val="inner"/>
          <c:xMode val="edge"/>
          <c:yMode val="edge"/>
          <c:x val="0.0729068850242272"/>
          <c:y val="0.0602925437031752"/>
          <c:w val="0.904706456823048"/>
          <c:h val="0.659055773575931"/>
        </c:manualLayout>
      </c:layout>
      <c:lineChart>
        <c:grouping val="standard"/>
        <c:varyColors val="0"/>
        <c:ser>
          <c:idx val="0"/>
          <c:order val="0"/>
          <c:tx>
            <c:strRef>
              <c:f>label 0</c:f>
              <c:strCache>
                <c:ptCount val="1"/>
                <c:pt idx="0">
                  <c:v>BD805-RF</c:v>
                </c:pt>
              </c:strCache>
            </c:strRef>
          </c:tx>
          <c:spPr>
            <a:solidFill>
              <a:srgbClr val="70ad47"/>
            </a:solidFill>
            <a:ln cap="rnd" w="28440">
              <a:solidFill>
                <a:srgbClr val="70ad47"/>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0</c:f>
              <c:numCache>
                <c:formatCode>General</c:formatCode>
                <c:ptCount val="17"/>
                <c:pt idx="0">
                  <c:v>0.33052755418171</c:v>
                </c:pt>
                <c:pt idx="1">
                  <c:v>0.349040188307074</c:v>
                </c:pt>
                <c:pt idx="2">
                  <c:v>0.402267251004871</c:v>
                </c:pt>
                <c:pt idx="3">
                  <c:v>0.397846793145535</c:v>
                </c:pt>
                <c:pt idx="4">
                  <c:v>0.458888188176277</c:v>
                </c:pt>
                <c:pt idx="5">
                  <c:v>0.456896221047474</c:v>
                </c:pt>
                <c:pt idx="6">
                  <c:v>0.502108406405105</c:v>
                </c:pt>
                <c:pt idx="7">
                  <c:v>0.420728033288652</c:v>
                </c:pt>
                <c:pt idx="8">
                  <c:v>0.288261293640976</c:v>
                </c:pt>
                <c:pt idx="9">
                  <c:v>0.41604704725191</c:v>
                </c:pt>
                <c:pt idx="10">
                  <c:v>0.338247978537337</c:v>
                </c:pt>
                <c:pt idx="11">
                  <c:v>0.385801501396398</c:v>
                </c:pt>
                <c:pt idx="12">
                  <c:v>0.255219914311558</c:v>
                </c:pt>
                <c:pt idx="13">
                  <c:v>0.298865219462366</c:v>
                </c:pt>
                <c:pt idx="14">
                  <c:v>0.408290257480309</c:v>
                </c:pt>
                <c:pt idx="15">
                  <c:v>0.429115366876775</c:v>
                </c:pt>
                <c:pt idx="16">
                  <c:v>0.388499512557438</c:v>
                </c:pt>
              </c:numCache>
            </c:numRef>
          </c:val>
          <c:smooth val="0"/>
        </c:ser>
        <c:ser>
          <c:idx val="1"/>
          <c:order val="1"/>
          <c:tx>
            <c:strRef>
              <c:f>label 1</c:f>
              <c:strCache>
                <c:ptCount val="1"/>
                <c:pt idx="0">
                  <c:v>PI478-RF</c:v>
                </c:pt>
              </c:strCache>
            </c:strRef>
          </c:tx>
          <c:spPr>
            <a:solidFill>
              <a:srgbClr val="4472c4"/>
            </a:solidFill>
            <a:ln cap="rnd" w="28440">
              <a:solidFill>
                <a:srgbClr val="4472c4"/>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1</c:f>
              <c:numCache>
                <c:formatCode>General</c:formatCode>
                <c:ptCount val="17"/>
                <c:pt idx="0">
                  <c:v>0.27629070696275</c:v>
                </c:pt>
                <c:pt idx="1">
                  <c:v>0.306017958713331</c:v>
                </c:pt>
                <c:pt idx="2">
                  <c:v>0.367854852156565</c:v>
                </c:pt>
                <c:pt idx="3">
                  <c:v>0.367449267191088</c:v>
                </c:pt>
                <c:pt idx="4">
                  <c:v>0.460885379647254</c:v>
                </c:pt>
                <c:pt idx="5">
                  <c:v>0.454913733715209</c:v>
                </c:pt>
                <c:pt idx="6">
                  <c:v>0.493726994743042</c:v>
                </c:pt>
                <c:pt idx="7">
                  <c:v>0.436025334436523</c:v>
                </c:pt>
                <c:pt idx="8">
                  <c:v>0.269937022173347</c:v>
                </c:pt>
                <c:pt idx="9">
                  <c:v>0.401802627507103</c:v>
                </c:pt>
                <c:pt idx="10">
                  <c:v>0.274565914761891</c:v>
                </c:pt>
                <c:pt idx="11">
                  <c:v>0.374335502976353</c:v>
                </c:pt>
                <c:pt idx="12">
                  <c:v>0.258873492488203</c:v>
                </c:pt>
                <c:pt idx="13">
                  <c:v>0.259902414866803</c:v>
                </c:pt>
                <c:pt idx="14">
                  <c:v>0.399189176166184</c:v>
                </c:pt>
                <c:pt idx="15">
                  <c:v>0.452850004114442</c:v>
                </c:pt>
                <c:pt idx="16">
                  <c:v>0.426831479446109</c:v>
                </c:pt>
              </c:numCache>
            </c:numRef>
          </c:val>
          <c:smooth val="0"/>
        </c:ser>
        <c:ser>
          <c:idx val="2"/>
          <c:order val="2"/>
          <c:tx>
            <c:strRef>
              <c:f>label 2</c:f>
              <c:strCache>
                <c:ptCount val="1"/>
                <c:pt idx="0">
                  <c:v>PI502-RF</c:v>
                </c:pt>
              </c:strCache>
            </c:strRef>
          </c:tx>
          <c:spPr>
            <a:solidFill>
              <a:srgbClr val="ffc000"/>
            </a:solidFill>
            <a:ln cap="rnd" w="28440">
              <a:solidFill>
                <a:srgbClr val="ffc000"/>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2</c:f>
              <c:numCache>
                <c:formatCode>General</c:formatCode>
                <c:ptCount val="17"/>
                <c:pt idx="0">
                  <c:v>0.330197478357994</c:v>
                </c:pt>
                <c:pt idx="1">
                  <c:v>0.357221238107585</c:v>
                </c:pt>
                <c:pt idx="2">
                  <c:v>0.382176622608446</c:v>
                </c:pt>
                <c:pt idx="3">
                  <c:v>0.37928910923996</c:v>
                </c:pt>
                <c:pt idx="4">
                  <c:v>0.435866692467942</c:v>
                </c:pt>
                <c:pt idx="5">
                  <c:v>0.442251900124929</c:v>
                </c:pt>
                <c:pt idx="6">
                  <c:v>0.49497668164893</c:v>
                </c:pt>
                <c:pt idx="7">
                  <c:v>0.430298626641582</c:v>
                </c:pt>
                <c:pt idx="8">
                  <c:v>0.284124018323949</c:v>
                </c:pt>
                <c:pt idx="9">
                  <c:v>0.404929933371308</c:v>
                </c:pt>
                <c:pt idx="10">
                  <c:v>0.322406059109958</c:v>
                </c:pt>
                <c:pt idx="11">
                  <c:v>0.407122617306906</c:v>
                </c:pt>
                <c:pt idx="12">
                  <c:v>0.273630850000514</c:v>
                </c:pt>
                <c:pt idx="13">
                  <c:v>0.312131012880502</c:v>
                </c:pt>
                <c:pt idx="14">
                  <c:v>0.384090373067631</c:v>
                </c:pt>
                <c:pt idx="15">
                  <c:v>0.449424958748732</c:v>
                </c:pt>
                <c:pt idx="16">
                  <c:v>0.362461674695236</c:v>
                </c:pt>
              </c:numCache>
            </c:numRef>
          </c:val>
          <c:smooth val="0"/>
        </c:ser>
        <c:hiLowLines>
          <c:spPr>
            <a:ln w="0">
              <a:noFill/>
            </a:ln>
          </c:spPr>
        </c:hiLowLines>
        <c:marker val="0"/>
        <c:axId val="24454791"/>
        <c:axId val="7725575"/>
      </c:lineChart>
      <c:catAx>
        <c:axId val="24454791"/>
        <c:scaling>
          <c:orientation val="minMax"/>
        </c:scaling>
        <c:delete val="0"/>
        <c:axPos val="b"/>
        <c:numFmt formatCode="General" sourceLinked="0"/>
        <c:majorTickMark val="none"/>
        <c:minorTickMark val="none"/>
        <c:tickLblPos val="nextTo"/>
        <c:spPr>
          <a:ln w="9360">
            <a:solidFill>
              <a:srgbClr val="d9d9d9"/>
            </a:solidFill>
            <a:round/>
          </a:ln>
        </c:spPr>
        <c:txPr>
          <a:bodyPr/>
          <a:lstStyle/>
          <a:p>
            <a:pPr>
              <a:defRPr b="0" sz="900" spc="-1" strike="noStrike">
                <a:solidFill>
                  <a:srgbClr val="000000"/>
                </a:solidFill>
                <a:latin typeface="Calibri"/>
                <a:ea typeface="DejaVu Sans"/>
              </a:defRPr>
            </a:pPr>
          </a:p>
        </c:txPr>
        <c:crossAx val="7725575"/>
        <c:crosses val="autoZero"/>
        <c:auto val="1"/>
        <c:lblAlgn val="ctr"/>
        <c:lblOffset val="100"/>
        <c:noMultiLvlLbl val="0"/>
      </c:catAx>
      <c:valAx>
        <c:axId val="7725575"/>
        <c:scaling>
          <c:orientation val="minMax"/>
        </c:scaling>
        <c:delete val="0"/>
        <c:axPos val="l"/>
        <c:majorGridlines>
          <c:spPr>
            <a:ln w="9360">
              <a:solidFill>
                <a:srgbClr val="d9d9d9"/>
              </a:solidFill>
              <a:round/>
            </a:ln>
          </c:spPr>
        </c:majorGridlines>
        <c:numFmt formatCode="General" sourceLinked="0"/>
        <c:majorTickMark val="none"/>
        <c:minorTickMark val="none"/>
        <c:tickLblPos val="nextTo"/>
        <c:spPr>
          <a:ln w="6480">
            <a:solidFill>
              <a:srgbClr val="000000"/>
            </a:solidFill>
            <a:round/>
          </a:ln>
        </c:spPr>
        <c:txPr>
          <a:bodyPr/>
          <a:lstStyle/>
          <a:p>
            <a:pPr>
              <a:defRPr b="0" sz="900" spc="-1" strike="noStrike">
                <a:solidFill>
                  <a:srgbClr val="000000"/>
                </a:solidFill>
                <a:latin typeface="Calibri"/>
                <a:ea typeface="DejaVu Sans"/>
              </a:defRPr>
            </a:pPr>
          </a:p>
        </c:txPr>
        <c:crossAx val="24454791"/>
        <c:crosses val="autoZero"/>
        <c:crossBetween val="between"/>
      </c:valAx>
      <c:spPr>
        <a:noFill/>
        <a:ln w="0">
          <a:noFill/>
        </a:ln>
      </c:spPr>
    </c:plotArea>
    <c:legend>
      <c:legendPos val="b"/>
      <c:layout>
        <c:manualLayout>
          <c:xMode val="edge"/>
          <c:yMode val="edge"/>
          <c:x val="0.359267232859916"/>
          <c:y val="0.801989659367597"/>
          <c:w val="0.295527067549583"/>
          <c:h val="0.0661769133311986"/>
        </c:manualLayout>
      </c:layout>
      <c:overlay val="0"/>
      <c:spPr>
        <a:noFill/>
        <a:ln w="0">
          <a:noFill/>
        </a:ln>
      </c:spPr>
      <c:txPr>
        <a:bodyPr/>
        <a:lstStyle/>
        <a:p>
          <a:pPr>
            <a:defRPr b="0" sz="900" spc="-1" strike="noStrike">
              <a:solidFill>
                <a:srgbClr val="000000"/>
              </a:solidFill>
              <a:latin typeface="Calibri"/>
              <a:ea typeface="DejaVu Sans"/>
            </a:defRPr>
          </a:pPr>
        </a:p>
      </c:txPr>
    </c:legend>
    <c:plotVisOnly val="1"/>
    <c:dispBlanksAs val="gap"/>
  </c:chart>
  <c:spPr>
    <a:noFill/>
    <a:ln w="9360">
      <a:noFill/>
    </a:ln>
  </c:spPr>
</c:chartSpace>
</file>

<file path=ppt/charts/chart16.xml><?xml version="1.0" encoding="utf-8"?>
<c:chartSpace xmlns:c="http://schemas.openxmlformats.org/drawingml/2006/chart" xmlns:a="http://schemas.openxmlformats.org/drawingml/2006/main" xmlns:r="http://schemas.openxmlformats.org/officeDocument/2006/relationships">
  <c:lang val="en-US"/>
  <c:roundedCorners val="0"/>
  <c:chart>
    <c:autoTitleDeleted val="1"/>
    <c:plotArea>
      <c:layout>
        <c:manualLayout>
          <c:layoutTarget val="inner"/>
          <c:xMode val="edge"/>
          <c:yMode val="edge"/>
          <c:x val="0.0387611998441761"/>
          <c:y val="0.0584689572031344"/>
          <c:w val="0.935722633424231"/>
          <c:h val="0.816757082579867"/>
        </c:manualLayout>
      </c:layout>
      <c:lineChart>
        <c:grouping val="standard"/>
        <c:varyColors val="0"/>
        <c:ser>
          <c:idx val="0"/>
          <c:order val="0"/>
          <c:tx>
            <c:strRef>
              <c:f>label 0</c:f>
              <c:strCache>
                <c:ptCount val="1"/>
                <c:pt idx="0">
                  <c:v>BD805-IR</c:v>
                </c:pt>
              </c:strCache>
            </c:strRef>
          </c:tx>
          <c:spPr>
            <a:solidFill>
              <a:srgbClr val="70ad47"/>
            </a:solidFill>
            <a:ln cap="rnd" w="28440">
              <a:solidFill>
                <a:srgbClr val="70ad47"/>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0</c:f>
              <c:numCache>
                <c:formatCode>General</c:formatCode>
                <c:ptCount val="17"/>
                <c:pt idx="0">
                  <c:v>0.334367536963999</c:v>
                </c:pt>
                <c:pt idx="1">
                  <c:v>0.3534177070766</c:v>
                </c:pt>
                <c:pt idx="2">
                  <c:v>0.404787996202272</c:v>
                </c:pt>
                <c:pt idx="3">
                  <c:v>0.409040695146013</c:v>
                </c:pt>
                <c:pt idx="4">
                  <c:v>0.437795717503153</c:v>
                </c:pt>
                <c:pt idx="5">
                  <c:v>0.486872618052677</c:v>
                </c:pt>
                <c:pt idx="6">
                  <c:v>0.489127176757752</c:v>
                </c:pt>
                <c:pt idx="7">
                  <c:v>0.423290686405212</c:v>
                </c:pt>
                <c:pt idx="8">
                  <c:v>0.276738075625674</c:v>
                </c:pt>
                <c:pt idx="9">
                  <c:v>0.360816526069432</c:v>
                </c:pt>
                <c:pt idx="10">
                  <c:v>0.336631390377998</c:v>
                </c:pt>
                <c:pt idx="11">
                  <c:v>0.442309418011634</c:v>
                </c:pt>
                <c:pt idx="12">
                  <c:v>0.274818465567437</c:v>
                </c:pt>
                <c:pt idx="13">
                  <c:v>0.396456342155937</c:v>
                </c:pt>
                <c:pt idx="14">
                  <c:v>0.412203489284994</c:v>
                </c:pt>
                <c:pt idx="15">
                  <c:v>0.436790624551725</c:v>
                </c:pt>
                <c:pt idx="16">
                  <c:v>0.384987790842057</c:v>
                </c:pt>
              </c:numCache>
            </c:numRef>
          </c:val>
          <c:smooth val="0"/>
        </c:ser>
        <c:ser>
          <c:idx val="1"/>
          <c:order val="1"/>
          <c:tx>
            <c:strRef>
              <c:f>label 1</c:f>
              <c:strCache>
                <c:ptCount val="1"/>
                <c:pt idx="0">
                  <c:v>PI478-IR</c:v>
                </c:pt>
              </c:strCache>
            </c:strRef>
          </c:tx>
          <c:spPr>
            <a:solidFill>
              <a:srgbClr val="4472c4"/>
            </a:solidFill>
            <a:ln cap="rnd" w="28440">
              <a:solidFill>
                <a:srgbClr val="4472c4"/>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1</c:f>
              <c:numCache>
                <c:formatCode>General</c:formatCode>
                <c:ptCount val="17"/>
                <c:pt idx="0">
                  <c:v>0.282993247024691</c:v>
                </c:pt>
                <c:pt idx="1">
                  <c:v>0.306848820240974</c:v>
                </c:pt>
                <c:pt idx="2">
                  <c:v>0.384202569229654</c:v>
                </c:pt>
                <c:pt idx="3">
                  <c:v>0.390589621212677</c:v>
                </c:pt>
                <c:pt idx="4">
                  <c:v>0.412963622420535</c:v>
                </c:pt>
                <c:pt idx="5">
                  <c:v>0.473808765091068</c:v>
                </c:pt>
                <c:pt idx="6">
                  <c:v>0.485016363543278</c:v>
                </c:pt>
                <c:pt idx="7">
                  <c:v>0.413494920166947</c:v>
                </c:pt>
                <c:pt idx="8">
                  <c:v>0.253790286211201</c:v>
                </c:pt>
                <c:pt idx="9">
                  <c:v>0.304949240228795</c:v>
                </c:pt>
                <c:pt idx="10">
                  <c:v>0.30551041814082</c:v>
                </c:pt>
                <c:pt idx="11">
                  <c:v>0.433272293731739</c:v>
                </c:pt>
                <c:pt idx="12">
                  <c:v>0.249188833752659</c:v>
                </c:pt>
                <c:pt idx="13">
                  <c:v>0.388987448888315</c:v>
                </c:pt>
                <c:pt idx="14">
                  <c:v>0.425910882096377</c:v>
                </c:pt>
                <c:pt idx="15">
                  <c:v>0.45062377697599</c:v>
                </c:pt>
                <c:pt idx="16">
                  <c:v>0.344899525098411</c:v>
                </c:pt>
              </c:numCache>
            </c:numRef>
          </c:val>
          <c:smooth val="0"/>
        </c:ser>
        <c:ser>
          <c:idx val="2"/>
          <c:order val="2"/>
          <c:tx>
            <c:strRef>
              <c:f>label 2</c:f>
              <c:strCache>
                <c:ptCount val="1"/>
                <c:pt idx="0">
                  <c:v>PI502-IR</c:v>
                </c:pt>
              </c:strCache>
            </c:strRef>
          </c:tx>
          <c:spPr>
            <a:solidFill>
              <a:srgbClr val="ffc000"/>
            </a:solidFill>
            <a:ln cap="rnd" w="28440">
              <a:solidFill>
                <a:srgbClr val="ffc000"/>
              </a:solidFill>
              <a:round/>
            </a:ln>
          </c:spPr>
          <c:marker>
            <c:symbol val="none"/>
          </c:marker>
          <c:dLbls>
            <c:txPr>
              <a:bodyPr wrap="square"/>
              <a:lstStyle/>
              <a:p>
                <a:pPr>
                  <a:defRPr b="0" sz="1000" spc="-1" strike="noStrike">
                    <a:solidFill>
                      <a:srgbClr val="000000"/>
                    </a:solidFill>
                    <a:latin typeface="Calibri"/>
                    <a:ea typeface="DejaVu Sans"/>
                  </a:defRPr>
                </a:pPr>
              </a:p>
            </c:txPr>
            <c:dLblPos val="r"/>
            <c:showLegendKey val="0"/>
            <c:showVal val="0"/>
            <c:showCatName val="0"/>
            <c:showSerName val="0"/>
            <c:showPercent val="0"/>
            <c:separator>; </c:separator>
            <c:showLeaderLines val="1"/>
            <c:extLst>
              <c:ext xmlns:c15="http://schemas.microsoft.com/office/drawing/2012/chart" uri="{CE6537A1-D6FC-4f65-9D91-7224C49458BB}">
                <c15:showLeaderLines val="1"/>
              </c:ext>
            </c:extLst>
          </c:dLbls>
          <c:errBars>
            <c:errDir val="y"/>
            <c:errBarType val="both"/>
            <c:errValType val="stdErr"/>
            <c:noEndCap val="0"/>
            <c:val val="0"/>
            <c:spPr>
              <a:ln w="9360">
                <a:solidFill>
                  <a:srgbClr val="595959"/>
                </a:solidFill>
                <a:round/>
              </a:ln>
            </c:spPr>
          </c:errBars>
          <c:cat>
            <c:strRef>
              <c:f>categories</c:f>
              <c:strCache>
                <c:ptCount val="17"/>
                <c:pt idx="0">
                  <c:v>NDVI1</c:v>
                </c:pt>
                <c:pt idx="1">
                  <c:v>NDVI2</c:v>
                </c:pt>
                <c:pt idx="2">
                  <c:v>NDVI3</c:v>
                </c:pt>
                <c:pt idx="3">
                  <c:v>NDVI4</c:v>
                </c:pt>
                <c:pt idx="4">
                  <c:v>NDVI5</c:v>
                </c:pt>
                <c:pt idx="5">
                  <c:v>NDVI6</c:v>
                </c:pt>
                <c:pt idx="6">
                  <c:v>NDVI7</c:v>
                </c:pt>
                <c:pt idx="7">
                  <c:v>NDVI8</c:v>
                </c:pt>
                <c:pt idx="8">
                  <c:v>NDVI9</c:v>
                </c:pt>
                <c:pt idx="9">
                  <c:v>NDVI10</c:v>
                </c:pt>
                <c:pt idx="10">
                  <c:v>NDVI11</c:v>
                </c:pt>
                <c:pt idx="11">
                  <c:v>NDVI12</c:v>
                </c:pt>
                <c:pt idx="12">
                  <c:v>NDVI13</c:v>
                </c:pt>
                <c:pt idx="13">
                  <c:v>NDVI14</c:v>
                </c:pt>
                <c:pt idx="14">
                  <c:v>NDVI15</c:v>
                </c:pt>
                <c:pt idx="15">
                  <c:v>NDVI16</c:v>
                </c:pt>
                <c:pt idx="16">
                  <c:v>NDVI17</c:v>
                </c:pt>
              </c:strCache>
            </c:strRef>
          </c:cat>
          <c:val>
            <c:numRef>
              <c:f>2</c:f>
              <c:numCache>
                <c:formatCode>General</c:formatCode>
                <c:ptCount val="17"/>
                <c:pt idx="0">
                  <c:v>0.351894601137897</c:v>
                </c:pt>
                <c:pt idx="1">
                  <c:v>0.348048426882211</c:v>
                </c:pt>
                <c:pt idx="2">
                  <c:v>0.421949700047002</c:v>
                </c:pt>
                <c:pt idx="3">
                  <c:v>0.407286165370662</c:v>
                </c:pt>
                <c:pt idx="4">
                  <c:v>0.438942466706824</c:v>
                </c:pt>
                <c:pt idx="5">
                  <c:v>0.472581726182376</c:v>
                </c:pt>
                <c:pt idx="6">
                  <c:v>0.493102480636621</c:v>
                </c:pt>
                <c:pt idx="7">
                  <c:v>0.412944207126227</c:v>
                </c:pt>
                <c:pt idx="8">
                  <c:v>0.255400635064641</c:v>
                </c:pt>
                <c:pt idx="9">
                  <c:v>0.352025146753014</c:v>
                </c:pt>
                <c:pt idx="10">
                  <c:v>0.338445834993732</c:v>
                </c:pt>
                <c:pt idx="11">
                  <c:v>0.436363708549097</c:v>
                </c:pt>
                <c:pt idx="12">
                  <c:v>0.269994259732931</c:v>
                </c:pt>
                <c:pt idx="13">
                  <c:v>0.38378798425363</c:v>
                </c:pt>
                <c:pt idx="14">
                  <c:v>0.406275550747687</c:v>
                </c:pt>
                <c:pt idx="15">
                  <c:v>0.428160906705703</c:v>
                </c:pt>
                <c:pt idx="16">
                  <c:v>0.377934255096292</c:v>
                </c:pt>
              </c:numCache>
            </c:numRef>
          </c:val>
          <c:smooth val="0"/>
        </c:ser>
        <c:hiLowLines>
          <c:spPr>
            <a:ln w="0">
              <a:noFill/>
            </a:ln>
          </c:spPr>
        </c:hiLowLines>
        <c:marker val="0"/>
        <c:axId val="41976602"/>
        <c:axId val="98509258"/>
      </c:lineChart>
      <c:catAx>
        <c:axId val="41976602"/>
        <c:scaling>
          <c:orientation val="minMax"/>
        </c:scaling>
        <c:delete val="0"/>
        <c:axPos val="b"/>
        <c:numFmt formatCode="General" sourceLinked="0"/>
        <c:majorTickMark val="none"/>
        <c:minorTickMark val="none"/>
        <c:tickLblPos val="nextTo"/>
        <c:spPr>
          <a:ln w="9360">
            <a:solidFill>
              <a:srgbClr val="000000"/>
            </a:solidFill>
            <a:round/>
          </a:ln>
        </c:spPr>
        <c:txPr>
          <a:bodyPr/>
          <a:lstStyle/>
          <a:p>
            <a:pPr>
              <a:defRPr b="0" sz="900" spc="-1" strike="noStrike">
                <a:solidFill>
                  <a:srgbClr val="000000"/>
                </a:solidFill>
                <a:latin typeface="Calibri"/>
                <a:ea typeface="DejaVu Sans"/>
              </a:defRPr>
            </a:pPr>
          </a:p>
        </c:txPr>
        <c:crossAx val="98509258"/>
        <c:crosses val="autoZero"/>
        <c:auto val="1"/>
        <c:lblAlgn val="ctr"/>
        <c:lblOffset val="100"/>
        <c:noMultiLvlLbl val="0"/>
      </c:catAx>
      <c:valAx>
        <c:axId val="98509258"/>
        <c:scaling>
          <c:orientation val="minMax"/>
        </c:scaling>
        <c:delete val="0"/>
        <c:axPos val="l"/>
        <c:majorGridlines>
          <c:spPr>
            <a:ln w="9360">
              <a:solidFill>
                <a:srgbClr val="d9d9d9"/>
              </a:solidFill>
              <a:round/>
            </a:ln>
          </c:spPr>
        </c:majorGridlines>
        <c:numFmt formatCode="General" sourceLinked="0"/>
        <c:majorTickMark val="none"/>
        <c:minorTickMark val="none"/>
        <c:tickLblPos val="nextTo"/>
        <c:spPr>
          <a:ln w="6480">
            <a:solidFill>
              <a:srgbClr val="000000"/>
            </a:solidFill>
            <a:round/>
          </a:ln>
        </c:spPr>
        <c:txPr>
          <a:bodyPr/>
          <a:lstStyle/>
          <a:p>
            <a:pPr>
              <a:defRPr b="0" sz="900" spc="-1" strike="noStrike">
                <a:solidFill>
                  <a:srgbClr val="000000"/>
                </a:solidFill>
                <a:latin typeface="Calibri"/>
                <a:ea typeface="DejaVu Sans"/>
              </a:defRPr>
            </a:pPr>
          </a:p>
        </c:txPr>
        <c:crossAx val="41976602"/>
        <c:crosses val="autoZero"/>
        <c:crossBetween val="between"/>
      </c:valAx>
      <c:spPr>
        <a:noFill/>
        <a:ln w="0">
          <a:noFill/>
        </a:ln>
      </c:spPr>
    </c:plotArea>
    <c:plotVisOnly val="1"/>
    <c:dispBlanksAs val="gap"/>
  </c:chart>
  <c:spPr>
    <a:noFill/>
    <a:ln w="9360">
      <a:noFill/>
    </a:ln>
  </c:spPr>
</c:chartSpace>
</file>

<file path=ppt/comments/comment4.xml><?xml version="1.0" encoding="utf-8"?>
<p:cmLst xmlns:p="http://schemas.openxmlformats.org/presentationml/2006/main">
  <p:cm authorId="0" dt="2021-09-07T16:30:05.356000000" idx="1">
    <p:pos x="0" y="0"/>
    <p:text>Include a mark when water was withheld. Was it at the start of the time shown here? I recall there was a grow in stage, is that included? If not, I think it should be then you would more easily understand when the WS started.</p:text>
  </p:cm>
  <p:cm authorId="0" dt="2021-09-07T16:36:20.112000000" idx="2">
    <p:pos x="0" y="0"/>
    <p:text>I'll be honest and say that I find the graphs surprising. It seems like they have similar patterns but then they are really different. Which I know you say in the manuscript.</p:text>
  </p:cm>
  <p:cm authorId="0" dt="2021-09-07T16:38:12.644000000" idx="3">
    <p:pos x="0" y="360"/>
    <p:text>Are you sure that these are labeled correctly? The graphs make more sense to me if in B, the order is from top to bottom 60 cm WW, 60 cm WS, 15 cm WW, 15 cm WS. I think it would help to include the full establishment time for Exp. 2 rather than just starting from the Oct 12. If I understand correctly, the set up had a longer DAT for Exp. 2. Why is 15 cm WW dropping?</p:text>
  </p:cm>
</p:cmLst>
</file>

<file path=ppt/comments/comment5.xml><?xml version="1.0" encoding="utf-8"?>
<p:cmLst xmlns:p="http://schemas.openxmlformats.org/presentationml/2006/main">
  <p:cm authorId="0" dt="2021-09-07T17:14:04.026000000" idx="4">
    <p:pos x="0" y="0"/>
    <p:text/>
  </p:cm>
</p:cmLst>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4" name="PlaceHolder 2"/>
          <p:cNvSpPr>
            <a:spLocks noGrp="1"/>
          </p:cNvSpPr>
          <p:nvPr>
            <p:ph type="body"/>
          </p:nvPr>
        </p:nvSpPr>
        <p:spPr>
          <a:xfrm>
            <a:off x="609480" y="1604520"/>
            <a:ext cx="109724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7"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32" name="PlaceHolder 2"/>
          <p:cNvSpPr>
            <a:spLocks noGrp="1"/>
          </p:cNvSpPr>
          <p:nvPr>
            <p:ph type="body"/>
          </p:nvPr>
        </p:nvSpPr>
        <p:spPr>
          <a:xfrm>
            <a:off x="609480" y="1604520"/>
            <a:ext cx="353304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4319640" y="1604520"/>
            <a:ext cx="353304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8029800" y="1604520"/>
            <a:ext cx="353304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609480" y="3682080"/>
            <a:ext cx="353304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4319640" y="3682080"/>
            <a:ext cx="353304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8029800" y="3682080"/>
            <a:ext cx="35330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1" name="PlaceHolder 2"/>
          <p:cNvSpPr>
            <a:spLocks noGrp="1"/>
          </p:cNvSpPr>
          <p:nvPr>
            <p:ph type="subTitle"/>
          </p:nvPr>
        </p:nvSpPr>
        <p:spPr>
          <a:xfrm>
            <a:off x="609480" y="1604520"/>
            <a:ext cx="109724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3" name="PlaceHolder 2"/>
          <p:cNvSpPr>
            <a:spLocks noGrp="1"/>
          </p:cNvSpPr>
          <p:nvPr>
            <p:ph type="body"/>
          </p:nvPr>
        </p:nvSpPr>
        <p:spPr>
          <a:xfrm>
            <a:off x="609480" y="1604520"/>
            <a:ext cx="109724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45"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46"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609480" y="273600"/>
            <a:ext cx="10972440" cy="53078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0"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51"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
        <p:nvSpPr>
          <p:cNvPr id="52"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3" name="PlaceHolder 2"/>
          <p:cNvSpPr>
            <a:spLocks noGrp="1"/>
          </p:cNvSpPr>
          <p:nvPr>
            <p:ph type="subTitle"/>
          </p:nvPr>
        </p:nvSpPr>
        <p:spPr>
          <a:xfrm>
            <a:off x="609480" y="1604520"/>
            <a:ext cx="109724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4"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55"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56" name="PlaceHolder 4"/>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8"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59"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60" name="PlaceHolder 4"/>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62" name="PlaceHolder 2"/>
          <p:cNvSpPr>
            <a:spLocks noGrp="1"/>
          </p:cNvSpPr>
          <p:nvPr>
            <p:ph type="body"/>
          </p:nvPr>
        </p:nvSpPr>
        <p:spPr>
          <a:xfrm>
            <a:off x="609480" y="1604520"/>
            <a:ext cx="10972440" cy="1896840"/>
          </a:xfrm>
          <a:prstGeom prst="rect">
            <a:avLst/>
          </a:prstGeom>
        </p:spPr>
        <p:txBody>
          <a:bodyPr lIns="0" rIns="0" tIns="0" bIns="0">
            <a:normAutofit/>
          </a:bodyPr>
          <a:p>
            <a:endParaRPr b="0" lang="en-US" sz="3200" spc="-1" strike="noStrike">
              <a:latin typeface="Arial"/>
            </a:endParaRPr>
          </a:p>
        </p:txBody>
      </p:sp>
      <p:sp>
        <p:nvSpPr>
          <p:cNvPr id="63" name="PlaceHolder 3"/>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65"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66"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67"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
        <p:nvSpPr>
          <p:cNvPr id="68" name="PlaceHolder 5"/>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70" name="PlaceHolder 2"/>
          <p:cNvSpPr>
            <a:spLocks noGrp="1"/>
          </p:cNvSpPr>
          <p:nvPr>
            <p:ph type="body"/>
          </p:nvPr>
        </p:nvSpPr>
        <p:spPr>
          <a:xfrm>
            <a:off x="609480" y="1604520"/>
            <a:ext cx="3533040" cy="1896840"/>
          </a:xfrm>
          <a:prstGeom prst="rect">
            <a:avLst/>
          </a:prstGeom>
        </p:spPr>
        <p:txBody>
          <a:bodyPr lIns="0" rIns="0" tIns="0" bIns="0">
            <a:normAutofit/>
          </a:bodyPr>
          <a:p>
            <a:endParaRPr b="0" lang="en-US" sz="3200" spc="-1" strike="noStrike">
              <a:latin typeface="Arial"/>
            </a:endParaRPr>
          </a:p>
        </p:txBody>
      </p:sp>
      <p:sp>
        <p:nvSpPr>
          <p:cNvPr id="71" name="PlaceHolder 3"/>
          <p:cNvSpPr>
            <a:spLocks noGrp="1"/>
          </p:cNvSpPr>
          <p:nvPr>
            <p:ph type="body"/>
          </p:nvPr>
        </p:nvSpPr>
        <p:spPr>
          <a:xfrm>
            <a:off x="4319640" y="1604520"/>
            <a:ext cx="3533040" cy="1896840"/>
          </a:xfrm>
          <a:prstGeom prst="rect">
            <a:avLst/>
          </a:prstGeom>
        </p:spPr>
        <p:txBody>
          <a:bodyPr lIns="0" rIns="0" tIns="0" bIns="0">
            <a:normAutofit/>
          </a:bodyPr>
          <a:p>
            <a:endParaRPr b="0" lang="en-US" sz="3200" spc="-1" strike="noStrike">
              <a:latin typeface="Arial"/>
            </a:endParaRPr>
          </a:p>
        </p:txBody>
      </p:sp>
      <p:sp>
        <p:nvSpPr>
          <p:cNvPr id="72" name="PlaceHolder 4"/>
          <p:cNvSpPr>
            <a:spLocks noGrp="1"/>
          </p:cNvSpPr>
          <p:nvPr>
            <p:ph type="body"/>
          </p:nvPr>
        </p:nvSpPr>
        <p:spPr>
          <a:xfrm>
            <a:off x="8029800" y="1604520"/>
            <a:ext cx="3533040" cy="1896840"/>
          </a:xfrm>
          <a:prstGeom prst="rect">
            <a:avLst/>
          </a:prstGeom>
        </p:spPr>
        <p:txBody>
          <a:bodyPr lIns="0" rIns="0" tIns="0" bIns="0">
            <a:normAutofit/>
          </a:bodyPr>
          <a:p>
            <a:endParaRPr b="0" lang="en-US" sz="3200" spc="-1" strike="noStrike">
              <a:latin typeface="Arial"/>
            </a:endParaRPr>
          </a:p>
        </p:txBody>
      </p:sp>
      <p:sp>
        <p:nvSpPr>
          <p:cNvPr id="73" name="PlaceHolder 5"/>
          <p:cNvSpPr>
            <a:spLocks noGrp="1"/>
          </p:cNvSpPr>
          <p:nvPr>
            <p:ph type="body"/>
          </p:nvPr>
        </p:nvSpPr>
        <p:spPr>
          <a:xfrm>
            <a:off x="609480" y="3682080"/>
            <a:ext cx="3533040" cy="1896840"/>
          </a:xfrm>
          <a:prstGeom prst="rect">
            <a:avLst/>
          </a:prstGeom>
        </p:spPr>
        <p:txBody>
          <a:bodyPr lIns="0" rIns="0" tIns="0" bIns="0">
            <a:normAutofit/>
          </a:bodyPr>
          <a:p>
            <a:endParaRPr b="0" lang="en-US" sz="3200" spc="-1" strike="noStrike">
              <a:latin typeface="Arial"/>
            </a:endParaRPr>
          </a:p>
        </p:txBody>
      </p:sp>
      <p:sp>
        <p:nvSpPr>
          <p:cNvPr id="74" name="PlaceHolder 6"/>
          <p:cNvSpPr>
            <a:spLocks noGrp="1"/>
          </p:cNvSpPr>
          <p:nvPr>
            <p:ph type="body"/>
          </p:nvPr>
        </p:nvSpPr>
        <p:spPr>
          <a:xfrm>
            <a:off x="4319640" y="3682080"/>
            <a:ext cx="3533040" cy="1896840"/>
          </a:xfrm>
          <a:prstGeom prst="rect">
            <a:avLst/>
          </a:prstGeom>
        </p:spPr>
        <p:txBody>
          <a:bodyPr lIns="0" rIns="0" tIns="0" bIns="0">
            <a:normAutofit/>
          </a:bodyPr>
          <a:p>
            <a:endParaRPr b="0" lang="en-US" sz="3200" spc="-1" strike="noStrike">
              <a:latin typeface="Arial"/>
            </a:endParaRPr>
          </a:p>
        </p:txBody>
      </p:sp>
      <p:sp>
        <p:nvSpPr>
          <p:cNvPr id="75" name="PlaceHolder 7"/>
          <p:cNvSpPr>
            <a:spLocks noGrp="1"/>
          </p:cNvSpPr>
          <p:nvPr>
            <p:ph type="body"/>
          </p:nvPr>
        </p:nvSpPr>
        <p:spPr>
          <a:xfrm>
            <a:off x="8029800" y="3682080"/>
            <a:ext cx="35330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78"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79" name="PlaceHolder 2"/>
          <p:cNvSpPr>
            <a:spLocks noGrp="1"/>
          </p:cNvSpPr>
          <p:nvPr>
            <p:ph type="subTitle"/>
          </p:nvPr>
        </p:nvSpPr>
        <p:spPr>
          <a:xfrm>
            <a:off x="609480" y="1604520"/>
            <a:ext cx="10972440" cy="397728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0"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81" name="PlaceHolder 2"/>
          <p:cNvSpPr>
            <a:spLocks noGrp="1"/>
          </p:cNvSpPr>
          <p:nvPr>
            <p:ph type="body"/>
          </p:nvPr>
        </p:nvSpPr>
        <p:spPr>
          <a:xfrm>
            <a:off x="609480" y="1604520"/>
            <a:ext cx="109724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83"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84"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5"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5" name="PlaceHolder 2"/>
          <p:cNvSpPr>
            <a:spLocks noGrp="1"/>
          </p:cNvSpPr>
          <p:nvPr>
            <p:ph type="body"/>
          </p:nvPr>
        </p:nvSpPr>
        <p:spPr>
          <a:xfrm>
            <a:off x="609480" y="1604520"/>
            <a:ext cx="109724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6" name="PlaceHolder 1"/>
          <p:cNvSpPr>
            <a:spLocks noGrp="1"/>
          </p:cNvSpPr>
          <p:nvPr>
            <p:ph type="subTitle"/>
          </p:nvPr>
        </p:nvSpPr>
        <p:spPr>
          <a:xfrm>
            <a:off x="609480" y="273600"/>
            <a:ext cx="10972440" cy="53078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8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88"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89"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
        <p:nvSpPr>
          <p:cNvPr id="90"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92"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93"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94" name="PlaceHolder 4"/>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96"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97"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98" name="PlaceHolder 4"/>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00" name="PlaceHolder 2"/>
          <p:cNvSpPr>
            <a:spLocks noGrp="1"/>
          </p:cNvSpPr>
          <p:nvPr>
            <p:ph type="body"/>
          </p:nvPr>
        </p:nvSpPr>
        <p:spPr>
          <a:xfrm>
            <a:off x="609480" y="1604520"/>
            <a:ext cx="10972440" cy="1896840"/>
          </a:xfrm>
          <a:prstGeom prst="rect">
            <a:avLst/>
          </a:prstGeom>
        </p:spPr>
        <p:txBody>
          <a:bodyPr lIns="0" rIns="0" tIns="0" bIns="0">
            <a:normAutofit/>
          </a:bodyPr>
          <a:p>
            <a:endParaRPr b="0" lang="en-US" sz="3200" spc="-1" strike="noStrike">
              <a:latin typeface="Arial"/>
            </a:endParaRPr>
          </a:p>
        </p:txBody>
      </p:sp>
      <p:sp>
        <p:nvSpPr>
          <p:cNvPr id="101" name="PlaceHolder 3"/>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02"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03"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104"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105"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
        <p:nvSpPr>
          <p:cNvPr id="106" name="PlaceHolder 5"/>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08" name="PlaceHolder 2"/>
          <p:cNvSpPr>
            <a:spLocks noGrp="1"/>
          </p:cNvSpPr>
          <p:nvPr>
            <p:ph type="body"/>
          </p:nvPr>
        </p:nvSpPr>
        <p:spPr>
          <a:xfrm>
            <a:off x="609480" y="1604520"/>
            <a:ext cx="3533040" cy="1896840"/>
          </a:xfrm>
          <a:prstGeom prst="rect">
            <a:avLst/>
          </a:prstGeom>
        </p:spPr>
        <p:txBody>
          <a:bodyPr lIns="0" rIns="0" tIns="0" bIns="0">
            <a:normAutofit/>
          </a:bodyPr>
          <a:p>
            <a:endParaRPr b="0" lang="en-US" sz="3200" spc="-1" strike="noStrike">
              <a:latin typeface="Arial"/>
            </a:endParaRPr>
          </a:p>
        </p:txBody>
      </p:sp>
      <p:sp>
        <p:nvSpPr>
          <p:cNvPr id="109" name="PlaceHolder 3"/>
          <p:cNvSpPr>
            <a:spLocks noGrp="1"/>
          </p:cNvSpPr>
          <p:nvPr>
            <p:ph type="body"/>
          </p:nvPr>
        </p:nvSpPr>
        <p:spPr>
          <a:xfrm>
            <a:off x="4319640" y="1604520"/>
            <a:ext cx="3533040" cy="1896840"/>
          </a:xfrm>
          <a:prstGeom prst="rect">
            <a:avLst/>
          </a:prstGeom>
        </p:spPr>
        <p:txBody>
          <a:bodyPr lIns="0" rIns="0" tIns="0" bIns="0">
            <a:normAutofit/>
          </a:bodyPr>
          <a:p>
            <a:endParaRPr b="0" lang="en-US" sz="3200" spc="-1" strike="noStrike">
              <a:latin typeface="Arial"/>
            </a:endParaRPr>
          </a:p>
        </p:txBody>
      </p:sp>
      <p:sp>
        <p:nvSpPr>
          <p:cNvPr id="110" name="PlaceHolder 4"/>
          <p:cNvSpPr>
            <a:spLocks noGrp="1"/>
          </p:cNvSpPr>
          <p:nvPr>
            <p:ph type="body"/>
          </p:nvPr>
        </p:nvSpPr>
        <p:spPr>
          <a:xfrm>
            <a:off x="8029800" y="1604520"/>
            <a:ext cx="3533040" cy="1896840"/>
          </a:xfrm>
          <a:prstGeom prst="rect">
            <a:avLst/>
          </a:prstGeom>
        </p:spPr>
        <p:txBody>
          <a:bodyPr lIns="0" rIns="0" tIns="0" bIns="0">
            <a:normAutofit/>
          </a:bodyPr>
          <a:p>
            <a:endParaRPr b="0" lang="en-US" sz="3200" spc="-1" strike="noStrike">
              <a:latin typeface="Arial"/>
            </a:endParaRPr>
          </a:p>
        </p:txBody>
      </p:sp>
      <p:sp>
        <p:nvSpPr>
          <p:cNvPr id="111" name="PlaceHolder 5"/>
          <p:cNvSpPr>
            <a:spLocks noGrp="1"/>
          </p:cNvSpPr>
          <p:nvPr>
            <p:ph type="body"/>
          </p:nvPr>
        </p:nvSpPr>
        <p:spPr>
          <a:xfrm>
            <a:off x="609480" y="3682080"/>
            <a:ext cx="3533040" cy="1896840"/>
          </a:xfrm>
          <a:prstGeom prst="rect">
            <a:avLst/>
          </a:prstGeom>
        </p:spPr>
        <p:txBody>
          <a:bodyPr lIns="0" rIns="0" tIns="0" bIns="0">
            <a:normAutofit/>
          </a:bodyPr>
          <a:p>
            <a:endParaRPr b="0" lang="en-US" sz="3200" spc="-1" strike="noStrike">
              <a:latin typeface="Arial"/>
            </a:endParaRPr>
          </a:p>
        </p:txBody>
      </p:sp>
      <p:sp>
        <p:nvSpPr>
          <p:cNvPr id="112" name="PlaceHolder 6"/>
          <p:cNvSpPr>
            <a:spLocks noGrp="1"/>
          </p:cNvSpPr>
          <p:nvPr>
            <p:ph type="body"/>
          </p:nvPr>
        </p:nvSpPr>
        <p:spPr>
          <a:xfrm>
            <a:off x="4319640" y="3682080"/>
            <a:ext cx="3533040" cy="1896840"/>
          </a:xfrm>
          <a:prstGeom prst="rect">
            <a:avLst/>
          </a:prstGeom>
        </p:spPr>
        <p:txBody>
          <a:bodyPr lIns="0" rIns="0" tIns="0" bIns="0">
            <a:normAutofit/>
          </a:bodyPr>
          <a:p>
            <a:endParaRPr b="0" lang="en-US" sz="3200" spc="-1" strike="noStrike">
              <a:latin typeface="Arial"/>
            </a:endParaRPr>
          </a:p>
        </p:txBody>
      </p:sp>
      <p:sp>
        <p:nvSpPr>
          <p:cNvPr id="113" name="PlaceHolder 7"/>
          <p:cNvSpPr>
            <a:spLocks noGrp="1"/>
          </p:cNvSpPr>
          <p:nvPr>
            <p:ph type="body"/>
          </p:nvPr>
        </p:nvSpPr>
        <p:spPr>
          <a:xfrm>
            <a:off x="8029800" y="3682080"/>
            <a:ext cx="35330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7"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609480" y="273600"/>
            <a:ext cx="10972440" cy="53078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2"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6231960" y="1604520"/>
            <a:ext cx="535428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60948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16" name="PlaceHolder 2"/>
          <p:cNvSpPr>
            <a:spLocks noGrp="1"/>
          </p:cNvSpPr>
          <p:nvPr>
            <p:ph type="body"/>
          </p:nvPr>
        </p:nvSpPr>
        <p:spPr>
          <a:xfrm>
            <a:off x="609480" y="1604520"/>
            <a:ext cx="535428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6231960" y="3682080"/>
            <a:ext cx="535428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endParaRPr b="0" lang="en-US" sz="4400" spc="-1" strike="noStrike">
              <a:latin typeface="Arial"/>
            </a:endParaRPr>
          </a:p>
        </p:txBody>
      </p:sp>
      <p:sp>
        <p:nvSpPr>
          <p:cNvPr id="20" name="PlaceHolder 2"/>
          <p:cNvSpPr>
            <a:spLocks noGrp="1"/>
          </p:cNvSpPr>
          <p:nvPr>
            <p:ph type="body"/>
          </p:nvPr>
        </p:nvSpPr>
        <p:spPr>
          <a:xfrm>
            <a:off x="609480" y="1604520"/>
            <a:ext cx="535428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6231960" y="1604520"/>
            <a:ext cx="535428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609480" y="3682080"/>
            <a:ext cx="109724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0"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609480" y="1604520"/>
            <a:ext cx="109724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r>
              <a:rPr b="0" lang="en-US" sz="4400" spc="-1" strike="noStrike">
                <a:latin typeface="Arial"/>
              </a:rPr>
              <a:t>Click to edit the title text format</a:t>
            </a:r>
            <a:endParaRPr b="0" lang="en-US" sz="4400" spc="-1" strike="noStrike">
              <a:latin typeface="Arial"/>
            </a:endParaRPr>
          </a:p>
        </p:txBody>
      </p:sp>
      <p:sp>
        <p:nvSpPr>
          <p:cNvPr id="39" name="PlaceHolder 2"/>
          <p:cNvSpPr>
            <a:spLocks noGrp="1"/>
          </p:cNvSpPr>
          <p:nvPr>
            <p:ph type="body"/>
          </p:nvPr>
        </p:nvSpPr>
        <p:spPr>
          <a:xfrm>
            <a:off x="609480" y="1604520"/>
            <a:ext cx="109724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6" name="PlaceHolder 1"/>
          <p:cNvSpPr>
            <a:spLocks noGrp="1"/>
          </p:cNvSpPr>
          <p:nvPr>
            <p:ph type="title"/>
          </p:nvPr>
        </p:nvSpPr>
        <p:spPr>
          <a:xfrm>
            <a:off x="609480" y="273600"/>
            <a:ext cx="10972440" cy="1144800"/>
          </a:xfrm>
          <a:prstGeom prst="rect">
            <a:avLst/>
          </a:prstGeom>
        </p:spPr>
        <p:txBody>
          <a:bodyPr lIns="0" rIns="0" tIns="0" bIns="0" anchor="ctr">
            <a:noAutofit/>
          </a:bodyPr>
          <a:p>
            <a:pPr algn="ctr"/>
            <a:r>
              <a:rPr b="0" lang="en-US" sz="4400" spc="-1" strike="noStrike">
                <a:latin typeface="Arial"/>
              </a:rPr>
              <a:t>Click to edit the title text format</a:t>
            </a:r>
            <a:endParaRPr b="0" lang="en-US" sz="4400" spc="-1" strike="noStrike">
              <a:latin typeface="Arial"/>
            </a:endParaRPr>
          </a:p>
        </p:txBody>
      </p:sp>
      <p:sp>
        <p:nvSpPr>
          <p:cNvPr id="77" name="PlaceHolder 2"/>
          <p:cNvSpPr>
            <a:spLocks noGrp="1"/>
          </p:cNvSpPr>
          <p:nvPr>
            <p:ph type="body"/>
          </p:nvPr>
        </p:nvSpPr>
        <p:spPr>
          <a:xfrm>
            <a:off x="609480" y="1604520"/>
            <a:ext cx="10972440" cy="39772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25.xml"/>
</Relationships>
</file>

<file path=ppt/slides/_rels/slide4.xml.rels><?xml version="1.0" encoding="UTF-8"?>
<Relationships xmlns="http://schemas.openxmlformats.org/package/2006/relationships"><Relationship Id="rId1" Type="http://schemas.openxmlformats.org/officeDocument/2006/relationships/chart" Target="../charts/chart13.xml"/><Relationship Id="rId2" Type="http://schemas.openxmlformats.org/officeDocument/2006/relationships/chart" Target="../charts/chart14.xml"/><Relationship Id="rId3" Type="http://schemas.openxmlformats.org/officeDocument/2006/relationships/slideLayout" Target="../slideLayouts/slideLayout25.xml"/><Relationship Id="rId4" Type="http://schemas.openxmlformats.org/officeDocument/2006/relationships/comments" Target="../comments/comment4.xml"/>
</Relationships>
</file>

<file path=ppt/slides/_rels/slide5.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3.xml"/><Relationship Id="rId3" Type="http://schemas.openxmlformats.org/officeDocument/2006/relationships/comments" Target="../comments/comment5.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image" Target="../media/image8.png"/><Relationship Id="rId5" Type="http://schemas.openxmlformats.org/officeDocument/2006/relationships/slideLayout" Target="../slideLayouts/slideLayout13.xml"/>
</Relationships>
</file>

<file path=ppt/slides/_rels/slide7.xml.rels><?xml version="1.0" encoding="UTF-8"?>
<Relationships xmlns="http://schemas.openxmlformats.org/package/2006/relationships"><Relationship Id="rId1" Type="http://schemas.openxmlformats.org/officeDocument/2006/relationships/chart" Target="../charts/chart15.xml"/><Relationship Id="rId2" Type="http://schemas.openxmlformats.org/officeDocument/2006/relationships/chart" Target="../charts/chart16.xml"/><Relationship Id="rId3" Type="http://schemas.openxmlformats.org/officeDocument/2006/relationships/slideLayout" Target="../slideLayouts/slideLayout25.xml"/>
</Relationships>
</file>

<file path=ppt/slides/_rels/slide8.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4" name=""/>
          <p:cNvSpPr/>
          <p:nvPr/>
        </p:nvSpPr>
        <p:spPr>
          <a:xfrm>
            <a:off x="504000" y="226080"/>
            <a:ext cx="9067680" cy="942480"/>
          </a:xfrm>
          <a:prstGeom prst="rect">
            <a:avLst/>
          </a:prstGeom>
          <a:noFill/>
          <a:ln w="0">
            <a:noFill/>
          </a:ln>
        </p:spPr>
        <p:style>
          <a:lnRef idx="0"/>
          <a:fillRef idx="0"/>
          <a:effectRef idx="0"/>
          <a:fontRef idx="minor"/>
        </p:style>
      </p:sp>
      <p:sp>
        <p:nvSpPr>
          <p:cNvPr id="115" name=""/>
          <p:cNvSpPr/>
          <p:nvPr/>
        </p:nvSpPr>
        <p:spPr>
          <a:xfrm>
            <a:off x="504000" y="1326600"/>
            <a:ext cx="9067680" cy="3284280"/>
          </a:xfrm>
          <a:prstGeom prst="rect">
            <a:avLst/>
          </a:prstGeom>
          <a:noFill/>
          <a:ln w="0">
            <a:noFill/>
          </a:ln>
        </p:spPr>
        <p:style>
          <a:lnRef idx="0"/>
          <a:fillRef idx="0"/>
          <a:effectRef idx="0"/>
          <a:fontRef idx="minor"/>
        </p:style>
      </p:sp>
      <p:pic>
        <p:nvPicPr>
          <p:cNvPr id="116" name="Picture 33" descr=""/>
          <p:cNvPicPr/>
          <p:nvPr/>
        </p:nvPicPr>
        <p:blipFill>
          <a:blip r:embed="rId1"/>
          <a:srcRect l="0" t="0" r="0" b="9642"/>
          <a:stretch/>
        </p:blipFill>
        <p:spPr>
          <a:xfrm>
            <a:off x="1828800" y="795240"/>
            <a:ext cx="3803400" cy="4112280"/>
          </a:xfrm>
          <a:prstGeom prst="rect">
            <a:avLst/>
          </a:prstGeom>
          <a:ln w="0">
            <a:noFill/>
          </a:ln>
        </p:spPr>
      </p:pic>
      <p:sp>
        <p:nvSpPr>
          <p:cNvPr id="117" name=""/>
          <p:cNvSpPr/>
          <p:nvPr/>
        </p:nvSpPr>
        <p:spPr>
          <a:xfrm>
            <a:off x="0" y="0"/>
            <a:ext cx="10045080" cy="599040"/>
          </a:xfrm>
          <a:prstGeom prst="rect">
            <a:avLst/>
          </a:prstGeom>
          <a:noFill/>
          <a:ln w="0">
            <a:noFill/>
          </a:ln>
        </p:spPr>
        <p:style>
          <a:lnRef idx="0"/>
          <a:fillRef idx="0"/>
          <a:effectRef idx="0"/>
          <a:fontRef idx="minor"/>
        </p:style>
        <p:txBody>
          <a:bodyPr lIns="90000" rIns="90000" tIns="45000" bIns="45000">
            <a:noAutofit/>
          </a:bodyPr>
          <a:p>
            <a:pPr>
              <a:lnSpc>
                <a:spcPct val="100000"/>
              </a:lnSpc>
            </a:pPr>
            <a:r>
              <a:rPr b="0" lang="en-US" sz="1800" spc="-1" strike="noStrike">
                <a:solidFill>
                  <a:srgbClr val="000000"/>
                </a:solidFill>
                <a:latin typeface="Arial"/>
                <a:ea typeface="DejaVu Sans"/>
              </a:rPr>
              <a:t> </a:t>
            </a:r>
            <a:endParaRPr b="0" lang="en-US" sz="1800" spc="-1" strike="noStrike">
              <a:latin typeface="Arial"/>
            </a:endParaRPr>
          </a:p>
        </p:txBody>
      </p:sp>
      <p:grpSp>
        <p:nvGrpSpPr>
          <p:cNvPr id="118" name="Group 112_1"/>
          <p:cNvGrpSpPr/>
          <p:nvPr/>
        </p:nvGrpSpPr>
        <p:grpSpPr>
          <a:xfrm>
            <a:off x="5948280" y="454680"/>
            <a:ext cx="2989080" cy="4520880"/>
            <a:chOff x="5948280" y="454680"/>
            <a:chExt cx="2989080" cy="4520880"/>
          </a:xfrm>
        </p:grpSpPr>
        <p:sp>
          <p:nvSpPr>
            <p:cNvPr id="119" name="Rectangle 3_0"/>
            <p:cNvSpPr/>
            <p:nvPr/>
          </p:nvSpPr>
          <p:spPr>
            <a:xfrm>
              <a:off x="5952600" y="700200"/>
              <a:ext cx="2979000" cy="4272120"/>
            </a:xfrm>
            <a:prstGeom prst="rect">
              <a:avLst/>
            </a:prstGeom>
            <a:noFill/>
            <a:ln w="28575">
              <a:solidFill>
                <a:srgbClr val="000000"/>
              </a:solidFill>
            </a:ln>
          </p:spPr>
          <p:style>
            <a:lnRef idx="2">
              <a:schemeClr val="accent1">
                <a:shade val="50000"/>
              </a:schemeClr>
            </a:lnRef>
            <a:fillRef idx="1">
              <a:schemeClr val="accent1"/>
            </a:fillRef>
            <a:effectRef idx="0">
              <a:schemeClr val="accent1"/>
            </a:effectRef>
            <a:fontRef idx="minor"/>
          </p:style>
        </p:sp>
        <p:sp>
          <p:nvSpPr>
            <p:cNvPr id="120" name="Straight Connector 18_0"/>
            <p:cNvSpPr/>
            <p:nvPr/>
          </p:nvSpPr>
          <p:spPr>
            <a:xfrm>
              <a:off x="7418880" y="700200"/>
              <a:ext cx="360" cy="4275360"/>
            </a:xfrm>
            <a:prstGeom prst="line">
              <a:avLst/>
            </a:prstGeom>
            <a:ln w="76200">
              <a:solidFill>
                <a:srgbClr val="a5a5a5"/>
              </a:solidFill>
            </a:ln>
          </p:spPr>
          <p:style>
            <a:lnRef idx="3">
              <a:schemeClr val="accent3"/>
            </a:lnRef>
            <a:fillRef idx="0">
              <a:schemeClr val="accent3"/>
            </a:fillRef>
            <a:effectRef idx="2">
              <a:schemeClr val="accent3"/>
            </a:effectRef>
            <a:fontRef idx="minor"/>
          </p:style>
        </p:sp>
        <p:grpSp>
          <p:nvGrpSpPr>
            <p:cNvPr id="121" name="Group 25_0"/>
            <p:cNvGrpSpPr/>
            <p:nvPr/>
          </p:nvGrpSpPr>
          <p:grpSpPr>
            <a:xfrm>
              <a:off x="5989680" y="3575160"/>
              <a:ext cx="1279800" cy="1257480"/>
              <a:chOff x="5989680" y="3575160"/>
              <a:chExt cx="1279800" cy="1257480"/>
            </a:xfrm>
          </p:grpSpPr>
          <p:sp>
            <p:nvSpPr>
              <p:cNvPr id="122" name="Oval 7_0"/>
              <p:cNvSpPr/>
              <p:nvPr/>
            </p:nvSpPr>
            <p:spPr>
              <a:xfrm>
                <a:off x="6687720" y="424260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23" name="Oval 8_0"/>
              <p:cNvSpPr/>
              <p:nvPr/>
            </p:nvSpPr>
            <p:spPr>
              <a:xfrm>
                <a:off x="5993640" y="357516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24" name="Oval 9_0"/>
              <p:cNvSpPr/>
              <p:nvPr/>
            </p:nvSpPr>
            <p:spPr>
              <a:xfrm>
                <a:off x="5989680" y="423828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25" name="Oval 21_0"/>
              <p:cNvSpPr/>
              <p:nvPr/>
            </p:nvSpPr>
            <p:spPr>
              <a:xfrm>
                <a:off x="6704280" y="357516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grpSp>
        <p:grpSp>
          <p:nvGrpSpPr>
            <p:cNvPr id="126" name="Group 26_0"/>
            <p:cNvGrpSpPr/>
            <p:nvPr/>
          </p:nvGrpSpPr>
          <p:grpSpPr>
            <a:xfrm>
              <a:off x="7558920" y="3591720"/>
              <a:ext cx="1296360" cy="1339560"/>
              <a:chOff x="7558920" y="3591720"/>
              <a:chExt cx="1296360" cy="1339560"/>
            </a:xfrm>
          </p:grpSpPr>
          <p:sp>
            <p:nvSpPr>
              <p:cNvPr id="127" name="Oval 27_0"/>
              <p:cNvSpPr/>
              <p:nvPr/>
            </p:nvSpPr>
            <p:spPr>
              <a:xfrm>
                <a:off x="8281800" y="4302720"/>
                <a:ext cx="565200" cy="62856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28" name="Oval 28_0"/>
              <p:cNvSpPr/>
              <p:nvPr/>
            </p:nvSpPr>
            <p:spPr>
              <a:xfrm>
                <a:off x="7563240" y="3591720"/>
                <a:ext cx="565200" cy="62856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29" name="Oval 29_0"/>
              <p:cNvSpPr/>
              <p:nvPr/>
            </p:nvSpPr>
            <p:spPr>
              <a:xfrm>
                <a:off x="7558920" y="4298400"/>
                <a:ext cx="565200" cy="628560"/>
              </a:xfrm>
              <a:prstGeom prst="ellipse">
                <a:avLst/>
              </a:prstGeom>
              <a:solidFill>
                <a:schemeClr val="bg1"/>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0" name="Oval 30_0"/>
              <p:cNvSpPr/>
              <p:nvPr/>
            </p:nvSpPr>
            <p:spPr>
              <a:xfrm>
                <a:off x="8290080" y="3591720"/>
                <a:ext cx="565200" cy="62856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grpSp>
        <p:grpSp>
          <p:nvGrpSpPr>
            <p:cNvPr id="131" name="Group 31_0"/>
            <p:cNvGrpSpPr/>
            <p:nvPr/>
          </p:nvGrpSpPr>
          <p:grpSpPr>
            <a:xfrm>
              <a:off x="5996880" y="2185200"/>
              <a:ext cx="1279800" cy="1257120"/>
              <a:chOff x="5996880" y="2185200"/>
              <a:chExt cx="1279800" cy="1257120"/>
            </a:xfrm>
          </p:grpSpPr>
          <p:sp>
            <p:nvSpPr>
              <p:cNvPr id="132" name="Oval 32_0"/>
              <p:cNvSpPr/>
              <p:nvPr/>
            </p:nvSpPr>
            <p:spPr>
              <a:xfrm>
                <a:off x="6678720" y="285228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3" name="Oval 33_0"/>
              <p:cNvSpPr/>
              <p:nvPr/>
            </p:nvSpPr>
            <p:spPr>
              <a:xfrm>
                <a:off x="6000840" y="218520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4" name="Oval 34_0"/>
              <p:cNvSpPr/>
              <p:nvPr/>
            </p:nvSpPr>
            <p:spPr>
              <a:xfrm>
                <a:off x="5996880" y="284832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5" name="Oval 35_0"/>
              <p:cNvSpPr/>
              <p:nvPr/>
            </p:nvSpPr>
            <p:spPr>
              <a:xfrm>
                <a:off x="6711480" y="218520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grpSp>
        <p:grpSp>
          <p:nvGrpSpPr>
            <p:cNvPr id="136" name="Group 36_0"/>
            <p:cNvGrpSpPr/>
            <p:nvPr/>
          </p:nvGrpSpPr>
          <p:grpSpPr>
            <a:xfrm>
              <a:off x="7583760" y="2220120"/>
              <a:ext cx="1279800" cy="1257480"/>
              <a:chOff x="7583760" y="2220120"/>
              <a:chExt cx="1279800" cy="1257480"/>
            </a:xfrm>
          </p:grpSpPr>
          <p:sp>
            <p:nvSpPr>
              <p:cNvPr id="137" name="Oval 37_0"/>
              <p:cNvSpPr/>
              <p:nvPr/>
            </p:nvSpPr>
            <p:spPr>
              <a:xfrm>
                <a:off x="8290080" y="288756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8" name="Oval 38_0"/>
              <p:cNvSpPr/>
              <p:nvPr/>
            </p:nvSpPr>
            <p:spPr>
              <a:xfrm>
                <a:off x="7587720" y="222012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39" name="Oval 39_0"/>
              <p:cNvSpPr/>
              <p:nvPr/>
            </p:nvSpPr>
            <p:spPr>
              <a:xfrm>
                <a:off x="7583760" y="288324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0" name="Oval 40_0"/>
              <p:cNvSpPr/>
              <p:nvPr/>
            </p:nvSpPr>
            <p:spPr>
              <a:xfrm>
                <a:off x="8298360" y="222012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grpSp>
        <p:grpSp>
          <p:nvGrpSpPr>
            <p:cNvPr id="141" name="Group 46_0"/>
            <p:cNvGrpSpPr/>
            <p:nvPr/>
          </p:nvGrpSpPr>
          <p:grpSpPr>
            <a:xfrm>
              <a:off x="6000120" y="799200"/>
              <a:ext cx="1279800" cy="1257120"/>
              <a:chOff x="6000120" y="799200"/>
              <a:chExt cx="1279800" cy="1257120"/>
            </a:xfrm>
          </p:grpSpPr>
          <p:sp>
            <p:nvSpPr>
              <p:cNvPr id="142" name="Oval 47_0"/>
              <p:cNvSpPr/>
              <p:nvPr/>
            </p:nvSpPr>
            <p:spPr>
              <a:xfrm>
                <a:off x="6681600" y="146628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3" name="Oval 48_0"/>
              <p:cNvSpPr/>
              <p:nvPr/>
            </p:nvSpPr>
            <p:spPr>
              <a:xfrm>
                <a:off x="6004080" y="79920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4" name="Oval 49_0"/>
              <p:cNvSpPr/>
              <p:nvPr/>
            </p:nvSpPr>
            <p:spPr>
              <a:xfrm>
                <a:off x="6000120" y="146232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5" name="Oval 50_0"/>
              <p:cNvSpPr/>
              <p:nvPr/>
            </p:nvSpPr>
            <p:spPr>
              <a:xfrm>
                <a:off x="6714720" y="79920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grpSp>
        <p:grpSp>
          <p:nvGrpSpPr>
            <p:cNvPr id="146" name="Group 51_0"/>
            <p:cNvGrpSpPr/>
            <p:nvPr/>
          </p:nvGrpSpPr>
          <p:grpSpPr>
            <a:xfrm>
              <a:off x="7599240" y="799200"/>
              <a:ext cx="1288080" cy="1257120"/>
              <a:chOff x="7599240" y="799200"/>
              <a:chExt cx="1288080" cy="1257120"/>
            </a:xfrm>
          </p:grpSpPr>
          <p:sp>
            <p:nvSpPr>
              <p:cNvPr id="147" name="Oval 52_0"/>
              <p:cNvSpPr/>
              <p:nvPr/>
            </p:nvSpPr>
            <p:spPr>
              <a:xfrm>
                <a:off x="8322120" y="146628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8" name="Oval 53_0"/>
              <p:cNvSpPr/>
              <p:nvPr/>
            </p:nvSpPr>
            <p:spPr>
              <a:xfrm>
                <a:off x="7603200" y="79920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49" name="Oval 54_0"/>
              <p:cNvSpPr/>
              <p:nvPr/>
            </p:nvSpPr>
            <p:spPr>
              <a:xfrm>
                <a:off x="7599240" y="1462320"/>
                <a:ext cx="565200" cy="590040"/>
              </a:xfrm>
              <a:prstGeom prst="ellipse">
                <a:avLst/>
              </a:prstGeom>
              <a:no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50" name="Oval 55_0"/>
              <p:cNvSpPr/>
              <p:nvPr/>
            </p:nvSpPr>
            <p:spPr>
              <a:xfrm>
                <a:off x="8313840" y="799200"/>
                <a:ext cx="565200" cy="590040"/>
              </a:xfrm>
              <a:prstGeom prst="ellipse">
                <a:avLst/>
              </a:prstGeom>
              <a:solidFill>
                <a:schemeClr val="accent2">
                  <a:lumMod val="50000"/>
                </a:schemeClr>
              </a:solidFill>
              <a:ln>
                <a:solidFill>
                  <a:srgbClr val="325490"/>
                </a:solidFill>
              </a:ln>
            </p:spPr>
            <p:style>
              <a:lnRef idx="2">
                <a:schemeClr val="accent1">
                  <a:shade val="50000"/>
                </a:schemeClr>
              </a:lnRef>
              <a:fillRef idx="1">
                <a:schemeClr val="accent1"/>
              </a:fillRef>
              <a:effectRef idx="0">
                <a:schemeClr val="accent1"/>
              </a:effectRef>
              <a:fontRef idx="minor"/>
            </p:style>
          </p:sp>
        </p:grpSp>
        <p:sp>
          <p:nvSpPr>
            <p:cNvPr id="151" name="Straight Connector 66_0"/>
            <p:cNvSpPr/>
            <p:nvPr/>
          </p:nvSpPr>
          <p:spPr>
            <a:xfrm>
              <a:off x="8223840" y="700200"/>
              <a:ext cx="360" cy="4275360"/>
            </a:xfrm>
            <a:prstGeom prst="line">
              <a:avLst/>
            </a:prstGeom>
            <a:ln w="76200">
              <a:solidFill>
                <a:srgbClr val="a5a5a5"/>
              </a:solidFill>
            </a:ln>
          </p:spPr>
          <p:style>
            <a:lnRef idx="3">
              <a:schemeClr val="accent3"/>
            </a:lnRef>
            <a:fillRef idx="0">
              <a:schemeClr val="accent3"/>
            </a:fillRef>
            <a:effectRef idx="2">
              <a:schemeClr val="accent3"/>
            </a:effectRef>
            <a:fontRef idx="minor"/>
          </p:style>
        </p:sp>
        <p:sp>
          <p:nvSpPr>
            <p:cNvPr id="152" name="Straight Connector 68_0"/>
            <p:cNvSpPr/>
            <p:nvPr/>
          </p:nvSpPr>
          <p:spPr>
            <a:xfrm>
              <a:off x="6613560" y="700200"/>
              <a:ext cx="360" cy="4250520"/>
            </a:xfrm>
            <a:prstGeom prst="line">
              <a:avLst/>
            </a:prstGeom>
            <a:ln w="76200">
              <a:solidFill>
                <a:srgbClr val="a5a5a5"/>
              </a:solidFill>
            </a:ln>
          </p:spPr>
          <p:style>
            <a:lnRef idx="3">
              <a:schemeClr val="accent3"/>
            </a:lnRef>
            <a:fillRef idx="0">
              <a:schemeClr val="accent3"/>
            </a:fillRef>
            <a:effectRef idx="2">
              <a:schemeClr val="accent3"/>
            </a:effectRef>
            <a:fontRef idx="minor"/>
          </p:style>
        </p:sp>
        <p:sp>
          <p:nvSpPr>
            <p:cNvPr id="153" name="Straight Connector 72_0"/>
            <p:cNvSpPr/>
            <p:nvPr/>
          </p:nvSpPr>
          <p:spPr>
            <a:xfrm flipH="1">
              <a:off x="5948280" y="2125080"/>
              <a:ext cx="2986200" cy="360"/>
            </a:xfrm>
            <a:prstGeom prst="line">
              <a:avLst/>
            </a:prstGeom>
            <a:ln w="76200">
              <a:solidFill>
                <a:srgbClr val="a5a5a5"/>
              </a:solidFill>
            </a:ln>
          </p:spPr>
          <p:style>
            <a:lnRef idx="3">
              <a:schemeClr val="accent3"/>
            </a:lnRef>
            <a:fillRef idx="0">
              <a:schemeClr val="accent3"/>
            </a:fillRef>
            <a:effectRef idx="2">
              <a:schemeClr val="accent3"/>
            </a:effectRef>
            <a:fontRef idx="minor"/>
          </p:style>
        </p:sp>
        <p:sp>
          <p:nvSpPr>
            <p:cNvPr id="154" name="TextBox 77_0"/>
            <p:cNvSpPr/>
            <p:nvPr/>
          </p:nvSpPr>
          <p:spPr>
            <a:xfrm>
              <a:off x="5952960" y="460440"/>
              <a:ext cx="697680" cy="3027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Block 1</a:t>
              </a:r>
              <a:endParaRPr b="0" lang="en-US" sz="1400" spc="-1" strike="noStrike">
                <a:latin typeface="Arial"/>
              </a:endParaRPr>
            </a:p>
          </p:txBody>
        </p:sp>
        <p:sp>
          <p:nvSpPr>
            <p:cNvPr id="155" name="TextBox 78_0"/>
            <p:cNvSpPr/>
            <p:nvPr/>
          </p:nvSpPr>
          <p:spPr>
            <a:xfrm>
              <a:off x="6683400" y="454680"/>
              <a:ext cx="697680" cy="3027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Block 2</a:t>
              </a:r>
              <a:endParaRPr b="0" lang="en-US" sz="1400" spc="-1" strike="noStrike">
                <a:latin typeface="Arial"/>
              </a:endParaRPr>
            </a:p>
          </p:txBody>
        </p:sp>
        <p:sp>
          <p:nvSpPr>
            <p:cNvPr id="156" name="TextBox 79_0"/>
            <p:cNvSpPr/>
            <p:nvPr/>
          </p:nvSpPr>
          <p:spPr>
            <a:xfrm>
              <a:off x="7510680" y="462600"/>
              <a:ext cx="697680" cy="3027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Block 3</a:t>
              </a:r>
              <a:endParaRPr b="0" lang="en-US" sz="1400" spc="-1" strike="noStrike">
                <a:latin typeface="Arial"/>
              </a:endParaRPr>
            </a:p>
          </p:txBody>
        </p:sp>
        <p:sp>
          <p:nvSpPr>
            <p:cNvPr id="157" name="TextBox 80_0"/>
            <p:cNvSpPr/>
            <p:nvPr/>
          </p:nvSpPr>
          <p:spPr>
            <a:xfrm>
              <a:off x="8239680" y="463320"/>
              <a:ext cx="697680" cy="3027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Block 4</a:t>
              </a:r>
              <a:endParaRPr b="0" lang="en-US" sz="1400" spc="-1" strike="noStrike">
                <a:latin typeface="Arial"/>
              </a:endParaRPr>
            </a:p>
          </p:txBody>
        </p:sp>
        <p:sp>
          <p:nvSpPr>
            <p:cNvPr id="158" name="Star: 5 Points 82_0"/>
            <p:cNvSpPr/>
            <p:nvPr/>
          </p:nvSpPr>
          <p:spPr>
            <a:xfrm>
              <a:off x="6845400" y="423720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59" name="Star: 5 Points 83_0"/>
            <p:cNvSpPr/>
            <p:nvPr/>
          </p:nvSpPr>
          <p:spPr>
            <a:xfrm>
              <a:off x="7752600" y="360144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60" name="Star: 5 Points 84_0"/>
            <p:cNvSpPr/>
            <p:nvPr/>
          </p:nvSpPr>
          <p:spPr>
            <a:xfrm>
              <a:off x="6158520" y="287496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61" name="Star: 5 Points 85_0"/>
            <p:cNvSpPr/>
            <p:nvPr/>
          </p:nvSpPr>
          <p:spPr>
            <a:xfrm>
              <a:off x="8458920" y="221436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62" name="Star: 5 Points 86_0"/>
            <p:cNvSpPr/>
            <p:nvPr/>
          </p:nvSpPr>
          <p:spPr>
            <a:xfrm>
              <a:off x="7768080" y="148680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63" name="Star: 5 Points 87_0"/>
            <p:cNvSpPr/>
            <p:nvPr/>
          </p:nvSpPr>
          <p:spPr>
            <a:xfrm>
              <a:off x="8490600" y="799200"/>
              <a:ext cx="227520" cy="302760"/>
            </a:xfrm>
            <a:prstGeom prst="star5">
              <a:avLst>
                <a:gd name="adj" fmla="val 19098"/>
                <a:gd name="hf" fmla="val 105146"/>
                <a:gd name="vf" fmla="val 110557"/>
              </a:avLst>
            </a:prstGeom>
            <a:solidFill>
              <a:srgbClr val="ffff00"/>
            </a:solidFill>
            <a:ln>
              <a:solidFill>
                <a:srgbClr val="325490"/>
              </a:solidFill>
            </a:ln>
          </p:spPr>
          <p:style>
            <a:lnRef idx="2">
              <a:schemeClr val="accent1">
                <a:shade val="50000"/>
              </a:schemeClr>
            </a:lnRef>
            <a:fillRef idx="1">
              <a:schemeClr val="accent1"/>
            </a:fillRef>
            <a:effectRef idx="0">
              <a:schemeClr val="accent1"/>
            </a:effectRef>
            <a:fontRef idx="minor"/>
          </p:style>
        </p:sp>
        <p:sp>
          <p:nvSpPr>
            <p:cNvPr id="164" name="TextBox 88_0"/>
            <p:cNvSpPr/>
            <p:nvPr/>
          </p:nvSpPr>
          <p:spPr>
            <a:xfrm>
              <a:off x="6102720" y="44020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65" name="TextBox 89_0"/>
            <p:cNvSpPr/>
            <p:nvPr/>
          </p:nvSpPr>
          <p:spPr>
            <a:xfrm>
              <a:off x="6114960" y="372096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66" name="TextBox 90_0"/>
            <p:cNvSpPr/>
            <p:nvPr/>
          </p:nvSpPr>
          <p:spPr>
            <a:xfrm>
              <a:off x="6085440" y="16243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67" name="TextBox 91_0"/>
            <p:cNvSpPr/>
            <p:nvPr/>
          </p:nvSpPr>
          <p:spPr>
            <a:xfrm>
              <a:off x="6097680" y="31111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68" name="TextBox 92_0"/>
            <p:cNvSpPr/>
            <p:nvPr/>
          </p:nvSpPr>
          <p:spPr>
            <a:xfrm>
              <a:off x="6091920" y="9352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69" name="TextBox 93_0"/>
            <p:cNvSpPr/>
            <p:nvPr/>
          </p:nvSpPr>
          <p:spPr>
            <a:xfrm>
              <a:off x="6102720" y="23482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70" name="TextBox 94_0"/>
            <p:cNvSpPr/>
            <p:nvPr/>
          </p:nvSpPr>
          <p:spPr>
            <a:xfrm>
              <a:off x="6794640" y="230976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71" name="TextBox 95_0"/>
            <p:cNvSpPr/>
            <p:nvPr/>
          </p:nvSpPr>
          <p:spPr>
            <a:xfrm>
              <a:off x="6778440" y="305676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72" name="TextBox 96_0"/>
            <p:cNvSpPr/>
            <p:nvPr/>
          </p:nvSpPr>
          <p:spPr>
            <a:xfrm>
              <a:off x="6810120" y="9334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73" name="TextBox 97_0"/>
            <p:cNvSpPr/>
            <p:nvPr/>
          </p:nvSpPr>
          <p:spPr>
            <a:xfrm>
              <a:off x="6794640" y="16243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74" name="TextBox 98_0"/>
            <p:cNvSpPr/>
            <p:nvPr/>
          </p:nvSpPr>
          <p:spPr>
            <a:xfrm>
              <a:off x="6768360" y="44650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75" name="TextBox 99_0"/>
            <p:cNvSpPr/>
            <p:nvPr/>
          </p:nvSpPr>
          <p:spPr>
            <a:xfrm>
              <a:off x="6782760" y="372096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76" name="TextBox 100_0"/>
            <p:cNvSpPr/>
            <p:nvPr/>
          </p:nvSpPr>
          <p:spPr>
            <a:xfrm>
              <a:off x="7686000" y="9406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77" name="TextBox 101_0"/>
            <p:cNvSpPr/>
            <p:nvPr/>
          </p:nvSpPr>
          <p:spPr>
            <a:xfrm>
              <a:off x="7671240" y="304128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78" name="TextBox 102_0"/>
            <p:cNvSpPr/>
            <p:nvPr/>
          </p:nvSpPr>
          <p:spPr>
            <a:xfrm>
              <a:off x="7654320" y="23767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79" name="TextBox 103_0"/>
            <p:cNvSpPr/>
            <p:nvPr/>
          </p:nvSpPr>
          <p:spPr>
            <a:xfrm>
              <a:off x="7656840" y="446724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80" name="TextBox 104_0"/>
            <p:cNvSpPr/>
            <p:nvPr/>
          </p:nvSpPr>
          <p:spPr>
            <a:xfrm>
              <a:off x="7678800" y="388440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81" name="TextBox 105_0"/>
            <p:cNvSpPr/>
            <p:nvPr/>
          </p:nvSpPr>
          <p:spPr>
            <a:xfrm>
              <a:off x="7706880" y="173340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82" name="TextBox 106_0"/>
            <p:cNvSpPr/>
            <p:nvPr/>
          </p:nvSpPr>
          <p:spPr>
            <a:xfrm>
              <a:off x="8417520" y="17287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sp>
          <p:nvSpPr>
            <p:cNvPr id="183" name="TextBox 107_0"/>
            <p:cNvSpPr/>
            <p:nvPr/>
          </p:nvSpPr>
          <p:spPr>
            <a:xfrm>
              <a:off x="8400960" y="44755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84" name="TextBox 108_0"/>
            <p:cNvSpPr/>
            <p:nvPr/>
          </p:nvSpPr>
          <p:spPr>
            <a:xfrm>
              <a:off x="8407800" y="386964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85" name="TextBox 109_0"/>
            <p:cNvSpPr/>
            <p:nvPr/>
          </p:nvSpPr>
          <p:spPr>
            <a:xfrm>
              <a:off x="8395920" y="245340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1</a:t>
              </a:r>
              <a:endParaRPr b="0" lang="en-US" sz="1200" spc="-1" strike="noStrike">
                <a:latin typeface="Arial"/>
              </a:endParaRPr>
            </a:p>
          </p:txBody>
        </p:sp>
        <p:sp>
          <p:nvSpPr>
            <p:cNvPr id="186" name="TextBox 110_0"/>
            <p:cNvSpPr/>
            <p:nvPr/>
          </p:nvSpPr>
          <p:spPr>
            <a:xfrm>
              <a:off x="8404200" y="106020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3</a:t>
              </a:r>
              <a:endParaRPr b="0" lang="en-US" sz="1200" spc="-1" strike="noStrike">
                <a:latin typeface="Arial"/>
              </a:endParaRPr>
            </a:p>
          </p:txBody>
        </p:sp>
        <p:sp>
          <p:nvSpPr>
            <p:cNvPr id="187" name="TextBox 111_0"/>
            <p:cNvSpPr/>
            <p:nvPr/>
          </p:nvSpPr>
          <p:spPr>
            <a:xfrm>
              <a:off x="8362800" y="3039120"/>
              <a:ext cx="3549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200" spc="-1" strike="noStrike">
                  <a:solidFill>
                    <a:srgbClr val="000000"/>
                  </a:solidFill>
                  <a:latin typeface="Calibri"/>
                  <a:ea typeface="DejaVu Sans"/>
                </a:rPr>
                <a:t>G2</a:t>
              </a:r>
              <a:endParaRPr b="0" lang="en-US" sz="1200" spc="-1" strike="noStrike">
                <a:latin typeface="Arial"/>
              </a:endParaRPr>
            </a:p>
          </p:txBody>
        </p:sp>
      </p:grpSp>
      <p:sp>
        <p:nvSpPr>
          <p:cNvPr id="188" name="TextBox 16_0"/>
          <p:cNvSpPr/>
          <p:nvPr/>
        </p:nvSpPr>
        <p:spPr>
          <a:xfrm>
            <a:off x="581400" y="5707080"/>
            <a:ext cx="11128320" cy="819720"/>
          </a:xfrm>
          <a:prstGeom prst="rect">
            <a:avLst/>
          </a:prstGeom>
          <a:noFill/>
          <a:ln w="0">
            <a:noFill/>
          </a:ln>
        </p:spPr>
        <p:style>
          <a:lnRef idx="0"/>
          <a:fillRef idx="0"/>
          <a:effectRef idx="0"/>
          <a:fontRef idx="minor"/>
        </p:style>
        <p:txBody>
          <a:bodyPr lIns="90000" rIns="90000" tIns="45000" bIns="45000">
            <a:spAutoFit/>
          </a:bodyPr>
          <a:p>
            <a:pPr algn="just">
              <a:lnSpc>
                <a:spcPct val="100000"/>
              </a:lnSpc>
            </a:pPr>
            <a:r>
              <a:rPr b="1" lang="en-US" sz="1200" spc="-1" strike="noStrike">
                <a:solidFill>
                  <a:srgbClr val="000000"/>
                </a:solidFill>
                <a:latin typeface="Calibri"/>
                <a:ea typeface="DejaVu Sans"/>
              </a:rPr>
              <a:t>Supplementary Figure 1. </a:t>
            </a:r>
            <a:r>
              <a:rPr b="0" lang="en-US" sz="1200" spc="-1" strike="noStrike">
                <a:solidFill>
                  <a:srgbClr val="000000"/>
                </a:solidFill>
                <a:latin typeface="Calibri"/>
                <a:ea typeface="DejaVu Sans"/>
              </a:rPr>
              <a:t>The PVC mesocosm experiment (Exp. 2)  conducted in the controlled greenhouse set up. (A) Layout of PVC columns in a randomized complete block design with WW and WS treatments with white and green labels, respectively. (B) Experimental design to show how three alfalfa are randomized and treatments are assigned among experimental units. Each circle represent a PVC unit, G1 through G3 represents three alfalfa evaluated in the study and units with a yellow star icon represents units with soil sensor installed at 15 and 60 cm depths.</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9" name="TextBox 7"/>
          <p:cNvSpPr/>
          <p:nvPr/>
        </p:nvSpPr>
        <p:spPr>
          <a:xfrm>
            <a:off x="573120" y="6211800"/>
            <a:ext cx="11201760" cy="63720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1" lang="en-US" sz="1200" spc="-1" strike="noStrike">
                <a:solidFill>
                  <a:srgbClr val="000000"/>
                </a:solidFill>
                <a:latin typeface="Calibri"/>
                <a:ea typeface="DejaVu Sans"/>
              </a:rPr>
              <a:t>Supplementary Figure 2. </a:t>
            </a:r>
            <a:r>
              <a:rPr b="0" lang="en-US" sz="1200" spc="-1" strike="noStrike">
                <a:solidFill>
                  <a:srgbClr val="000000"/>
                </a:solidFill>
                <a:latin typeface="Calibri"/>
                <a:ea typeface="DejaVu Sans"/>
              </a:rPr>
              <a:t>Processing pipeline of alfalfa leaf images from PI 478573 to evaluate leaf morphological traits from plants grown in Exp. 2. </a:t>
            </a:r>
            <a:r>
              <a:rPr b="1" lang="en-US" sz="1200" spc="-1" strike="noStrike">
                <a:solidFill>
                  <a:srgbClr val="000000"/>
                </a:solidFill>
                <a:latin typeface="Calibri"/>
                <a:ea typeface="DejaVu Sans"/>
              </a:rPr>
              <a:t>(A)</a:t>
            </a:r>
            <a:r>
              <a:rPr b="0" lang="en-US" sz="1200" spc="-1" strike="noStrike">
                <a:solidFill>
                  <a:srgbClr val="000000"/>
                </a:solidFill>
                <a:latin typeface="Calibri"/>
                <a:ea typeface="DejaVu Sans"/>
              </a:rPr>
              <a:t> Raw image of the leaves against a black background including the plant stake with unique barcode ID. </a:t>
            </a:r>
            <a:r>
              <a:rPr b="1" lang="en-US" sz="1200" spc="-1" strike="noStrike">
                <a:solidFill>
                  <a:srgbClr val="000000"/>
                </a:solidFill>
                <a:latin typeface="Calibri"/>
                <a:ea typeface="DejaVu Sans"/>
              </a:rPr>
              <a:t>(B)</a:t>
            </a:r>
            <a:r>
              <a:rPr b="0" lang="en-US" sz="1200" spc="-1" strike="noStrike">
                <a:solidFill>
                  <a:srgbClr val="000000"/>
                </a:solidFill>
                <a:latin typeface="Calibri"/>
                <a:ea typeface="DejaVu Sans"/>
              </a:rPr>
              <a:t> Cropped image to remove part of the image background. </a:t>
            </a:r>
            <a:r>
              <a:rPr b="1" lang="en-US" sz="1200" spc="-1" strike="noStrike">
                <a:solidFill>
                  <a:srgbClr val="000000"/>
                </a:solidFill>
                <a:latin typeface="Calibri"/>
                <a:ea typeface="DejaVu Sans"/>
              </a:rPr>
              <a:t>(C)</a:t>
            </a:r>
            <a:r>
              <a:rPr b="0" lang="en-US" sz="1200" spc="-1" strike="noStrike">
                <a:solidFill>
                  <a:srgbClr val="000000"/>
                </a:solidFill>
                <a:latin typeface="Calibri"/>
                <a:ea typeface="DejaVu Sans"/>
              </a:rPr>
              <a:t> Image size calibrated based on the pixel counts that are represented in 1 cm spacing based on the ruler.  </a:t>
            </a:r>
            <a:r>
              <a:rPr b="1" lang="en-US" sz="1200" spc="-1" strike="noStrike">
                <a:solidFill>
                  <a:srgbClr val="000000"/>
                </a:solidFill>
                <a:latin typeface="Calibri"/>
                <a:ea typeface="DejaVu Sans"/>
              </a:rPr>
              <a:t>(D)</a:t>
            </a:r>
            <a:r>
              <a:rPr b="0" lang="en-US" sz="1200" spc="-1" strike="noStrike">
                <a:solidFill>
                  <a:srgbClr val="000000"/>
                </a:solidFill>
                <a:latin typeface="Calibri"/>
                <a:ea typeface="DejaVu Sans"/>
              </a:rPr>
              <a:t> Application of white canvas as background to process images using the LeafletAnalyzer program.</a:t>
            </a:r>
            <a:endParaRPr b="0" lang="en-US" sz="1200" spc="-1" strike="noStrike">
              <a:latin typeface="Arial"/>
            </a:endParaRPr>
          </a:p>
        </p:txBody>
      </p:sp>
      <p:pic>
        <p:nvPicPr>
          <p:cNvPr id="190" name="Picture 8" descr=""/>
          <p:cNvPicPr/>
          <p:nvPr/>
        </p:nvPicPr>
        <p:blipFill>
          <a:blip r:embed="rId1"/>
          <a:stretch/>
        </p:blipFill>
        <p:spPr>
          <a:xfrm>
            <a:off x="1833120" y="7920"/>
            <a:ext cx="7644240" cy="62002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1" name="TextBox 2"/>
          <p:cNvSpPr/>
          <p:nvPr/>
        </p:nvSpPr>
        <p:spPr>
          <a:xfrm>
            <a:off x="805320" y="-15840"/>
            <a:ext cx="31212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800" spc="-1" strike="noStrike">
                <a:solidFill>
                  <a:srgbClr val="ffffff"/>
                </a:solidFill>
                <a:latin typeface="Calibri"/>
                <a:ea typeface="DejaVu Sans"/>
              </a:rPr>
              <a:t>A</a:t>
            </a:r>
            <a:endParaRPr b="0" lang="en-US" sz="1800" spc="-1" strike="noStrike">
              <a:latin typeface="Arial"/>
            </a:endParaRPr>
          </a:p>
        </p:txBody>
      </p:sp>
      <p:sp>
        <p:nvSpPr>
          <p:cNvPr id="192" name="TextBox 16"/>
          <p:cNvSpPr/>
          <p:nvPr/>
        </p:nvSpPr>
        <p:spPr>
          <a:xfrm>
            <a:off x="4838760" y="-25560"/>
            <a:ext cx="280440" cy="36396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0" lang="en-US" sz="1800" spc="-1" strike="noStrike">
                <a:solidFill>
                  <a:srgbClr val="ffffff"/>
                </a:solidFill>
                <a:latin typeface="Calibri"/>
                <a:ea typeface="DejaVu Sans"/>
              </a:rPr>
              <a:t>B</a:t>
            </a:r>
            <a:endParaRPr b="0" lang="en-US" sz="1800" spc="-1" strike="noStrike">
              <a:latin typeface="Arial"/>
            </a:endParaRPr>
          </a:p>
        </p:txBody>
      </p:sp>
      <p:sp>
        <p:nvSpPr>
          <p:cNvPr id="193" name="TextBox 18"/>
          <p:cNvSpPr/>
          <p:nvPr/>
        </p:nvSpPr>
        <p:spPr>
          <a:xfrm>
            <a:off x="4842720" y="2954880"/>
            <a:ext cx="31968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800" spc="-1" strike="noStrike">
                <a:solidFill>
                  <a:srgbClr val="ffffff"/>
                </a:solidFill>
                <a:latin typeface="Calibri"/>
                <a:ea typeface="DejaVu Sans"/>
              </a:rPr>
              <a:t>D</a:t>
            </a:r>
            <a:endParaRPr b="0" lang="en-US" sz="1800" spc="-1" strike="noStrike">
              <a:latin typeface="Arial"/>
            </a:endParaRPr>
          </a:p>
        </p:txBody>
      </p:sp>
      <p:sp>
        <p:nvSpPr>
          <p:cNvPr id="194" name="TextBox 20"/>
          <p:cNvSpPr/>
          <p:nvPr/>
        </p:nvSpPr>
        <p:spPr>
          <a:xfrm>
            <a:off x="1121400" y="6061680"/>
            <a:ext cx="10177920" cy="63720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1" lang="en-US" sz="1200" spc="-1" strike="noStrike">
                <a:solidFill>
                  <a:srgbClr val="000000"/>
                </a:solidFill>
                <a:latin typeface="Calibri"/>
                <a:ea typeface="DejaVu Sans"/>
              </a:rPr>
              <a:t>Supplementary Figure 3. </a:t>
            </a:r>
            <a:r>
              <a:rPr b="0" lang="en-US" sz="1200" spc="-1" strike="noStrike">
                <a:solidFill>
                  <a:srgbClr val="000000"/>
                </a:solidFill>
                <a:latin typeface="Calibri"/>
                <a:ea typeface="DejaVu Sans"/>
              </a:rPr>
              <a:t>Extraction of alfalfa leaf morphological data using MATLAB scripts developed in LeafletAnalyzer software for both experiments.            </a:t>
            </a:r>
            <a:r>
              <a:rPr b="1" lang="en-US" sz="1200" spc="-1" strike="noStrike">
                <a:solidFill>
                  <a:srgbClr val="000000"/>
                </a:solidFill>
                <a:latin typeface="Calibri"/>
                <a:ea typeface="DejaVu Sans"/>
              </a:rPr>
              <a:t>(A)</a:t>
            </a:r>
            <a:r>
              <a:rPr b="0" lang="en-US" sz="1200" spc="-1" strike="noStrike">
                <a:solidFill>
                  <a:srgbClr val="000000"/>
                </a:solidFill>
                <a:latin typeface="Calibri"/>
                <a:ea typeface="DejaVu Sans"/>
              </a:rPr>
              <a:t> Leaflet image from PI 478573 extracted for analysis to show the sample processing pipeline. </a:t>
            </a:r>
            <a:r>
              <a:rPr b="1" lang="en-US" sz="1200" spc="-1" strike="noStrike">
                <a:solidFill>
                  <a:srgbClr val="000000"/>
                </a:solidFill>
                <a:latin typeface="Calibri"/>
                <a:ea typeface="DejaVu Sans"/>
              </a:rPr>
              <a:t>(B)</a:t>
            </a:r>
            <a:r>
              <a:rPr b="0" lang="en-US" sz="1200" spc="-1" strike="noStrike">
                <a:solidFill>
                  <a:srgbClr val="000000"/>
                </a:solidFill>
                <a:latin typeface="Calibri"/>
                <a:ea typeface="DejaVu Sans"/>
              </a:rPr>
              <a:t> Elliptical curve drawn around each leaf blade. </a:t>
            </a:r>
            <a:r>
              <a:rPr b="1" lang="en-US" sz="1200" spc="-1" strike="noStrike">
                <a:solidFill>
                  <a:srgbClr val="000000"/>
                </a:solidFill>
                <a:latin typeface="Calibri"/>
                <a:ea typeface="DejaVu Sans"/>
              </a:rPr>
              <a:t>(C)</a:t>
            </a:r>
            <a:r>
              <a:rPr b="0" lang="en-US" sz="1200" spc="-1" strike="noStrike">
                <a:solidFill>
                  <a:srgbClr val="000000"/>
                </a:solidFill>
                <a:latin typeface="Calibri"/>
                <a:ea typeface="DejaVu Sans"/>
              </a:rPr>
              <a:t> Leaf morphological measurement using the elliptic curve. </a:t>
            </a:r>
            <a:r>
              <a:rPr b="1" lang="en-US" sz="1200" spc="-1" strike="noStrike">
                <a:solidFill>
                  <a:srgbClr val="000000"/>
                </a:solidFill>
                <a:latin typeface="Calibri"/>
                <a:ea typeface="DejaVu Sans"/>
              </a:rPr>
              <a:t>(D) </a:t>
            </a:r>
            <a:r>
              <a:rPr b="0" lang="en-US" sz="1200" spc="-1" strike="noStrike">
                <a:solidFill>
                  <a:srgbClr val="000000"/>
                </a:solidFill>
                <a:latin typeface="Calibri"/>
                <a:ea typeface="DejaVu Sans"/>
              </a:rPr>
              <a:t>Image used for leaf shape and size analysis. </a:t>
            </a:r>
            <a:endParaRPr b="0" lang="en-US" sz="1200" spc="-1" strike="noStrike">
              <a:latin typeface="Arial"/>
            </a:endParaRPr>
          </a:p>
        </p:txBody>
      </p:sp>
      <p:pic>
        <p:nvPicPr>
          <p:cNvPr id="195" name="Picture 3" descr=""/>
          <p:cNvPicPr/>
          <p:nvPr/>
        </p:nvPicPr>
        <p:blipFill>
          <a:blip r:embed="rId1"/>
          <a:stretch/>
        </p:blipFill>
        <p:spPr>
          <a:xfrm>
            <a:off x="2089080" y="294480"/>
            <a:ext cx="7787520" cy="5673960"/>
          </a:xfrm>
          <a:prstGeom prst="rect">
            <a:avLst/>
          </a:prstGeom>
          <a:ln w="0">
            <a:noFill/>
          </a:ln>
        </p:spPr>
      </p:pic>
      <p:sp>
        <p:nvSpPr>
          <p:cNvPr id="196" name="TextBox 1"/>
          <p:cNvSpPr/>
          <p:nvPr/>
        </p:nvSpPr>
        <p:spPr>
          <a:xfrm>
            <a:off x="2530800" y="1306440"/>
            <a:ext cx="878040" cy="371880"/>
          </a:xfrm>
          <a:prstGeom prst="rect">
            <a:avLst/>
          </a:prstGeom>
          <a:solidFill>
            <a:schemeClr val="tx1"/>
          </a:solidFill>
          <a:ln w="0">
            <a:noFill/>
          </a:ln>
        </p:spPr>
        <p:style>
          <a:lnRef idx="0"/>
          <a:fillRef idx="0"/>
          <a:effectRef idx="0"/>
          <a:fontRef idx="minor"/>
        </p:style>
      </p:sp>
      <p:sp>
        <p:nvSpPr>
          <p:cNvPr id="197" name="TextBox 7"/>
          <p:cNvSpPr/>
          <p:nvPr/>
        </p:nvSpPr>
        <p:spPr>
          <a:xfrm>
            <a:off x="4726080" y="1368720"/>
            <a:ext cx="878040" cy="371880"/>
          </a:xfrm>
          <a:prstGeom prst="rect">
            <a:avLst/>
          </a:prstGeom>
          <a:solidFill>
            <a:schemeClr val="tx1"/>
          </a:solidFill>
          <a:ln w="0">
            <a:noFill/>
          </a:ln>
        </p:spPr>
        <p:style>
          <a:lnRef idx="0"/>
          <a:fillRef idx="0"/>
          <a:effectRef idx="0"/>
          <a:fontRef idx="minor"/>
        </p:style>
      </p:sp>
      <p:sp>
        <p:nvSpPr>
          <p:cNvPr id="198" name="TextBox 8"/>
          <p:cNvSpPr/>
          <p:nvPr/>
        </p:nvSpPr>
        <p:spPr>
          <a:xfrm>
            <a:off x="4285440" y="398160"/>
            <a:ext cx="878040" cy="371880"/>
          </a:xfrm>
          <a:prstGeom prst="rect">
            <a:avLst/>
          </a:prstGeom>
          <a:solidFill>
            <a:schemeClr val="tx1"/>
          </a:solidFill>
          <a:ln w="0">
            <a:noFill/>
          </a:ln>
        </p:spPr>
        <p:style>
          <a:lnRef idx="0"/>
          <a:fillRef idx="0"/>
          <a:effectRef idx="0"/>
          <a:fontRef idx="minor"/>
        </p:style>
      </p:sp>
      <p:sp>
        <p:nvSpPr>
          <p:cNvPr id="199" name="TextBox 4"/>
          <p:cNvSpPr/>
          <p:nvPr/>
        </p:nvSpPr>
        <p:spPr>
          <a:xfrm>
            <a:off x="3806280" y="294480"/>
            <a:ext cx="473760" cy="33300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600" spc="-1" strike="noStrike">
                <a:solidFill>
                  <a:srgbClr val="ffffff"/>
                </a:solidFill>
                <a:latin typeface="Calibri"/>
                <a:ea typeface="DejaVu Sans"/>
              </a:rPr>
              <a:t>Top</a:t>
            </a:r>
            <a:endParaRPr b="0" lang="en-US" sz="1600" spc="-1" strike="noStrike">
              <a:latin typeface="Arial"/>
            </a:endParaRPr>
          </a:p>
        </p:txBody>
      </p:sp>
      <p:sp>
        <p:nvSpPr>
          <p:cNvPr id="200" name="TextBox 10"/>
          <p:cNvSpPr/>
          <p:nvPr/>
        </p:nvSpPr>
        <p:spPr>
          <a:xfrm>
            <a:off x="2345400" y="2524320"/>
            <a:ext cx="488880" cy="33300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600" spc="-1" strike="noStrike">
                <a:solidFill>
                  <a:srgbClr val="ffffff"/>
                </a:solidFill>
                <a:latin typeface="Calibri"/>
                <a:ea typeface="DejaVu Sans"/>
              </a:rPr>
              <a:t>Left</a:t>
            </a:r>
            <a:endParaRPr b="0" lang="en-US" sz="1600" spc="-1" strike="noStrike">
              <a:latin typeface="Arial"/>
            </a:endParaRPr>
          </a:p>
        </p:txBody>
      </p:sp>
      <p:sp>
        <p:nvSpPr>
          <p:cNvPr id="201" name="TextBox 11"/>
          <p:cNvSpPr/>
          <p:nvPr/>
        </p:nvSpPr>
        <p:spPr>
          <a:xfrm>
            <a:off x="5237280" y="2524320"/>
            <a:ext cx="606240" cy="33300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600" spc="-1" strike="noStrike">
                <a:solidFill>
                  <a:srgbClr val="ffffff"/>
                </a:solidFill>
                <a:latin typeface="Calibri"/>
                <a:ea typeface="DejaVu Sans"/>
              </a:rPr>
              <a:t>Right</a:t>
            </a:r>
            <a:endParaRPr b="0" lang="en-US" sz="1600" spc="-1" strike="noStrike">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02" name="Chart 12"/>
          <p:cNvGraphicFramePr/>
          <p:nvPr/>
        </p:nvGraphicFramePr>
        <p:xfrm>
          <a:off x="2063160" y="7200"/>
          <a:ext cx="6827040" cy="3418200"/>
        </p:xfrm>
        <a:graphic>
          <a:graphicData uri="http://schemas.openxmlformats.org/drawingml/2006/chart">
            <c:chart xmlns:c="http://schemas.openxmlformats.org/drawingml/2006/chart" xmlns:r="http://schemas.openxmlformats.org/officeDocument/2006/relationships" r:id="rId1"/>
          </a:graphicData>
        </a:graphic>
      </p:graphicFrame>
      <p:graphicFrame>
        <p:nvGraphicFramePr>
          <p:cNvPr id="203" name="Chart 3"/>
          <p:cNvGraphicFramePr/>
          <p:nvPr/>
        </p:nvGraphicFramePr>
        <p:xfrm>
          <a:off x="2063160" y="3183120"/>
          <a:ext cx="6913800" cy="3117600"/>
        </p:xfrm>
        <a:graphic>
          <a:graphicData uri="http://schemas.openxmlformats.org/drawingml/2006/chart">
            <c:chart xmlns:c="http://schemas.openxmlformats.org/drawingml/2006/chart" xmlns:r="http://schemas.openxmlformats.org/officeDocument/2006/relationships" r:id="rId2"/>
          </a:graphicData>
        </a:graphic>
      </p:graphicFrame>
      <p:sp>
        <p:nvSpPr>
          <p:cNvPr id="204" name="TextBox 6"/>
          <p:cNvSpPr/>
          <p:nvPr/>
        </p:nvSpPr>
        <p:spPr>
          <a:xfrm>
            <a:off x="0" y="6194520"/>
            <a:ext cx="12188520" cy="637200"/>
          </a:xfrm>
          <a:prstGeom prst="rect">
            <a:avLst/>
          </a:prstGeom>
          <a:noFill/>
          <a:ln w="0">
            <a:noFill/>
          </a:ln>
        </p:spPr>
        <p:style>
          <a:lnRef idx="0"/>
          <a:fillRef idx="0"/>
          <a:effectRef idx="0"/>
          <a:fontRef idx="minor"/>
        </p:style>
        <p:txBody>
          <a:bodyPr lIns="90000" rIns="90000" tIns="45000" bIns="45000">
            <a:spAutoFit/>
          </a:bodyPr>
          <a:p>
            <a:pPr algn="just">
              <a:lnSpc>
                <a:spcPct val="100000"/>
              </a:lnSpc>
            </a:pPr>
            <a:r>
              <a:rPr b="1" lang="en-US" sz="1200" spc="-1" strike="noStrike">
                <a:solidFill>
                  <a:srgbClr val="000000"/>
                </a:solidFill>
                <a:latin typeface="Calibri"/>
                <a:ea typeface="DejaVu Sans"/>
              </a:rPr>
              <a:t>Supplementary Figure 4. </a:t>
            </a:r>
            <a:r>
              <a:rPr b="0" lang="en-US" sz="1200" spc="-1" strike="noStrike">
                <a:solidFill>
                  <a:srgbClr val="000000"/>
                </a:solidFill>
                <a:latin typeface="Calibri"/>
                <a:ea typeface="DejaVu Sans"/>
              </a:rPr>
              <a:t>Average percent soil moisture (%) in well-watered (WW) and water-stressed (WS) treatments at 15 and 60 cm depth within PVC columns in Exp. 1 </a:t>
            </a:r>
            <a:r>
              <a:rPr b="1" lang="en-US" sz="1200" spc="-1" strike="noStrike">
                <a:solidFill>
                  <a:srgbClr val="000000"/>
                </a:solidFill>
                <a:latin typeface="Calibri"/>
                <a:ea typeface="DejaVu Sans"/>
              </a:rPr>
              <a:t>(A)</a:t>
            </a:r>
            <a:r>
              <a:rPr b="0" lang="en-US" sz="1200" spc="-1" strike="noStrike">
                <a:solidFill>
                  <a:srgbClr val="000000"/>
                </a:solidFill>
                <a:latin typeface="Calibri"/>
                <a:ea typeface="DejaVu Sans"/>
              </a:rPr>
              <a:t> and Exp. 2 </a:t>
            </a:r>
            <a:r>
              <a:rPr b="1" lang="en-US" sz="1200" spc="-1" strike="noStrike">
                <a:solidFill>
                  <a:srgbClr val="000000"/>
                </a:solidFill>
                <a:latin typeface="Calibri"/>
                <a:ea typeface="DejaVu Sans"/>
              </a:rPr>
              <a:t>(B)</a:t>
            </a:r>
            <a:r>
              <a:rPr b="0" lang="en-US" sz="1200" spc="-1" strike="noStrike">
                <a:solidFill>
                  <a:srgbClr val="000000"/>
                </a:solidFill>
                <a:latin typeface="Calibri"/>
                <a:ea typeface="DejaVu Sans"/>
              </a:rPr>
              <a:t> after drought stress. Exp. 1 contained metromix 360 while the media in Exp. 2 was sand and perlite mix (2:1 v/v). The period between Oct. 7 to Oct 9 (A) represents a period of heavy rainfall in which water leaked inside the greenhouse near the location of plants grown in Exp. 1. </a:t>
            </a:r>
            <a:endParaRPr b="0" lang="en-US" sz="1200" spc="-1" strike="noStrike">
              <a:latin typeface="Arial"/>
            </a:endParaRPr>
          </a:p>
        </p:txBody>
      </p:sp>
      <p:sp>
        <p:nvSpPr>
          <p:cNvPr id="205" name="TextBox 7"/>
          <p:cNvSpPr/>
          <p:nvPr/>
        </p:nvSpPr>
        <p:spPr>
          <a:xfrm rot="16200000">
            <a:off x="1219320" y="4286880"/>
            <a:ext cx="1278720" cy="30312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 soil moisture</a:t>
            </a:r>
            <a:endParaRPr b="0" lang="en-US" sz="1400" spc="-1" strike="noStrike">
              <a:latin typeface="Arial"/>
            </a:endParaRPr>
          </a:p>
        </p:txBody>
      </p:sp>
      <p:sp>
        <p:nvSpPr>
          <p:cNvPr id="206" name="TextBox 8"/>
          <p:cNvSpPr/>
          <p:nvPr/>
        </p:nvSpPr>
        <p:spPr>
          <a:xfrm rot="16200000">
            <a:off x="1267560" y="1104840"/>
            <a:ext cx="1278720" cy="30312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400" spc="-1" strike="noStrike">
                <a:solidFill>
                  <a:srgbClr val="000000"/>
                </a:solidFill>
                <a:latin typeface="Calibri"/>
                <a:ea typeface="DejaVu Sans"/>
              </a:rPr>
              <a:t>% soil moisture</a:t>
            </a:r>
            <a:endParaRPr b="0" lang="en-US" sz="1400" spc="-1" strike="noStrike">
              <a:latin typeface="Arial"/>
            </a:endParaRPr>
          </a:p>
        </p:txBody>
      </p:sp>
      <p:sp>
        <p:nvSpPr>
          <p:cNvPr id="207" name="TextBox 9"/>
          <p:cNvSpPr/>
          <p:nvPr/>
        </p:nvSpPr>
        <p:spPr>
          <a:xfrm>
            <a:off x="1754640" y="-29160"/>
            <a:ext cx="339480" cy="36396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0" lang="en-US" sz="1800" spc="-1" strike="noStrike">
                <a:solidFill>
                  <a:srgbClr val="000000"/>
                </a:solidFill>
                <a:latin typeface="Calibri"/>
                <a:ea typeface="DejaVu Sans"/>
              </a:rPr>
              <a:t>A</a:t>
            </a:r>
            <a:endParaRPr b="0" lang="en-US" sz="1800" spc="-1" strike="noStrike">
              <a:latin typeface="Arial"/>
            </a:endParaRPr>
          </a:p>
        </p:txBody>
      </p:sp>
      <p:sp>
        <p:nvSpPr>
          <p:cNvPr id="208" name="TextBox 10"/>
          <p:cNvSpPr/>
          <p:nvPr/>
        </p:nvSpPr>
        <p:spPr>
          <a:xfrm>
            <a:off x="1744200" y="3143520"/>
            <a:ext cx="339480" cy="36396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0" lang="en-US" sz="1800" spc="-1" strike="noStrike">
                <a:solidFill>
                  <a:srgbClr val="000000"/>
                </a:solidFill>
                <a:latin typeface="Calibri"/>
                <a:ea typeface="DejaVu Sans"/>
              </a:rPr>
              <a:t>B</a:t>
            </a:r>
            <a:endParaRPr b="0" lang="en-US" sz="1800" spc="-1" strike="noStrike">
              <a:latin typeface="Arial"/>
            </a:endParaRPr>
          </a:p>
        </p:txBody>
      </p:sp>
      <p:sp>
        <p:nvSpPr>
          <p:cNvPr id="209" name="TextBox 2"/>
          <p:cNvSpPr/>
          <p:nvPr/>
        </p:nvSpPr>
        <p:spPr>
          <a:xfrm>
            <a:off x="8609760" y="180360"/>
            <a:ext cx="8625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60 cm WW</a:t>
            </a:r>
            <a:endParaRPr b="0" lang="en-US" sz="1200" spc="-1" strike="noStrike">
              <a:latin typeface="Arial"/>
            </a:endParaRPr>
          </a:p>
        </p:txBody>
      </p:sp>
      <p:sp>
        <p:nvSpPr>
          <p:cNvPr id="210" name="TextBox 19"/>
          <p:cNvSpPr/>
          <p:nvPr/>
        </p:nvSpPr>
        <p:spPr>
          <a:xfrm>
            <a:off x="8610120" y="1783080"/>
            <a:ext cx="79524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60 cm WS</a:t>
            </a:r>
            <a:endParaRPr b="0" lang="en-US" sz="1200" spc="-1" strike="noStrike">
              <a:latin typeface="Arial"/>
            </a:endParaRPr>
          </a:p>
        </p:txBody>
      </p:sp>
      <p:sp>
        <p:nvSpPr>
          <p:cNvPr id="211" name="TextBox 20"/>
          <p:cNvSpPr/>
          <p:nvPr/>
        </p:nvSpPr>
        <p:spPr>
          <a:xfrm>
            <a:off x="8609760" y="2194920"/>
            <a:ext cx="8625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15 cm WW</a:t>
            </a:r>
            <a:endParaRPr b="0" lang="en-US" sz="1200" spc="-1" strike="noStrike">
              <a:latin typeface="Arial"/>
            </a:endParaRPr>
          </a:p>
        </p:txBody>
      </p:sp>
      <p:sp>
        <p:nvSpPr>
          <p:cNvPr id="212" name="TextBox 21"/>
          <p:cNvSpPr/>
          <p:nvPr/>
        </p:nvSpPr>
        <p:spPr>
          <a:xfrm>
            <a:off x="8610120" y="2418840"/>
            <a:ext cx="79524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15 cm WS</a:t>
            </a:r>
            <a:endParaRPr b="0" lang="en-US" sz="1200" spc="-1" strike="noStrike">
              <a:latin typeface="Arial"/>
            </a:endParaRPr>
          </a:p>
        </p:txBody>
      </p:sp>
      <p:sp>
        <p:nvSpPr>
          <p:cNvPr id="213" name="TextBox 22"/>
          <p:cNvSpPr/>
          <p:nvPr/>
        </p:nvSpPr>
        <p:spPr>
          <a:xfrm>
            <a:off x="8725320" y="3765240"/>
            <a:ext cx="8625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60 cm WW</a:t>
            </a:r>
            <a:endParaRPr b="0" lang="en-US" sz="1200" spc="-1" strike="noStrike">
              <a:latin typeface="Arial"/>
            </a:endParaRPr>
          </a:p>
        </p:txBody>
      </p:sp>
      <p:sp>
        <p:nvSpPr>
          <p:cNvPr id="214" name="TextBox 23"/>
          <p:cNvSpPr/>
          <p:nvPr/>
        </p:nvSpPr>
        <p:spPr>
          <a:xfrm>
            <a:off x="8725320" y="4344120"/>
            <a:ext cx="8625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15 cm WW</a:t>
            </a:r>
            <a:endParaRPr b="0" lang="en-US" sz="1200" spc="-1" strike="noStrike">
              <a:latin typeface="Arial"/>
            </a:endParaRPr>
          </a:p>
        </p:txBody>
      </p:sp>
      <p:sp>
        <p:nvSpPr>
          <p:cNvPr id="215" name="TextBox 24"/>
          <p:cNvSpPr/>
          <p:nvPr/>
        </p:nvSpPr>
        <p:spPr>
          <a:xfrm>
            <a:off x="8725680" y="4907520"/>
            <a:ext cx="79524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60 cm WS</a:t>
            </a:r>
            <a:endParaRPr b="0" lang="en-US" sz="1200" spc="-1" strike="noStrike">
              <a:latin typeface="Arial"/>
            </a:endParaRPr>
          </a:p>
        </p:txBody>
      </p:sp>
      <p:sp>
        <p:nvSpPr>
          <p:cNvPr id="216" name="TextBox 25"/>
          <p:cNvSpPr/>
          <p:nvPr/>
        </p:nvSpPr>
        <p:spPr>
          <a:xfrm>
            <a:off x="8725680" y="5479920"/>
            <a:ext cx="79524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15 cm WS</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17" name="Content Placeholder 3" descr=""/>
          <p:cNvPicPr/>
          <p:nvPr/>
        </p:nvPicPr>
        <p:blipFill>
          <a:blip r:embed="rId1"/>
          <a:stretch/>
        </p:blipFill>
        <p:spPr>
          <a:xfrm>
            <a:off x="1491480" y="353880"/>
            <a:ext cx="9142200" cy="5243400"/>
          </a:xfrm>
          <a:prstGeom prst="rect">
            <a:avLst/>
          </a:prstGeom>
          <a:ln w="0">
            <a:noFill/>
          </a:ln>
        </p:spPr>
      </p:pic>
      <p:grpSp>
        <p:nvGrpSpPr>
          <p:cNvPr id="218" name="Group 4_1"/>
          <p:cNvGrpSpPr/>
          <p:nvPr/>
        </p:nvGrpSpPr>
        <p:grpSpPr>
          <a:xfrm>
            <a:off x="1498680" y="280440"/>
            <a:ext cx="2417040" cy="4265640"/>
            <a:chOff x="1498680" y="280440"/>
            <a:chExt cx="2417040" cy="4265640"/>
          </a:xfrm>
        </p:grpSpPr>
        <p:sp>
          <p:nvSpPr>
            <p:cNvPr id="219" name="TextBox 5_1"/>
            <p:cNvSpPr/>
            <p:nvPr/>
          </p:nvSpPr>
          <p:spPr>
            <a:xfrm>
              <a:off x="1503000" y="366480"/>
              <a:ext cx="31824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800" spc="-1" strike="noStrike">
                  <a:solidFill>
                    <a:srgbClr val="ffffff"/>
                  </a:solidFill>
                  <a:latin typeface="Calibri"/>
                  <a:ea typeface="DejaVu Sans"/>
                </a:rPr>
                <a:t>A</a:t>
              </a:r>
              <a:endParaRPr b="0" lang="en-US" sz="1800" spc="-1" strike="noStrike">
                <a:latin typeface="Arial"/>
              </a:endParaRPr>
            </a:p>
          </p:txBody>
        </p:sp>
        <p:sp>
          <p:nvSpPr>
            <p:cNvPr id="220" name="TextBox 6_1"/>
            <p:cNvSpPr/>
            <p:nvPr/>
          </p:nvSpPr>
          <p:spPr>
            <a:xfrm>
              <a:off x="1506960" y="4182120"/>
              <a:ext cx="29988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800" spc="-1" strike="noStrike">
                  <a:solidFill>
                    <a:srgbClr val="ffffff"/>
                  </a:solidFill>
                  <a:latin typeface="Calibri"/>
                  <a:ea typeface="DejaVu Sans"/>
                </a:rPr>
                <a:t>C</a:t>
              </a:r>
              <a:endParaRPr b="0" lang="en-US" sz="1800" spc="-1" strike="noStrike">
                <a:latin typeface="Arial"/>
              </a:endParaRPr>
            </a:p>
          </p:txBody>
        </p:sp>
        <p:sp>
          <p:nvSpPr>
            <p:cNvPr id="221" name="TextBox 7_1"/>
            <p:cNvSpPr/>
            <p:nvPr/>
          </p:nvSpPr>
          <p:spPr>
            <a:xfrm>
              <a:off x="1498680" y="2398320"/>
              <a:ext cx="30780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800" spc="-1" strike="noStrike">
                  <a:solidFill>
                    <a:srgbClr val="ffffff"/>
                  </a:solidFill>
                  <a:latin typeface="Calibri"/>
                  <a:ea typeface="DejaVu Sans"/>
                </a:rPr>
                <a:t>B</a:t>
              </a:r>
              <a:endParaRPr b="0" lang="en-US" sz="1800" spc="-1" strike="noStrike">
                <a:latin typeface="Arial"/>
              </a:endParaRPr>
            </a:p>
          </p:txBody>
        </p:sp>
        <p:sp>
          <p:nvSpPr>
            <p:cNvPr id="222" name="TextBox 8_1"/>
            <p:cNvSpPr/>
            <p:nvPr/>
          </p:nvSpPr>
          <p:spPr>
            <a:xfrm>
              <a:off x="1565280" y="1672560"/>
              <a:ext cx="52704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800" spc="-1" strike="noStrike">
                  <a:solidFill>
                    <a:srgbClr val="ffffff"/>
                  </a:solidFill>
                  <a:latin typeface="Calibri"/>
                  <a:ea typeface="DejaVu Sans"/>
                </a:rPr>
                <a:t>Left</a:t>
              </a:r>
              <a:endParaRPr b="0" lang="en-US" sz="1800" spc="-1" strike="noStrike">
                <a:latin typeface="Arial"/>
              </a:endParaRPr>
            </a:p>
          </p:txBody>
        </p:sp>
        <p:sp>
          <p:nvSpPr>
            <p:cNvPr id="223" name="TextBox 9_1"/>
            <p:cNvSpPr/>
            <p:nvPr/>
          </p:nvSpPr>
          <p:spPr>
            <a:xfrm>
              <a:off x="3259080" y="1656720"/>
              <a:ext cx="65664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800" spc="-1" strike="noStrike">
                  <a:solidFill>
                    <a:srgbClr val="ffffff"/>
                  </a:solidFill>
                  <a:latin typeface="Calibri"/>
                  <a:ea typeface="DejaVu Sans"/>
                </a:rPr>
                <a:t>Right</a:t>
              </a:r>
              <a:endParaRPr b="0" lang="en-US" sz="1800" spc="-1" strike="noStrike">
                <a:latin typeface="Arial"/>
              </a:endParaRPr>
            </a:p>
          </p:txBody>
        </p:sp>
        <p:sp>
          <p:nvSpPr>
            <p:cNvPr id="224" name="TextBox 10_1"/>
            <p:cNvSpPr/>
            <p:nvPr/>
          </p:nvSpPr>
          <p:spPr>
            <a:xfrm>
              <a:off x="2339640" y="280440"/>
              <a:ext cx="51192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800" spc="-1" strike="noStrike">
                  <a:solidFill>
                    <a:srgbClr val="ffffff"/>
                  </a:solidFill>
                  <a:latin typeface="Calibri"/>
                  <a:ea typeface="DejaVu Sans"/>
                </a:rPr>
                <a:t>Top</a:t>
              </a:r>
              <a:endParaRPr b="0" lang="en-US" sz="1800" spc="-1" strike="noStrike">
                <a:latin typeface="Arial"/>
              </a:endParaRPr>
            </a:p>
          </p:txBody>
        </p:sp>
      </p:grpSp>
      <p:sp>
        <p:nvSpPr>
          <p:cNvPr id="225" name="TextBox 11_1"/>
          <p:cNvSpPr/>
          <p:nvPr/>
        </p:nvSpPr>
        <p:spPr>
          <a:xfrm>
            <a:off x="1453680" y="5673600"/>
            <a:ext cx="9180000" cy="42444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1" lang="en-US" sz="1100" spc="-1" strike="noStrike">
                <a:solidFill>
                  <a:srgbClr val="000000"/>
                </a:solidFill>
                <a:latin typeface="Calibri"/>
                <a:ea typeface="DejaVu Sans"/>
              </a:rPr>
              <a:t>Supplementary Figure 5. </a:t>
            </a:r>
            <a:r>
              <a:rPr b="0" lang="en-US" sz="1100" spc="-1" strike="noStrike">
                <a:solidFill>
                  <a:srgbClr val="000000"/>
                </a:solidFill>
                <a:latin typeface="Calibri"/>
                <a:ea typeface="DejaVu Sans"/>
              </a:rPr>
              <a:t>Sample images used to evaluate leaf size, shape and morphology of individual leaflets (top, left and right) of alfalfa populations PI 478573 (</a:t>
            </a:r>
            <a:r>
              <a:rPr b="1" lang="en-US" sz="1100" spc="-1" strike="noStrike">
                <a:solidFill>
                  <a:srgbClr val="000000"/>
                </a:solidFill>
                <a:latin typeface="Calibri"/>
                <a:ea typeface="DejaVu Sans"/>
              </a:rPr>
              <a:t>A</a:t>
            </a:r>
            <a:r>
              <a:rPr b="0" lang="en-US" sz="1100" spc="-1" strike="noStrike">
                <a:solidFill>
                  <a:srgbClr val="000000"/>
                </a:solidFill>
                <a:latin typeface="Calibri"/>
                <a:ea typeface="DejaVu Sans"/>
              </a:rPr>
              <a:t>), PI 502521 (</a:t>
            </a:r>
            <a:r>
              <a:rPr b="1" lang="en-US" sz="1100" spc="-1" strike="noStrike">
                <a:solidFill>
                  <a:srgbClr val="000000"/>
                </a:solidFill>
                <a:latin typeface="Calibri"/>
                <a:ea typeface="DejaVu Sans"/>
              </a:rPr>
              <a:t>B</a:t>
            </a:r>
            <a:r>
              <a:rPr b="0" lang="en-US" sz="1100" spc="-1" strike="noStrike">
                <a:solidFill>
                  <a:srgbClr val="000000"/>
                </a:solidFill>
                <a:latin typeface="Calibri"/>
                <a:ea typeface="DejaVu Sans"/>
              </a:rPr>
              <a:t>) and Bulldog 805 (</a:t>
            </a:r>
            <a:r>
              <a:rPr b="1" lang="en-US" sz="1100" spc="-1" strike="noStrike">
                <a:solidFill>
                  <a:srgbClr val="000000"/>
                </a:solidFill>
                <a:latin typeface="Calibri"/>
                <a:ea typeface="DejaVu Sans"/>
              </a:rPr>
              <a:t>C</a:t>
            </a:r>
            <a:r>
              <a:rPr b="0" lang="en-US" sz="1100" spc="-1" strike="noStrike">
                <a:solidFill>
                  <a:srgbClr val="000000"/>
                </a:solidFill>
                <a:latin typeface="Calibri"/>
                <a:ea typeface="DejaVu Sans"/>
              </a:rPr>
              <a:t>) in Exp. 1. </a:t>
            </a:r>
            <a:endParaRPr b="0" lang="en-US" sz="1100" spc="-1" strike="noStrike">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26" name="Group 4"/>
          <p:cNvGrpSpPr/>
          <p:nvPr/>
        </p:nvGrpSpPr>
        <p:grpSpPr>
          <a:xfrm>
            <a:off x="1021680" y="710280"/>
            <a:ext cx="3187440" cy="3412080"/>
            <a:chOff x="1021680" y="710280"/>
            <a:chExt cx="3187440" cy="3412080"/>
          </a:xfrm>
        </p:grpSpPr>
        <p:pic>
          <p:nvPicPr>
            <p:cNvPr id="227" name="Picture 2" descr=""/>
            <p:cNvPicPr/>
            <p:nvPr/>
          </p:nvPicPr>
          <p:blipFill>
            <a:blip r:embed="rId1"/>
            <a:srcRect l="0" t="7929" r="19501" b="0"/>
            <a:stretch/>
          </p:blipFill>
          <p:spPr>
            <a:xfrm>
              <a:off x="1453680" y="710280"/>
              <a:ext cx="2755440" cy="3412080"/>
            </a:xfrm>
            <a:prstGeom prst="rect">
              <a:avLst/>
            </a:prstGeom>
            <a:ln w="0">
              <a:noFill/>
            </a:ln>
          </p:spPr>
        </p:pic>
        <p:pic>
          <p:nvPicPr>
            <p:cNvPr id="228" name="Picture 3" descr=""/>
            <p:cNvPicPr/>
            <p:nvPr/>
          </p:nvPicPr>
          <p:blipFill>
            <a:blip r:embed="rId2"/>
            <a:srcRect l="0" t="7929" r="19430" b="76148"/>
            <a:stretch/>
          </p:blipFill>
          <p:spPr>
            <a:xfrm rot="5400000">
              <a:off x="-83160" y="2198880"/>
              <a:ext cx="2796480" cy="586800"/>
            </a:xfrm>
            <a:prstGeom prst="rect">
              <a:avLst/>
            </a:prstGeom>
            <a:ln w="0">
              <a:noFill/>
            </a:ln>
          </p:spPr>
        </p:pic>
      </p:grpSp>
      <p:sp>
        <p:nvSpPr>
          <p:cNvPr id="229" name="TextBox 5"/>
          <p:cNvSpPr/>
          <p:nvPr/>
        </p:nvSpPr>
        <p:spPr>
          <a:xfrm>
            <a:off x="610560" y="4277880"/>
            <a:ext cx="11283120" cy="1794600"/>
          </a:xfrm>
          <a:prstGeom prst="rect">
            <a:avLst/>
          </a:prstGeom>
          <a:noFill/>
          <a:ln w="0">
            <a:noFill/>
          </a:ln>
        </p:spPr>
        <p:style>
          <a:lnRef idx="0"/>
          <a:fillRef idx="0"/>
          <a:effectRef idx="0"/>
          <a:fontRef idx="minor"/>
        </p:style>
        <p:txBody>
          <a:bodyPr lIns="90000" rIns="90000" tIns="45000" bIns="45000">
            <a:spAutoFit/>
          </a:bodyPr>
          <a:p>
            <a:pPr algn="just">
              <a:lnSpc>
                <a:spcPct val="100000"/>
              </a:lnSpc>
            </a:pPr>
            <a:r>
              <a:rPr b="1" lang="en-US" sz="1400" spc="-1" strike="noStrike">
                <a:solidFill>
                  <a:srgbClr val="000000"/>
                </a:solidFill>
                <a:latin typeface="Calibri"/>
                <a:ea typeface="Microsoft YaHei"/>
              </a:rPr>
              <a:t>Supplementary Figure</a:t>
            </a:r>
            <a:r>
              <a:rPr b="0" lang="en-US" sz="1400" spc="-1" strike="noStrike">
                <a:solidFill>
                  <a:srgbClr val="000000"/>
                </a:solidFill>
                <a:latin typeface="Calibri"/>
                <a:ea typeface="Microsoft YaHei"/>
              </a:rPr>
              <a:t>. </a:t>
            </a:r>
            <a:r>
              <a:rPr b="1" lang="en-US" sz="1400" spc="-1" strike="noStrike">
                <a:solidFill>
                  <a:srgbClr val="000000"/>
                </a:solidFill>
                <a:latin typeface="Calibri"/>
                <a:ea typeface="Microsoft YaHei"/>
              </a:rPr>
              <a:t>6</a:t>
            </a:r>
            <a:r>
              <a:rPr b="0" lang="en-US" sz="1400" spc="-1" strike="noStrike">
                <a:solidFill>
                  <a:srgbClr val="000000"/>
                </a:solidFill>
                <a:latin typeface="Calibri"/>
                <a:ea typeface="Microsoft YaHei"/>
              </a:rPr>
              <a:t>. Significant correlations between biomass yield and other traits evaluated in alfalfa populations. </a:t>
            </a:r>
            <a:r>
              <a:rPr b="1" lang="en-US" sz="1400" spc="-1" strike="noStrike">
                <a:solidFill>
                  <a:srgbClr val="000000"/>
                </a:solidFill>
                <a:latin typeface="Calibri"/>
                <a:ea typeface="Microsoft YaHei"/>
              </a:rPr>
              <a:t>A.</a:t>
            </a:r>
            <a:r>
              <a:rPr b="0" lang="en-US" sz="1400" spc="-1" strike="noStrike">
                <a:solidFill>
                  <a:srgbClr val="000000"/>
                </a:solidFill>
                <a:latin typeface="Calibri"/>
                <a:ea typeface="Microsoft YaHei"/>
              </a:rPr>
              <a:t> Phenotypic traits from three alfalfa population data of </a:t>
            </a:r>
            <a:r>
              <a:rPr b="1" lang="en-US" sz="1400" spc="-1" strike="noStrike">
                <a:solidFill>
                  <a:srgbClr val="000000"/>
                </a:solidFill>
                <a:latin typeface="Calibri"/>
                <a:ea typeface="Microsoft YaHei"/>
              </a:rPr>
              <a:t>Exp. 1</a:t>
            </a:r>
            <a:r>
              <a:rPr b="0" lang="en-US" sz="1400" spc="-1" strike="noStrike">
                <a:solidFill>
                  <a:srgbClr val="000000"/>
                </a:solidFill>
                <a:latin typeface="Calibri"/>
                <a:ea typeface="Microsoft YaHei"/>
              </a:rPr>
              <a:t>  for shoot fresh weight after drought (SFWAD) after rewatering (</a:t>
            </a:r>
            <a:r>
              <a:rPr b="0" lang="en-US" sz="1400" spc="-1" strike="noStrike">
                <a:solidFill>
                  <a:srgbClr val="000000"/>
                </a:solidFill>
                <a:latin typeface="Calibri"/>
                <a:ea typeface="DejaVu Sans"/>
              </a:rPr>
              <a:t>SFWAW), chlorophyll content before drought (CCBD), stomatal conductance after drought (SCAD), Individual leaflet of trifoliate: Top leaf (T)- Area (A), Width(W), Length-Width ratio (LW); Left leaf (L)- Area (A), Width(W), Length-Width ratio (LW); Right Leaf (R)- Width (W), Length-Width ratio (LW); Root volume (RV), Distance from shoot to first lateral root in cm (FLD), Root fresh weight after re-watering (RFWAW), Root: Shoot fresh weight ratio after re-watering (RFRAW). </a:t>
            </a:r>
            <a:r>
              <a:rPr b="1" lang="en-US" sz="1400" spc="-1" strike="noStrike">
                <a:solidFill>
                  <a:srgbClr val="000000"/>
                </a:solidFill>
                <a:latin typeface="Calibri"/>
                <a:ea typeface="DejaVu Sans"/>
              </a:rPr>
              <a:t>B.</a:t>
            </a:r>
            <a:r>
              <a:rPr b="0" lang="en-US" sz="1400" spc="-1" strike="noStrike">
                <a:solidFill>
                  <a:srgbClr val="000000"/>
                </a:solidFill>
                <a:latin typeface="Calibri"/>
                <a:ea typeface="DejaVu Sans"/>
              </a:rPr>
              <a:t> Phenotypic traits from three alfalfa population data of </a:t>
            </a:r>
            <a:r>
              <a:rPr b="1" lang="en-US" sz="1400" spc="-1" strike="noStrike">
                <a:solidFill>
                  <a:srgbClr val="000000"/>
                </a:solidFill>
                <a:latin typeface="Calibri"/>
                <a:ea typeface="DejaVu Sans"/>
              </a:rPr>
              <a:t>Exp. 2</a:t>
            </a:r>
            <a:r>
              <a:rPr b="0" lang="en-US" sz="1400" spc="-1" strike="noStrike">
                <a:solidFill>
                  <a:srgbClr val="000000"/>
                </a:solidFill>
                <a:latin typeface="Calibri"/>
                <a:ea typeface="DejaVu Sans"/>
              </a:rPr>
              <a:t>. Correlation matrix of Exp. 2 for shoot dry weight (SDW) after drought (AD), after rewatering (AW), chlorophyll content after drought (CCAD), Individual leaflet of trifoliate: Top leaf (T)- Length-Width ratio (LW), Compactness (C); Left leaf (L)- Compactness (C), Entropy (E), Width(W) ; Right Leaf (R)- Width (W), Length-Width ratio (LW) Compactness (C); Root dry weight after re-watering (RFWAW).</a:t>
            </a:r>
            <a:endParaRPr b="0" lang="en-US" sz="1400" spc="-1" strike="noStrike">
              <a:latin typeface="Arial"/>
            </a:endParaRPr>
          </a:p>
        </p:txBody>
      </p:sp>
      <p:sp>
        <p:nvSpPr>
          <p:cNvPr id="230" name="TextBox 6"/>
          <p:cNvSpPr/>
          <p:nvPr/>
        </p:nvSpPr>
        <p:spPr>
          <a:xfrm>
            <a:off x="1153080" y="757440"/>
            <a:ext cx="31824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800" spc="-1" strike="noStrike">
                <a:solidFill>
                  <a:srgbClr val="000000"/>
                </a:solidFill>
                <a:latin typeface="Calibri"/>
                <a:ea typeface="DejaVu Sans"/>
              </a:rPr>
              <a:t>A</a:t>
            </a:r>
            <a:endParaRPr b="0" lang="en-US" sz="1800" spc="-1" strike="noStrike">
              <a:latin typeface="Arial"/>
            </a:endParaRPr>
          </a:p>
        </p:txBody>
      </p:sp>
      <p:grpSp>
        <p:nvGrpSpPr>
          <p:cNvPr id="231" name="Group 10"/>
          <p:cNvGrpSpPr/>
          <p:nvPr/>
        </p:nvGrpSpPr>
        <p:grpSpPr>
          <a:xfrm>
            <a:off x="6127920" y="710280"/>
            <a:ext cx="3844080" cy="3395880"/>
            <a:chOff x="6127920" y="710280"/>
            <a:chExt cx="3844080" cy="3395880"/>
          </a:xfrm>
        </p:grpSpPr>
        <p:pic>
          <p:nvPicPr>
            <p:cNvPr id="232" name="Picture 8" descr=""/>
            <p:cNvPicPr/>
            <p:nvPr/>
          </p:nvPicPr>
          <p:blipFill>
            <a:blip r:embed="rId3"/>
            <a:srcRect l="0" t="8154" r="0" b="0"/>
            <a:stretch/>
          </p:blipFill>
          <p:spPr>
            <a:xfrm>
              <a:off x="6591600" y="710280"/>
              <a:ext cx="3380400" cy="3395880"/>
            </a:xfrm>
            <a:prstGeom prst="rect">
              <a:avLst/>
            </a:prstGeom>
            <a:ln w="0">
              <a:noFill/>
            </a:ln>
          </p:spPr>
        </p:pic>
        <p:pic>
          <p:nvPicPr>
            <p:cNvPr id="233" name="Picture 9" descr=""/>
            <p:cNvPicPr/>
            <p:nvPr/>
          </p:nvPicPr>
          <p:blipFill>
            <a:blip r:embed="rId4"/>
            <a:srcRect l="4566" t="8154" r="19678" b="76039"/>
            <a:stretch/>
          </p:blipFill>
          <p:spPr>
            <a:xfrm rot="5400000">
              <a:off x="5138640" y="2303280"/>
              <a:ext cx="2559960" cy="581760"/>
            </a:xfrm>
            <a:prstGeom prst="rect">
              <a:avLst/>
            </a:prstGeom>
            <a:ln w="0">
              <a:noFill/>
            </a:ln>
          </p:spPr>
        </p:pic>
      </p:grpSp>
      <p:sp>
        <p:nvSpPr>
          <p:cNvPr id="234" name="TextBox 11"/>
          <p:cNvSpPr/>
          <p:nvPr/>
        </p:nvSpPr>
        <p:spPr>
          <a:xfrm>
            <a:off x="6274800" y="753120"/>
            <a:ext cx="307800" cy="3639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1" lang="en-US" sz="1800" spc="-1" strike="noStrike">
                <a:solidFill>
                  <a:srgbClr val="000000"/>
                </a:solidFill>
                <a:latin typeface="Calibri"/>
                <a:ea typeface="DejaVu Sans"/>
              </a:rPr>
              <a:t>B</a:t>
            </a:r>
            <a:endParaRPr b="0" lang="en-US" sz="1800" spc="-1" strike="noStrike">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35" name="Group 5"/>
          <p:cNvGrpSpPr/>
          <p:nvPr/>
        </p:nvGrpSpPr>
        <p:grpSpPr>
          <a:xfrm>
            <a:off x="1273320" y="673920"/>
            <a:ext cx="9584280" cy="5328720"/>
            <a:chOff x="1273320" y="673920"/>
            <a:chExt cx="9584280" cy="5328720"/>
          </a:xfrm>
        </p:grpSpPr>
        <p:grpSp>
          <p:nvGrpSpPr>
            <p:cNvPr id="236" name="Group 2"/>
            <p:cNvGrpSpPr/>
            <p:nvPr/>
          </p:nvGrpSpPr>
          <p:grpSpPr>
            <a:xfrm>
              <a:off x="1273320" y="673920"/>
              <a:ext cx="9584280" cy="5328720"/>
              <a:chOff x="1273320" y="673920"/>
              <a:chExt cx="9584280" cy="5328720"/>
            </a:xfrm>
          </p:grpSpPr>
          <p:graphicFrame>
            <p:nvGraphicFramePr>
              <p:cNvPr id="237" name="Chart 3"/>
              <p:cNvGraphicFramePr/>
              <p:nvPr/>
            </p:nvGraphicFramePr>
            <p:xfrm>
              <a:off x="1273320" y="2975760"/>
              <a:ext cx="9583920" cy="3026880"/>
            </p:xfrm>
            <a:graphic>
              <a:graphicData uri="http://schemas.openxmlformats.org/drawingml/2006/chart">
                <c:chart xmlns:c="http://schemas.openxmlformats.org/drawingml/2006/chart" xmlns:r="http://schemas.openxmlformats.org/officeDocument/2006/relationships" r:id="rId1"/>
              </a:graphicData>
            </a:graphic>
          </p:graphicFrame>
          <p:graphicFrame>
            <p:nvGraphicFramePr>
              <p:cNvPr id="238" name="Chart 4"/>
              <p:cNvGraphicFramePr/>
              <p:nvPr/>
            </p:nvGraphicFramePr>
            <p:xfrm>
              <a:off x="1616760" y="673920"/>
              <a:ext cx="9240840" cy="2388600"/>
            </p:xfrm>
            <a:graphic>
              <a:graphicData uri="http://schemas.openxmlformats.org/drawingml/2006/chart">
                <c:chart xmlns:c="http://schemas.openxmlformats.org/drawingml/2006/chart" xmlns:r="http://schemas.openxmlformats.org/officeDocument/2006/relationships" r:id="rId2"/>
              </a:graphicData>
            </a:graphic>
          </p:graphicFrame>
        </p:grpSp>
        <p:grpSp>
          <p:nvGrpSpPr>
            <p:cNvPr id="239" name="Group 1"/>
            <p:cNvGrpSpPr/>
            <p:nvPr/>
          </p:nvGrpSpPr>
          <p:grpSpPr>
            <a:xfrm>
              <a:off x="1896480" y="4461120"/>
              <a:ext cx="8748360" cy="260280"/>
              <a:chOff x="1896480" y="4461120"/>
              <a:chExt cx="8748360" cy="260280"/>
            </a:xfrm>
          </p:grpSpPr>
          <p:grpSp>
            <p:nvGrpSpPr>
              <p:cNvPr id="240" name="Group 26"/>
              <p:cNvGrpSpPr/>
              <p:nvPr/>
            </p:nvGrpSpPr>
            <p:grpSpPr>
              <a:xfrm>
                <a:off x="1965240" y="4461120"/>
                <a:ext cx="8679600" cy="260280"/>
                <a:chOff x="1965240" y="4461120"/>
                <a:chExt cx="8679600" cy="260280"/>
              </a:xfrm>
            </p:grpSpPr>
            <p:sp>
              <p:nvSpPr>
                <p:cNvPr id="241" name="Straight Connector 27"/>
                <p:cNvSpPr/>
                <p:nvPr/>
              </p:nvSpPr>
              <p:spPr>
                <a:xfrm>
                  <a:off x="2587320" y="4500000"/>
                  <a:ext cx="74268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42" name="Straight Connector 28"/>
                <p:cNvSpPr/>
                <p:nvPr/>
              </p:nvSpPr>
              <p:spPr>
                <a:xfrm>
                  <a:off x="1965240" y="4500000"/>
                  <a:ext cx="47520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43" name="Straight Connector 29"/>
                <p:cNvSpPr/>
                <p:nvPr/>
              </p:nvSpPr>
              <p:spPr>
                <a:xfrm>
                  <a:off x="3580560" y="4500000"/>
                  <a:ext cx="74304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44" name="TextBox 1"/>
                <p:cNvSpPr/>
                <p:nvPr/>
              </p:nvSpPr>
              <p:spPr>
                <a:xfrm>
                  <a:off x="2587320" y="450036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Feb 2017</a:t>
                  </a:r>
                  <a:endParaRPr b="0" lang="en-US" sz="1100" spc="-1" strike="noStrike">
                    <a:latin typeface="Arial"/>
                  </a:endParaRPr>
                </a:p>
              </p:txBody>
            </p:sp>
            <p:sp>
              <p:nvSpPr>
                <p:cNvPr id="245" name="TextBox 1"/>
                <p:cNvSpPr/>
                <p:nvPr/>
              </p:nvSpPr>
              <p:spPr>
                <a:xfrm>
                  <a:off x="3580920" y="449244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Mar 2017</a:t>
                  </a:r>
                  <a:endParaRPr b="0" lang="en-US" sz="1100" spc="-1" strike="noStrike">
                    <a:latin typeface="Arial"/>
                  </a:endParaRPr>
                </a:p>
              </p:txBody>
            </p:sp>
            <p:sp>
              <p:nvSpPr>
                <p:cNvPr id="246" name="Straight Connector 32"/>
                <p:cNvSpPr/>
                <p:nvPr/>
              </p:nvSpPr>
              <p:spPr>
                <a:xfrm>
                  <a:off x="4582800" y="4500000"/>
                  <a:ext cx="133020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47" name="TextBox 1"/>
                <p:cNvSpPr/>
                <p:nvPr/>
              </p:nvSpPr>
              <p:spPr>
                <a:xfrm>
                  <a:off x="4876560" y="449244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Apr 2017</a:t>
                  </a:r>
                  <a:endParaRPr b="0" lang="en-US" sz="1100" spc="-1" strike="noStrike">
                    <a:latin typeface="Arial"/>
                  </a:endParaRPr>
                </a:p>
              </p:txBody>
            </p:sp>
            <p:sp>
              <p:nvSpPr>
                <p:cNvPr id="248" name="Straight Connector 34"/>
                <p:cNvSpPr/>
                <p:nvPr/>
              </p:nvSpPr>
              <p:spPr>
                <a:xfrm>
                  <a:off x="6150960" y="4494240"/>
                  <a:ext cx="74304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49" name="TextBox 1"/>
                <p:cNvSpPr/>
                <p:nvPr/>
              </p:nvSpPr>
              <p:spPr>
                <a:xfrm>
                  <a:off x="6108120" y="449244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May 2017</a:t>
                  </a:r>
                  <a:endParaRPr b="0" lang="en-US" sz="1100" spc="-1" strike="noStrike">
                    <a:latin typeface="Arial"/>
                  </a:endParaRPr>
                </a:p>
              </p:txBody>
            </p:sp>
            <p:sp>
              <p:nvSpPr>
                <p:cNvPr id="250" name="Straight Connector 36"/>
                <p:cNvSpPr/>
                <p:nvPr/>
              </p:nvSpPr>
              <p:spPr>
                <a:xfrm>
                  <a:off x="7045560" y="4500000"/>
                  <a:ext cx="47520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51" name="TextBox 1"/>
                <p:cNvSpPr/>
                <p:nvPr/>
              </p:nvSpPr>
              <p:spPr>
                <a:xfrm>
                  <a:off x="6937200" y="449244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Jun 2017</a:t>
                  </a:r>
                  <a:endParaRPr b="0" lang="en-US" sz="1100" spc="-1" strike="noStrike">
                    <a:latin typeface="Arial"/>
                  </a:endParaRPr>
                </a:p>
              </p:txBody>
            </p:sp>
            <p:sp>
              <p:nvSpPr>
                <p:cNvPr id="252" name="Straight Connector 38"/>
                <p:cNvSpPr/>
                <p:nvPr/>
              </p:nvSpPr>
              <p:spPr>
                <a:xfrm>
                  <a:off x="7679880" y="4492080"/>
                  <a:ext cx="133056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53" name="TextBox 1"/>
                <p:cNvSpPr/>
                <p:nvPr/>
              </p:nvSpPr>
              <p:spPr>
                <a:xfrm>
                  <a:off x="7974000" y="449136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July 2017</a:t>
                  </a:r>
                  <a:endParaRPr b="0" lang="en-US" sz="1100" spc="-1" strike="noStrike">
                    <a:latin typeface="Arial"/>
                  </a:endParaRPr>
                </a:p>
              </p:txBody>
            </p:sp>
            <p:sp>
              <p:nvSpPr>
                <p:cNvPr id="254" name="Straight Connector 40"/>
                <p:cNvSpPr/>
                <p:nvPr/>
              </p:nvSpPr>
              <p:spPr>
                <a:xfrm>
                  <a:off x="9166320" y="4491360"/>
                  <a:ext cx="74268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55" name="TextBox 1"/>
                <p:cNvSpPr/>
                <p:nvPr/>
              </p:nvSpPr>
              <p:spPr>
                <a:xfrm>
                  <a:off x="9159120" y="446616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Aug 2017</a:t>
                  </a:r>
                  <a:endParaRPr b="0" lang="en-US" sz="1100" spc="-1" strike="noStrike">
                    <a:latin typeface="Arial"/>
                  </a:endParaRPr>
                </a:p>
              </p:txBody>
            </p:sp>
            <p:sp>
              <p:nvSpPr>
                <p:cNvPr id="256" name="Straight Connector 42"/>
                <p:cNvSpPr/>
                <p:nvPr/>
              </p:nvSpPr>
              <p:spPr>
                <a:xfrm>
                  <a:off x="10045080" y="4486320"/>
                  <a:ext cx="474840" cy="360"/>
                </a:xfrm>
                <a:prstGeom prst="line">
                  <a:avLst/>
                </a:prstGeom>
                <a:ln>
                  <a:solidFill>
                    <a:srgbClr val="000000"/>
                  </a:solidFill>
                </a:ln>
              </p:spPr>
              <p:style>
                <a:lnRef idx="2">
                  <a:schemeClr val="dk1"/>
                </a:lnRef>
                <a:fillRef idx="0">
                  <a:schemeClr val="dk1"/>
                </a:fillRef>
                <a:effectRef idx="1">
                  <a:schemeClr val="dk1"/>
                </a:effectRef>
                <a:fontRef idx="minor"/>
              </p:style>
            </p:sp>
            <p:sp>
              <p:nvSpPr>
                <p:cNvPr id="257" name="TextBox 1"/>
                <p:cNvSpPr/>
                <p:nvPr/>
              </p:nvSpPr>
              <p:spPr>
                <a:xfrm>
                  <a:off x="9905400" y="446112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Sep 2017</a:t>
                  </a:r>
                  <a:endParaRPr b="0" lang="en-US" sz="1100" spc="-1" strike="noStrike">
                    <a:latin typeface="Arial"/>
                  </a:endParaRPr>
                </a:p>
              </p:txBody>
            </p:sp>
          </p:grpSp>
          <p:sp>
            <p:nvSpPr>
              <p:cNvPr id="258" name="TextBox 1"/>
              <p:cNvSpPr/>
              <p:nvPr/>
            </p:nvSpPr>
            <p:spPr>
              <a:xfrm>
                <a:off x="1896480" y="4494240"/>
                <a:ext cx="739440" cy="221040"/>
              </a:xfrm>
              <a:prstGeom prst="rect">
                <a:avLst/>
              </a:prstGeom>
              <a:noFill/>
              <a:ln w="0">
                <a:noFill/>
              </a:ln>
            </p:spPr>
            <p:style>
              <a:lnRef idx="0"/>
              <a:fillRef idx="0"/>
              <a:effectRef idx="0"/>
              <a:fontRef idx="minor"/>
            </p:style>
            <p:txBody>
              <a:bodyPr wrap="none" lIns="90000" rIns="90000" tIns="45000" bIns="45000">
                <a:noAutofit/>
              </a:bodyPr>
              <a:p>
                <a:pPr>
                  <a:lnSpc>
                    <a:spcPct val="100000"/>
                  </a:lnSpc>
                  <a:tabLst>
                    <a:tab algn="l" pos="0"/>
                  </a:tabLst>
                </a:pPr>
                <a:r>
                  <a:rPr b="0" lang="en-US" sz="1100" spc="-1" strike="noStrike">
                    <a:solidFill>
                      <a:srgbClr val="000000"/>
                    </a:solidFill>
                    <a:latin typeface="Calibri"/>
                    <a:ea typeface="DejaVu Sans"/>
                  </a:rPr>
                  <a:t>Jan 2017</a:t>
                </a:r>
                <a:endParaRPr b="0" lang="en-US" sz="1100" spc="-1" strike="noStrike">
                  <a:latin typeface="Arial"/>
                </a:endParaRPr>
              </a:p>
            </p:txBody>
          </p:sp>
        </p:grpSp>
      </p:grpSp>
      <p:sp>
        <p:nvSpPr>
          <p:cNvPr id="259" name="TextBox 48"/>
          <p:cNvSpPr/>
          <p:nvPr/>
        </p:nvSpPr>
        <p:spPr>
          <a:xfrm>
            <a:off x="595440" y="5703480"/>
            <a:ext cx="11283120" cy="454680"/>
          </a:xfrm>
          <a:prstGeom prst="rect">
            <a:avLst/>
          </a:prstGeom>
          <a:noFill/>
          <a:ln w="0">
            <a:noFill/>
          </a:ln>
        </p:spPr>
        <p:style>
          <a:lnRef idx="0"/>
          <a:fillRef idx="0"/>
          <a:effectRef idx="0"/>
          <a:fontRef idx="minor"/>
        </p:style>
        <p:txBody>
          <a:bodyPr lIns="90000" rIns="90000" tIns="45000" bIns="45000">
            <a:spAutoFit/>
          </a:bodyPr>
          <a:p>
            <a:pPr algn="just">
              <a:lnSpc>
                <a:spcPct val="100000"/>
              </a:lnSpc>
            </a:pPr>
            <a:r>
              <a:rPr b="1" lang="en-US" sz="1200" spc="-1" strike="noStrike">
                <a:solidFill>
                  <a:srgbClr val="000000"/>
                </a:solidFill>
                <a:latin typeface="Calibri"/>
                <a:ea typeface="DejaVu Sans"/>
              </a:rPr>
              <a:t>Supplementary Figure</a:t>
            </a:r>
            <a:r>
              <a:rPr b="0" lang="en-US" sz="1200" spc="-1" strike="noStrike">
                <a:solidFill>
                  <a:srgbClr val="000000"/>
                </a:solidFill>
                <a:latin typeface="Calibri"/>
                <a:ea typeface="DejaVu Sans"/>
              </a:rPr>
              <a:t> </a:t>
            </a:r>
            <a:r>
              <a:rPr b="1" lang="en-US" sz="1200" spc="-1" strike="noStrike">
                <a:solidFill>
                  <a:srgbClr val="000000"/>
                </a:solidFill>
                <a:latin typeface="Calibri"/>
                <a:ea typeface="DejaVu Sans"/>
              </a:rPr>
              <a:t>7</a:t>
            </a:r>
            <a:r>
              <a:rPr b="0" lang="en-US" sz="1200" spc="-1" strike="noStrike">
                <a:solidFill>
                  <a:srgbClr val="000000"/>
                </a:solidFill>
                <a:latin typeface="Calibri"/>
                <a:ea typeface="DejaVu Sans"/>
              </a:rPr>
              <a:t>. Variability of Normalized Differential Vegetation index measured across  2017 growing season in alfalfa populations [BD805-Bulldog 805, PI478- PI478573 and PI502-PI502521].  </a:t>
            </a:r>
            <a:endParaRPr b="0" lang="en-US" sz="1200" spc="-1" strike="noStrike">
              <a:latin typeface="Arial"/>
            </a:endParaRPr>
          </a:p>
        </p:txBody>
      </p:sp>
      <p:sp>
        <p:nvSpPr>
          <p:cNvPr id="260" name="TextBox 8"/>
          <p:cNvSpPr/>
          <p:nvPr/>
        </p:nvSpPr>
        <p:spPr>
          <a:xfrm>
            <a:off x="1965600" y="760680"/>
            <a:ext cx="1816560" cy="27216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Calibri"/>
                <a:ea typeface="DejaVu Sans"/>
              </a:rPr>
              <a:t>A. Irrigated</a:t>
            </a:r>
            <a:endParaRPr b="0" lang="en-US" sz="1200" spc="-1" strike="noStrike">
              <a:latin typeface="Arial"/>
            </a:endParaRPr>
          </a:p>
        </p:txBody>
      </p:sp>
      <p:sp>
        <p:nvSpPr>
          <p:cNvPr id="261" name="TextBox 49"/>
          <p:cNvSpPr/>
          <p:nvPr/>
        </p:nvSpPr>
        <p:spPr>
          <a:xfrm>
            <a:off x="1965600" y="3146760"/>
            <a:ext cx="1816560" cy="272160"/>
          </a:xfrm>
          <a:prstGeom prst="rect">
            <a:avLst/>
          </a:prstGeom>
          <a:noFill/>
          <a:ln w="0">
            <a:noFill/>
          </a:ln>
        </p:spPr>
        <p:style>
          <a:lnRef idx="0"/>
          <a:fillRef idx="0"/>
          <a:effectRef idx="0"/>
          <a:fontRef idx="minor"/>
        </p:style>
        <p:txBody>
          <a:bodyPr lIns="90000" rIns="90000" tIns="45000" bIns="45000">
            <a:spAutoFit/>
          </a:bodyPr>
          <a:p>
            <a:pPr>
              <a:lnSpc>
                <a:spcPct val="100000"/>
              </a:lnSpc>
            </a:pPr>
            <a:r>
              <a:rPr b="0" lang="en-US" sz="1200" spc="-1" strike="noStrike">
                <a:solidFill>
                  <a:srgbClr val="000000"/>
                </a:solidFill>
                <a:latin typeface="Calibri"/>
                <a:ea typeface="DejaVu Sans"/>
              </a:rPr>
              <a:t>B. Rainfed</a:t>
            </a:r>
            <a:endParaRPr b="0" lang="en-US" sz="1200" spc="-1" strike="noStrike">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62" name="Picture 4" descr=""/>
          <p:cNvPicPr/>
          <p:nvPr/>
        </p:nvPicPr>
        <p:blipFill>
          <a:blip r:embed="rId1"/>
          <a:stretch/>
        </p:blipFill>
        <p:spPr>
          <a:xfrm>
            <a:off x="10658880" y="476640"/>
            <a:ext cx="543240" cy="1834560"/>
          </a:xfrm>
          <a:prstGeom prst="rect">
            <a:avLst/>
          </a:prstGeom>
          <a:ln w="0">
            <a:noFill/>
          </a:ln>
        </p:spPr>
      </p:pic>
      <p:grpSp>
        <p:nvGrpSpPr>
          <p:cNvPr id="263" name="Group 1"/>
          <p:cNvGrpSpPr/>
          <p:nvPr/>
        </p:nvGrpSpPr>
        <p:grpSpPr>
          <a:xfrm>
            <a:off x="596880" y="741600"/>
            <a:ext cx="5112360" cy="4142880"/>
            <a:chOff x="596880" y="741600"/>
            <a:chExt cx="5112360" cy="4142880"/>
          </a:xfrm>
        </p:grpSpPr>
        <p:pic>
          <p:nvPicPr>
            <p:cNvPr id="264" name="Picture 8" descr=""/>
            <p:cNvPicPr/>
            <p:nvPr/>
          </p:nvPicPr>
          <p:blipFill>
            <a:blip r:embed="rId2"/>
            <a:srcRect l="0" t="0" r="0" b="3409"/>
            <a:stretch/>
          </p:blipFill>
          <p:spPr>
            <a:xfrm>
              <a:off x="596880" y="741600"/>
              <a:ext cx="5112360" cy="4142880"/>
            </a:xfrm>
            <a:prstGeom prst="rect">
              <a:avLst/>
            </a:prstGeom>
            <a:ln w="0">
              <a:noFill/>
            </a:ln>
          </p:spPr>
        </p:pic>
        <p:sp>
          <p:nvSpPr>
            <p:cNvPr id="265" name="Rectangle 6"/>
            <p:cNvSpPr/>
            <p:nvPr/>
          </p:nvSpPr>
          <p:spPr>
            <a:xfrm>
              <a:off x="3925440" y="2800800"/>
              <a:ext cx="1648080" cy="342000"/>
            </a:xfrm>
            <a:prstGeom prst="rect">
              <a:avLst/>
            </a:prstGeom>
            <a:noFill/>
            <a:ln>
              <a:solidFill>
                <a:srgbClr val="000000"/>
              </a:solidFill>
            </a:ln>
          </p:spPr>
          <p:style>
            <a:lnRef idx="2">
              <a:schemeClr val="accent1">
                <a:shade val="50000"/>
              </a:schemeClr>
            </a:lnRef>
            <a:fillRef idx="1">
              <a:schemeClr val="accent1"/>
            </a:fillRef>
            <a:effectRef idx="0">
              <a:schemeClr val="accent1"/>
            </a:effectRef>
            <a:fontRef idx="minor"/>
          </p:style>
        </p:sp>
        <p:sp>
          <p:nvSpPr>
            <p:cNvPr id="266" name="Rectangle 7"/>
            <p:cNvSpPr/>
            <p:nvPr/>
          </p:nvSpPr>
          <p:spPr>
            <a:xfrm>
              <a:off x="1077120" y="2814840"/>
              <a:ext cx="2408040" cy="327960"/>
            </a:xfrm>
            <a:prstGeom prst="rect">
              <a:avLst/>
            </a:prstGeom>
            <a:noFill/>
            <a:ln>
              <a:solidFill>
                <a:srgbClr val="000000"/>
              </a:solidFill>
            </a:ln>
          </p:spPr>
          <p:style>
            <a:lnRef idx="2">
              <a:schemeClr val="accent1">
                <a:shade val="50000"/>
              </a:schemeClr>
            </a:lnRef>
            <a:fillRef idx="1">
              <a:schemeClr val="accent1"/>
            </a:fillRef>
            <a:effectRef idx="0">
              <a:schemeClr val="accent1"/>
            </a:effectRef>
            <a:fontRef idx="minor"/>
          </p:style>
        </p:sp>
      </p:grpSp>
      <p:grpSp>
        <p:nvGrpSpPr>
          <p:cNvPr id="267" name="Group 9"/>
          <p:cNvGrpSpPr/>
          <p:nvPr/>
        </p:nvGrpSpPr>
        <p:grpSpPr>
          <a:xfrm>
            <a:off x="5712840" y="741600"/>
            <a:ext cx="4942440" cy="4125960"/>
            <a:chOff x="5712840" y="741600"/>
            <a:chExt cx="4942440" cy="4125960"/>
          </a:xfrm>
        </p:grpSpPr>
        <p:pic>
          <p:nvPicPr>
            <p:cNvPr id="268" name="Picture 10" descr=""/>
            <p:cNvPicPr/>
            <p:nvPr/>
          </p:nvPicPr>
          <p:blipFill>
            <a:blip r:embed="rId3"/>
            <a:srcRect l="0" t="0" r="0" b="4463"/>
            <a:stretch/>
          </p:blipFill>
          <p:spPr>
            <a:xfrm>
              <a:off x="5712840" y="741600"/>
              <a:ext cx="4942440" cy="4125960"/>
            </a:xfrm>
            <a:prstGeom prst="rect">
              <a:avLst/>
            </a:prstGeom>
            <a:ln w="0">
              <a:noFill/>
            </a:ln>
          </p:spPr>
        </p:pic>
        <p:sp>
          <p:nvSpPr>
            <p:cNvPr id="269" name="Rectangle 11"/>
            <p:cNvSpPr/>
            <p:nvPr/>
          </p:nvSpPr>
          <p:spPr>
            <a:xfrm>
              <a:off x="8929440" y="2829600"/>
              <a:ext cx="1606320" cy="320040"/>
            </a:xfrm>
            <a:prstGeom prst="rect">
              <a:avLst/>
            </a:prstGeom>
            <a:noFill/>
            <a:ln>
              <a:solidFill>
                <a:srgbClr val="000000"/>
              </a:solidFill>
            </a:ln>
          </p:spPr>
          <p:style>
            <a:lnRef idx="2">
              <a:schemeClr val="accent1">
                <a:shade val="50000"/>
              </a:schemeClr>
            </a:lnRef>
            <a:fillRef idx="1">
              <a:schemeClr val="accent1"/>
            </a:fillRef>
            <a:effectRef idx="0">
              <a:schemeClr val="accent1"/>
            </a:effectRef>
            <a:fontRef idx="minor"/>
          </p:style>
        </p:sp>
        <p:sp>
          <p:nvSpPr>
            <p:cNvPr id="270" name="Rectangle 12"/>
            <p:cNvSpPr/>
            <p:nvPr/>
          </p:nvSpPr>
          <p:spPr>
            <a:xfrm>
              <a:off x="6187320" y="2829600"/>
              <a:ext cx="2263680" cy="320040"/>
            </a:xfrm>
            <a:prstGeom prst="rect">
              <a:avLst/>
            </a:prstGeom>
            <a:noFill/>
            <a:ln>
              <a:solidFill>
                <a:srgbClr val="000000"/>
              </a:solidFill>
            </a:ln>
          </p:spPr>
          <p:style>
            <a:lnRef idx="2">
              <a:schemeClr val="accent1">
                <a:shade val="50000"/>
              </a:schemeClr>
            </a:lnRef>
            <a:fillRef idx="1">
              <a:schemeClr val="accent1"/>
            </a:fillRef>
            <a:effectRef idx="0">
              <a:schemeClr val="accent1"/>
            </a:effectRef>
            <a:fontRef idx="minor"/>
          </p:style>
        </p:sp>
      </p:grpSp>
      <p:sp>
        <p:nvSpPr>
          <p:cNvPr id="271" name="TextBox 2"/>
          <p:cNvSpPr/>
          <p:nvPr/>
        </p:nvSpPr>
        <p:spPr>
          <a:xfrm>
            <a:off x="600840" y="440280"/>
            <a:ext cx="81072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A. Rainfed</a:t>
            </a:r>
            <a:endParaRPr b="0" lang="en-US" sz="1200" spc="-1" strike="noStrike">
              <a:latin typeface="Arial"/>
            </a:endParaRPr>
          </a:p>
        </p:txBody>
      </p:sp>
      <p:sp>
        <p:nvSpPr>
          <p:cNvPr id="272" name="TextBox 14"/>
          <p:cNvSpPr/>
          <p:nvPr/>
        </p:nvSpPr>
        <p:spPr>
          <a:xfrm>
            <a:off x="6037560" y="440280"/>
            <a:ext cx="860760" cy="272160"/>
          </a:xfrm>
          <a:prstGeom prst="rect">
            <a:avLst/>
          </a:prstGeom>
          <a:noFill/>
          <a:ln w="0">
            <a:noFill/>
          </a:ln>
        </p:spPr>
        <p:style>
          <a:lnRef idx="0"/>
          <a:fillRef idx="0"/>
          <a:effectRef idx="0"/>
          <a:fontRef idx="minor"/>
        </p:style>
        <p:txBody>
          <a:bodyPr wrap="none" lIns="90000" rIns="90000" tIns="45000" bIns="45000">
            <a:spAutoFit/>
          </a:bodyPr>
          <a:p>
            <a:pPr>
              <a:lnSpc>
                <a:spcPct val="100000"/>
              </a:lnSpc>
            </a:pPr>
            <a:r>
              <a:rPr b="0" lang="en-US" sz="1200" spc="-1" strike="noStrike">
                <a:solidFill>
                  <a:srgbClr val="000000"/>
                </a:solidFill>
                <a:latin typeface="Calibri"/>
                <a:ea typeface="DejaVu Sans"/>
              </a:rPr>
              <a:t>B. Irrigated</a:t>
            </a:r>
            <a:endParaRPr b="0" lang="en-US" sz="1200" spc="-1" strike="noStrike">
              <a:latin typeface="Arial"/>
            </a:endParaRPr>
          </a:p>
        </p:txBody>
      </p:sp>
      <p:sp>
        <p:nvSpPr>
          <p:cNvPr id="273" name="TextBox 15"/>
          <p:cNvSpPr/>
          <p:nvPr/>
        </p:nvSpPr>
        <p:spPr>
          <a:xfrm>
            <a:off x="596880" y="5042160"/>
            <a:ext cx="11283120" cy="942120"/>
          </a:xfrm>
          <a:prstGeom prst="rect">
            <a:avLst/>
          </a:prstGeom>
          <a:noFill/>
          <a:ln w="0">
            <a:noFill/>
          </a:ln>
        </p:spPr>
        <p:style>
          <a:lnRef idx="0"/>
          <a:fillRef idx="0"/>
          <a:effectRef idx="0"/>
          <a:fontRef idx="minor"/>
        </p:style>
        <p:txBody>
          <a:bodyPr lIns="90000" rIns="90000" tIns="45000" bIns="45000">
            <a:spAutoFit/>
          </a:bodyPr>
          <a:p>
            <a:pPr algn="just">
              <a:lnSpc>
                <a:spcPct val="100000"/>
              </a:lnSpc>
            </a:pPr>
            <a:r>
              <a:rPr b="1" lang="en-US" sz="1400" spc="-1" strike="noStrike">
                <a:solidFill>
                  <a:srgbClr val="000000"/>
                </a:solidFill>
                <a:latin typeface="Calibri"/>
                <a:ea typeface="DejaVu Sans"/>
              </a:rPr>
              <a:t>Supplementary Figure</a:t>
            </a:r>
            <a:r>
              <a:rPr b="0" lang="en-US" sz="1400" spc="-1" strike="noStrike">
                <a:solidFill>
                  <a:srgbClr val="000000"/>
                </a:solidFill>
                <a:latin typeface="Calibri"/>
                <a:ea typeface="DejaVu Sans"/>
              </a:rPr>
              <a:t>. </a:t>
            </a:r>
            <a:r>
              <a:rPr b="1" lang="en-US" sz="1400" spc="-1" strike="noStrike">
                <a:solidFill>
                  <a:srgbClr val="000000"/>
                </a:solidFill>
                <a:latin typeface="Calibri"/>
                <a:ea typeface="DejaVu Sans"/>
              </a:rPr>
              <a:t>8</a:t>
            </a:r>
            <a:r>
              <a:rPr b="0" lang="en-US" sz="1400" spc="-1" strike="noStrike">
                <a:solidFill>
                  <a:srgbClr val="000000"/>
                </a:solidFill>
                <a:latin typeface="Calibri"/>
                <a:ea typeface="DejaVu Sans"/>
              </a:rPr>
              <a:t>. Significant correlations between dry biomass (RDW- rainfed dry weight and IDW-irrigated dry weight) yield (highlighted in box), root and NDVI measurements from three alfalfa population. The root data presented here are abbreviated in Table 5. Other traits presented are D- Diameter; WTDR-Width-to-depth ratio ; LRA- Lower root angle; ShAF- Shallow angle frequency; MAF-Medium Angle Frequency, SI-Shallowness Index, FRF-Fine Radius Frequency, MRF-Medium Radius Frequency, CRF-Coarse Radius Frequency, and FI-Fineness Index.</a:t>
            </a:r>
            <a:endParaRPr b="0" lang="en-US" sz="1400" spc="-1" strike="noStrike">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326</TotalTime>
  <Application>LibreOffice/7.1.5.2$Windows_X86_64 LibreOffice_project/85f04e9f809797b8199d13c421bd8a2b025d52b5</Application>
  <AppVersion>15.0000</AppVersion>
  <Words>825</Words>
  <Paragraphs>46</Paragraphs>
  <Company>The Samuel Roberts Noble Foundation</Company>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12-01T22:10:17Z</dcterms:created>
  <dc:creator>Prince Kirubakaran, Silvas</dc:creator>
  <dc:description/>
  <dc:language>en-US</dc:language>
  <cp:lastModifiedBy/>
  <cp:lastPrinted>2022-03-07T09:14:37Z</cp:lastPrinted>
  <dcterms:modified xsi:type="dcterms:W3CDTF">2022-03-27T12:03:32Z</dcterms:modified>
  <cp:revision>117</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PresentationFormat">
    <vt:lpwstr>Widescreen</vt:lpwstr>
  </property>
  <property fmtid="{D5CDD505-2E9C-101B-9397-08002B2CF9AE}" pid="3" name="Slides">
    <vt:i4>7</vt:i4>
  </property>
</Properties>
</file>